
<file path=[Content_Types].xml><?xml version="1.0" encoding="utf-8"?>
<Types xmlns="http://schemas.openxmlformats.org/package/2006/content-types">
  <Override PartName="/docProps/core.xml" ContentType="application/vnd.openxmlformats-package.core-properties+xml"/>
  <Default Extension="rels" ContentType="application/vnd.openxmlformats-package.relationships+xml"/>
  <Override PartName="/ppt/slideLayouts/slideLayout6.xml" ContentType="application/vnd.openxmlformats-officedocument.presentationml.slideLayout+xml"/>
  <Override PartName="/ppt/slideLayouts/slideLayout8.xml" ContentType="application/vnd.openxmlformats-officedocument.presentationml.slideLayout+xml"/>
  <Override PartName="/ppt/slideLayouts/slideLayout1.xml" ContentType="application/vnd.openxmlformats-officedocument.presentationml.slideLayout+xml"/>
  <Override PartName="/ppt/slideLayouts/slideLayout11.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docProps/app.xml" ContentType="application/vnd.openxmlformats-officedocument.extended-properties+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slideLayouts/slideLayout5.xml" ContentType="application/vnd.openxmlformats-officedocument.presentationml.slideLayout+xml"/>
  <Override PartName="/ppt/theme/theme2.xml" ContentType="application/vnd.openxmlformats-officedocument.theme+xml"/>
  <Override PartName="/ppt/viewProps.xml" ContentType="application/vnd.openxmlformats-officedocument.presentationml.viewProps+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2.xml" ContentType="application/vnd.openxmlformats-officedocument.presentationml.slideLayout+xml"/>
  <Default Extension="bin" ContentType="application/vnd.openxmlformats-officedocument.presentationml.printerSettings"/>
  <Override PartName="/ppt/slides/slide1.xml" ContentType="application/vnd.openxmlformats-officedocument.presentationml.slide+xml"/>
  <Default Extension="jpeg" ContentType="image/jpeg"/>
  <Override PartName="/ppt/slideLayouts/slideLayout4.xml" ContentType="application/vnd.openxmlformats-officedocument.presentationml.slideLayout+xml"/>
  <Override PartName="/ppt/tableStyles.xml" ContentType="application/vnd.openxmlformats-officedocument.presentationml.tableStyles+xml"/>
  <Override PartName="/ppt/theme/theme1.xml" ContentType="application/vnd.openxmlformats-officedocument.theme+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saveSubsetFonts="1" autoCompressPictures="0">
  <p:sldMasterIdLst>
    <p:sldMasterId id="2147483648" r:id="rId1"/>
  </p:sldMasterIdLst>
  <p:notesMasterIdLst>
    <p:notesMasterId r:id="rId3"/>
  </p:notesMasterIdLst>
  <p:sldIdLst>
    <p:sldId id="257"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normalViewPr>
    <p:restoredLeft sz="15620"/>
    <p:restoredTop sz="94660"/>
  </p:normalViewPr>
  <p:slideViewPr>
    <p:cSldViewPr snapToGrid="0" snapToObjects="1" showGuides="1">
      <p:cViewPr varScale="1">
        <p:scale>
          <a:sx n="94" d="100"/>
          <a:sy n="94" d="100"/>
        </p:scale>
        <p:origin x="-424" y="-96"/>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1E0A1B6-C577-C642-9E78-4FC0261DDDD5}" type="datetimeFigureOut">
              <a:rPr lang="en-US" smtClean="0"/>
              <a:pPr/>
              <a:t>3/22/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955B2C8-2A2E-8748-8F63-8A816BF03C80}"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Fig 1. </a:t>
            </a:r>
            <a:r>
              <a:rPr lang="en-US" baseline="0" dirty="0" smtClean="0"/>
              <a:t> </a:t>
            </a:r>
            <a:r>
              <a:rPr lang="en-US" b="1" baseline="0" dirty="0" smtClean="0"/>
              <a:t>Euler diagram of </a:t>
            </a:r>
            <a:r>
              <a:rPr lang="en-US" b="1" baseline="0" dirty="0" err="1" smtClean="0"/>
              <a:t>CTAb</a:t>
            </a:r>
            <a:r>
              <a:rPr lang="en-US" b="1" baseline="0" dirty="0" smtClean="0"/>
              <a:t> in the context of functional antibodies to an enveloped virus.  a.  </a:t>
            </a:r>
            <a:r>
              <a:rPr lang="en-US" b="0" baseline="0" dirty="0" smtClean="0"/>
              <a:t>Within the total population virus-reactive antibodies that arise in an individual host, some can be demonstrated to protect against disease caused by the homologous virus, and a subset of these are broadly protective against related viruses.  </a:t>
            </a:r>
            <a:r>
              <a:rPr lang="en-US" b="1" baseline="0" dirty="0" err="1" smtClean="0"/>
              <a:t>b</a:t>
            </a:r>
            <a:r>
              <a:rPr lang="en-US" b="1" baseline="0" dirty="0" smtClean="0"/>
              <a:t>.</a:t>
            </a:r>
            <a:r>
              <a:rPr lang="en-US" b="0" baseline="0" dirty="0" smtClean="0"/>
              <a:t>  Among the antibodies that can be defined as virus-neutralizing </a:t>
            </a:r>
            <a:r>
              <a:rPr lang="en-US" b="0" i="1" baseline="0" dirty="0" smtClean="0"/>
              <a:t>in vitro </a:t>
            </a:r>
            <a:r>
              <a:rPr lang="en-US" b="0" i="0" baseline="0" dirty="0" smtClean="0"/>
              <a:t>through any of several mechanisms and assays </a:t>
            </a:r>
            <a:r>
              <a:rPr lang="en-US" b="0" baseline="0" dirty="0" smtClean="0"/>
              <a:t>(see text), some are broadly neutralizing (BN), many but not all are protective </a:t>
            </a:r>
            <a:r>
              <a:rPr lang="en-US" b="0" i="1" baseline="0" dirty="0" smtClean="0"/>
              <a:t>in vivo</a:t>
            </a:r>
            <a:r>
              <a:rPr lang="en-US" b="0" baseline="0" dirty="0" smtClean="0"/>
              <a:t>, and neutralizing antibodies do not account for all protective antibodies. </a:t>
            </a:r>
            <a:r>
              <a:rPr lang="en-US" b="1" baseline="0" dirty="0" err="1" smtClean="0"/>
              <a:t>c</a:t>
            </a:r>
            <a:r>
              <a:rPr lang="en-US" b="0" baseline="0" dirty="0" smtClean="0"/>
              <a:t>.  Antibodies responsible for antibody-dependent cell-mediated </a:t>
            </a:r>
            <a:r>
              <a:rPr lang="en-US" b="0" baseline="0" dirty="0" err="1" smtClean="0"/>
              <a:t>cytotoxicity</a:t>
            </a:r>
            <a:r>
              <a:rPr lang="en-US" b="0" baseline="0" dirty="0" smtClean="0"/>
              <a:t> (ADCC) and complement-mediated cytolysis (CMC) form distinct but highly overlapping sets, and depending upon the antigen (as well as </a:t>
            </a:r>
            <a:r>
              <a:rPr lang="en-US" b="0" baseline="0" dirty="0" err="1" smtClean="0"/>
              <a:t>Ig</a:t>
            </a:r>
            <a:r>
              <a:rPr lang="en-US" b="0" baseline="0" dirty="0" smtClean="0"/>
              <a:t> </a:t>
            </a:r>
            <a:r>
              <a:rPr lang="en-US" b="0" baseline="0" dirty="0" err="1" smtClean="0"/>
              <a:t>isotype</a:t>
            </a:r>
            <a:r>
              <a:rPr lang="en-US" b="0" baseline="0" dirty="0" smtClean="0"/>
              <a:t> and other factors) may include a high proportion of neutralizing antibodies.  “Other” protective antibodies are described elsewhere (Schmaljohn 2013) </a:t>
            </a:r>
            <a:r>
              <a:rPr lang="en-US" b="1" baseline="0" dirty="0" err="1" smtClean="0"/>
              <a:t>d</a:t>
            </a:r>
            <a:r>
              <a:rPr lang="en-US" b="0" baseline="0" dirty="0" smtClean="0"/>
              <a:t>.  Antibodies of all types may occasionally be harmful to the host through mechanisms that include autoimmunity, antibody-dependent enhancement of viral infection, increased virus-specific </a:t>
            </a:r>
            <a:r>
              <a:rPr lang="en-US" b="0" baseline="0" dirty="0" err="1" smtClean="0"/>
              <a:t>immunopathology</a:t>
            </a:r>
            <a:r>
              <a:rPr lang="en-US" b="0" baseline="0" dirty="0" smtClean="0"/>
              <a:t>, displacing or functionally blocking otherwise-protective antibodies, or creating immunosuppressive immune complexes. Some antibodies may be categorized as both protective and harmful, with outcome depending on such things as antibody concentration, timing of antibody arrival relative to viral load, and host variations in inflammatory response.  It can further be inferred that a single antibody specificity (as defined by </a:t>
            </a:r>
            <a:r>
              <a:rPr lang="en-US" b="0" baseline="0" dirty="0" err="1" smtClean="0"/>
              <a:t>clonal</a:t>
            </a:r>
            <a:r>
              <a:rPr lang="en-US" b="0" baseline="0" dirty="0" smtClean="0"/>
              <a:t> lineage and </a:t>
            </a:r>
            <a:r>
              <a:rPr lang="en-US" b="0" baseline="0" dirty="0" err="1" smtClean="0"/>
              <a:t>paratope</a:t>
            </a:r>
            <a:r>
              <a:rPr lang="en-US" b="0" baseline="0" dirty="0" smtClean="0"/>
              <a:t>) may be protective, harmful, or impotent depending upon </a:t>
            </a:r>
            <a:r>
              <a:rPr lang="en-US" b="0" baseline="0" dirty="0" err="1" smtClean="0"/>
              <a:t>Ig</a:t>
            </a:r>
            <a:r>
              <a:rPr lang="en-US" b="0" baseline="0" dirty="0" smtClean="0"/>
              <a:t> </a:t>
            </a:r>
            <a:r>
              <a:rPr lang="en-US" b="0" baseline="0" dirty="0" err="1" smtClean="0"/>
              <a:t>isotype</a:t>
            </a:r>
            <a:r>
              <a:rPr lang="en-US" b="0" baseline="0" dirty="0" smtClean="0"/>
              <a:t> and its consequences.  </a:t>
            </a:r>
            <a:r>
              <a:rPr lang="en-US" b="1" baseline="0" dirty="0" err="1" smtClean="0"/>
              <a:t>e</a:t>
            </a:r>
            <a:r>
              <a:rPr lang="en-US" b="1" baseline="0" dirty="0" smtClean="0"/>
              <a:t>.</a:t>
            </a:r>
            <a:r>
              <a:rPr lang="en-US" b="0" baseline="0" dirty="0" smtClean="0"/>
              <a:t>  Cell-targeting antibodies (</a:t>
            </a:r>
            <a:r>
              <a:rPr lang="en-US" b="0" baseline="0" dirty="0" err="1" smtClean="0"/>
              <a:t>CTAb</a:t>
            </a:r>
            <a:r>
              <a:rPr lang="en-US" b="0" baseline="0" dirty="0" smtClean="0"/>
              <a:t>), often </a:t>
            </a:r>
            <a:r>
              <a:rPr lang="en-US" b="0" baseline="0" dirty="0" err="1" smtClean="0"/>
              <a:t>polyfunctional</a:t>
            </a:r>
            <a:r>
              <a:rPr lang="en-US" b="0" baseline="0" dirty="0" smtClean="0"/>
              <a:t>, are those that bind viral antigen on virus-infected (and sometimes uninfected but virus-sensitized) cells, potentially marking cells for damage or destruction by </a:t>
            </a:r>
            <a:r>
              <a:rPr lang="en-US" b="0" baseline="0" dirty="0" err="1" smtClean="0"/>
              <a:t>FcR</a:t>
            </a:r>
            <a:r>
              <a:rPr lang="en-US" b="0" baseline="0" dirty="0" smtClean="0"/>
              <a:t>-bearing cells before peak viral production by the antigen-bearing cells.   Antibody-mediated protection </a:t>
            </a:r>
            <a:r>
              <a:rPr lang="en-US" b="0" i="1" baseline="0" dirty="0" smtClean="0"/>
              <a:t>in vivo </a:t>
            </a:r>
            <a:r>
              <a:rPr lang="en-US" b="0" baseline="0" dirty="0" smtClean="0"/>
              <a:t>is very often dependent upon </a:t>
            </a:r>
            <a:r>
              <a:rPr lang="en-US" b="0" baseline="0" dirty="0" err="1" smtClean="0"/>
              <a:t>Fc-FcR</a:t>
            </a:r>
            <a:r>
              <a:rPr lang="en-US" b="0" baseline="0" dirty="0" smtClean="0"/>
              <a:t> interactions regardless of whether antibodies are also categorized as neutralizing.  </a:t>
            </a:r>
            <a:r>
              <a:rPr lang="en-US" b="0" baseline="0" dirty="0" err="1" smtClean="0"/>
              <a:t>Opsonization</a:t>
            </a:r>
            <a:r>
              <a:rPr lang="en-US" b="0" baseline="0" dirty="0" smtClean="0"/>
              <a:t> facilitated by antibodies against </a:t>
            </a:r>
            <a:r>
              <a:rPr lang="en-US" b="0" baseline="0" dirty="0" err="1" smtClean="0"/>
              <a:t>virion</a:t>
            </a:r>
            <a:r>
              <a:rPr lang="en-US" b="0" baseline="0" dirty="0" smtClean="0"/>
              <a:t> surfaces may play a role </a:t>
            </a:r>
            <a:r>
              <a:rPr lang="en-US" b="0" i="1" baseline="0" dirty="0" smtClean="0"/>
              <a:t>in vivo</a:t>
            </a:r>
            <a:r>
              <a:rPr lang="en-US" b="0" baseline="0" dirty="0" smtClean="0"/>
              <a:t>, but the larger body of </a:t>
            </a:r>
            <a:r>
              <a:rPr lang="en-US" b="0" baseline="0" dirty="0" err="1" smtClean="0"/>
              <a:t>virological</a:t>
            </a:r>
            <a:r>
              <a:rPr lang="en-US" b="0" baseline="0" dirty="0" smtClean="0"/>
              <a:t> evidence points toward </a:t>
            </a:r>
            <a:r>
              <a:rPr lang="en-US" b="0" baseline="0" dirty="0" err="1" smtClean="0"/>
              <a:t>CTAb</a:t>
            </a:r>
            <a:r>
              <a:rPr lang="en-US" b="0" baseline="0" dirty="0" smtClean="0"/>
              <a:t> mediating protection in concert with </a:t>
            </a:r>
            <a:r>
              <a:rPr lang="en-US" b="0" baseline="0" dirty="0" err="1" smtClean="0"/>
              <a:t>FcR</a:t>
            </a:r>
            <a:r>
              <a:rPr lang="en-US" b="0" baseline="0" dirty="0" smtClean="0"/>
              <a:t>-bearing cells of various types.</a:t>
            </a:r>
          </a:p>
          <a:p>
            <a:pPr marL="0" marR="0" indent="0" algn="l" defTabSz="457200" rtl="0" eaLnBrk="1" fontAlgn="auto" latinLnBrk="0" hangingPunct="1">
              <a:lnSpc>
                <a:spcPct val="100000"/>
              </a:lnSpc>
              <a:spcBef>
                <a:spcPts val="0"/>
              </a:spcBef>
              <a:spcAft>
                <a:spcPts val="0"/>
              </a:spcAft>
              <a:buClrTx/>
              <a:buSzTx/>
              <a:buFontTx/>
              <a:buNone/>
              <a:tabLst/>
              <a:defRPr/>
            </a:pPr>
            <a:endParaRPr lang="en-US" b="0" baseline="0" dirty="0" smtClean="0"/>
          </a:p>
        </p:txBody>
      </p:sp>
      <p:sp>
        <p:nvSpPr>
          <p:cNvPr id="4" name="Slide Number Placeholder 3"/>
          <p:cNvSpPr>
            <a:spLocks noGrp="1"/>
          </p:cNvSpPr>
          <p:nvPr>
            <p:ph type="sldNum" sz="quarter" idx="10"/>
          </p:nvPr>
        </p:nvSpPr>
        <p:spPr/>
        <p:txBody>
          <a:bodyPr/>
          <a:lstStyle/>
          <a:p>
            <a:fld id="{02903ACE-2D3C-1F42-90BF-CA81E7489A3D}" type="slidenum">
              <a:rPr lang="en-US" smtClean="0">
                <a:solidFill>
                  <a:prstClr val="black"/>
                </a:solidFill>
              </a:rPr>
              <a:pPr/>
              <a:t>1</a:t>
            </a:fld>
            <a:endParaRPr lang="en-US">
              <a:solidFill>
                <a:prstClr val="black"/>
              </a:solidFill>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D581587-7E5E-EB4F-A8E1-836377B979B2}" type="datetimeFigureOut">
              <a:rPr lang="en-US" smtClean="0"/>
              <a:pPr/>
              <a:t>3/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D581587-7E5E-EB4F-A8E1-836377B979B2}" type="datetimeFigureOut">
              <a:rPr lang="en-US" smtClean="0"/>
              <a:pPr/>
              <a:t>3/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D581587-7E5E-EB4F-A8E1-836377B979B2}" type="datetimeFigureOut">
              <a:rPr lang="en-US" smtClean="0"/>
              <a:pPr/>
              <a:t>3/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D581587-7E5E-EB4F-A8E1-836377B979B2}" type="datetimeFigureOut">
              <a:rPr lang="en-US" smtClean="0"/>
              <a:pPr/>
              <a:t>3/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D581587-7E5E-EB4F-A8E1-836377B979B2}" type="datetimeFigureOut">
              <a:rPr lang="en-US" smtClean="0"/>
              <a:pPr/>
              <a:t>3/22/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D581587-7E5E-EB4F-A8E1-836377B979B2}" type="datetimeFigureOut">
              <a:rPr lang="en-US" smtClean="0"/>
              <a:pPr/>
              <a:t>3/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D581587-7E5E-EB4F-A8E1-836377B979B2}" type="datetimeFigureOut">
              <a:rPr lang="en-US" smtClean="0"/>
              <a:pPr/>
              <a:t>3/22/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D581587-7E5E-EB4F-A8E1-836377B979B2}" type="datetimeFigureOut">
              <a:rPr lang="en-US" smtClean="0"/>
              <a:pPr/>
              <a:t>3/22/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581587-7E5E-EB4F-A8E1-836377B979B2}" type="datetimeFigureOut">
              <a:rPr lang="en-US" smtClean="0"/>
              <a:pPr/>
              <a:t>3/22/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D581587-7E5E-EB4F-A8E1-836377B979B2}" type="datetimeFigureOut">
              <a:rPr lang="en-US" smtClean="0"/>
              <a:pPr/>
              <a:t>3/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D581587-7E5E-EB4F-A8E1-836377B979B2}" type="datetimeFigureOut">
              <a:rPr lang="en-US" smtClean="0"/>
              <a:pPr/>
              <a:t>3/22/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7752B-8D18-2F4D-BD69-6D00BB45676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D581587-7E5E-EB4F-A8E1-836377B979B2}" type="datetimeFigureOut">
              <a:rPr lang="en-US" smtClean="0"/>
              <a:pPr/>
              <a:t>3/22/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D7752B-8D18-2F4D-BD69-6D00BB45676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jpe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mc:Ignorable="mv" mc:PreserveAttributes="mv:*">
  <p:cSld>
    <p:spTree>
      <p:nvGrpSpPr>
        <p:cNvPr id="1" name=""/>
        <p:cNvGrpSpPr/>
        <p:nvPr/>
      </p:nvGrpSpPr>
      <p:grpSpPr>
        <a:xfrm>
          <a:off x="0" y="0"/>
          <a:ext cx="0" cy="0"/>
          <a:chOff x="0" y="0"/>
          <a:chExt cx="0" cy="0"/>
        </a:xfrm>
      </p:grpSpPr>
      <p:grpSp>
        <p:nvGrpSpPr>
          <p:cNvPr id="30" name="Group 23"/>
          <p:cNvGrpSpPr/>
          <p:nvPr/>
        </p:nvGrpSpPr>
        <p:grpSpPr>
          <a:xfrm>
            <a:off x="3849678" y="1519239"/>
            <a:ext cx="4742252" cy="3364010"/>
            <a:chOff x="2711960" y="1670401"/>
            <a:chExt cx="4742251" cy="3364010"/>
          </a:xfrm>
        </p:grpSpPr>
        <p:sp>
          <p:nvSpPr>
            <p:cNvPr id="130" name="TextBox 25"/>
            <p:cNvSpPr txBox="1"/>
            <p:nvPr/>
          </p:nvSpPr>
          <p:spPr>
            <a:xfrm>
              <a:off x="5354273" y="4388080"/>
              <a:ext cx="2099938" cy="646331"/>
            </a:xfrm>
            <a:prstGeom prst="rect">
              <a:avLst/>
            </a:prstGeom>
            <a:noFill/>
          </p:spPr>
          <p:txBody>
            <a:bodyPr wrap="square" rtlCol="0">
              <a:spAutoFit/>
            </a:bodyPr>
            <a:lstStyle/>
            <a:p>
              <a:pPr algn="ctr"/>
              <a:r>
                <a:rPr lang="en-US" b="1" dirty="0">
                  <a:solidFill>
                    <a:prstClr val="black"/>
                  </a:solidFill>
                </a:rPr>
                <a:t>Viral Antigen-Binding (Total)</a:t>
              </a:r>
            </a:p>
          </p:txBody>
        </p:sp>
        <p:sp>
          <p:nvSpPr>
            <p:cNvPr id="128" name="Oval 18"/>
            <p:cNvSpPr/>
            <p:nvPr/>
          </p:nvSpPr>
          <p:spPr>
            <a:xfrm>
              <a:off x="2711960" y="1670401"/>
              <a:ext cx="3011655" cy="2963382"/>
            </a:xfrm>
            <a:prstGeom prst="ellipse">
              <a:avLst/>
            </a:prstGeom>
            <a:blipFill rotWithShape="1">
              <a:blip r:embed="rId3"/>
              <a:tile tx="0" ty="0" sx="100000" sy="100000" flip="none" algn="tl"/>
            </a:blipFill>
            <a:ln w="12700" cap="flat" cmpd="sng" algn="ctr">
              <a:solidFill>
                <a:schemeClr val="accent1">
                  <a:shade val="95000"/>
                  <a:satMod val="105000"/>
                </a:schemeClr>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9" name="Right Arrow 21"/>
            <p:cNvSpPr/>
            <p:nvPr/>
          </p:nvSpPr>
          <p:spPr>
            <a:xfrm rot="13255950">
              <a:off x="5010846" y="4146648"/>
              <a:ext cx="747996" cy="152042"/>
            </a:xfrm>
            <a:prstGeom prst="rightArrow">
              <a:avLst/>
            </a:prstGeom>
            <a:noFill/>
            <a:ln w="12700" cap="flat" cmpd="sng" algn="ctr">
              <a:solidFill>
                <a:srgbClr val="FF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grpSp>
      <p:grpSp>
        <p:nvGrpSpPr>
          <p:cNvPr id="146" name="Group 145"/>
          <p:cNvGrpSpPr/>
          <p:nvPr/>
        </p:nvGrpSpPr>
        <p:grpSpPr>
          <a:xfrm>
            <a:off x="410615" y="740257"/>
            <a:ext cx="5779591" cy="2933126"/>
            <a:chOff x="410615" y="740257"/>
            <a:chExt cx="5779591" cy="2933126"/>
          </a:xfrm>
        </p:grpSpPr>
        <p:grpSp>
          <p:nvGrpSpPr>
            <p:cNvPr id="34" name="Group 26"/>
            <p:cNvGrpSpPr/>
            <p:nvPr/>
          </p:nvGrpSpPr>
          <p:grpSpPr>
            <a:xfrm>
              <a:off x="3962400" y="740257"/>
              <a:ext cx="2227806" cy="2933126"/>
              <a:chOff x="2836785" y="891423"/>
              <a:chExt cx="2227806" cy="2933126"/>
            </a:xfrm>
          </p:grpSpPr>
          <p:sp>
            <p:nvSpPr>
              <p:cNvPr id="122" name="Oval 4"/>
              <p:cNvSpPr/>
              <p:nvPr/>
            </p:nvSpPr>
            <p:spPr>
              <a:xfrm>
                <a:off x="3295608" y="2024484"/>
                <a:ext cx="1768983" cy="1800065"/>
              </a:xfrm>
              <a:prstGeom prst="ellipse">
                <a:avLst/>
              </a:prstGeom>
              <a:solidFill>
                <a:srgbClr val="00FF00">
                  <a:alpha val="75000"/>
                </a:srgb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3" name="Right Arrow 9"/>
              <p:cNvSpPr/>
              <p:nvPr/>
            </p:nvSpPr>
            <p:spPr>
              <a:xfrm rot="4410453">
                <a:off x="3607639" y="1746662"/>
                <a:ext cx="653771" cy="152400"/>
              </a:xfrm>
              <a:prstGeom prst="rightArrow">
                <a:avLst/>
              </a:prstGeom>
              <a:solidFill>
                <a:srgbClr val="00FF00"/>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4" name="TextBox 16"/>
              <p:cNvSpPr txBox="1"/>
              <p:nvPr/>
            </p:nvSpPr>
            <p:spPr>
              <a:xfrm>
                <a:off x="2836785" y="891423"/>
                <a:ext cx="1410102" cy="553998"/>
              </a:xfrm>
              <a:prstGeom prst="rect">
                <a:avLst/>
              </a:prstGeom>
              <a:noFill/>
            </p:spPr>
            <p:txBody>
              <a:bodyPr wrap="square" rtlCol="0">
                <a:spAutoFit/>
              </a:bodyPr>
              <a:lstStyle/>
              <a:p>
                <a:pPr algn="ctr"/>
                <a:r>
                  <a:rPr lang="en-US" b="1" dirty="0" smtClean="0">
                    <a:solidFill>
                      <a:prstClr val="black"/>
                    </a:solidFill>
                  </a:rPr>
                  <a:t>Protective* </a:t>
                </a:r>
                <a:r>
                  <a:rPr lang="en-US" sz="1200" b="1" i="1" dirty="0">
                    <a:solidFill>
                      <a:prstClr val="black"/>
                    </a:solidFill>
                  </a:rPr>
                  <a:t>in vivo</a:t>
                </a:r>
              </a:p>
            </p:txBody>
          </p:sp>
        </p:grpSp>
        <p:sp>
          <p:nvSpPr>
            <p:cNvPr id="145" name="TextBox 144"/>
            <p:cNvSpPr txBox="1"/>
            <p:nvPr/>
          </p:nvSpPr>
          <p:spPr>
            <a:xfrm>
              <a:off x="410615" y="1060906"/>
              <a:ext cx="3439063" cy="1754327"/>
            </a:xfrm>
            <a:prstGeom prst="rect">
              <a:avLst/>
            </a:prstGeom>
            <a:noFill/>
          </p:spPr>
          <p:txBody>
            <a:bodyPr wrap="square" rtlCol="0">
              <a:spAutoFit/>
            </a:bodyPr>
            <a:lstStyle/>
            <a:p>
              <a:r>
                <a:rPr lang="en-US" i="1" dirty="0" smtClean="0">
                  <a:solidFill>
                    <a:srgbClr val="000000"/>
                  </a:solidFill>
                </a:rPr>
                <a:t>*Protective Abs may act against viruses to:</a:t>
              </a:r>
            </a:p>
            <a:p>
              <a:pPr>
                <a:tabLst>
                  <a:tab pos="227013" algn="l"/>
                </a:tabLst>
              </a:pPr>
              <a:r>
                <a:rPr lang="en-US" i="1" dirty="0" smtClean="0">
                  <a:solidFill>
                    <a:srgbClr val="000000"/>
                  </a:solidFill>
                </a:rPr>
                <a:t>	a) </a:t>
              </a:r>
              <a:r>
                <a:rPr lang="en-US" b="1" i="1" dirty="0" smtClean="0">
                  <a:solidFill>
                    <a:srgbClr val="000000"/>
                  </a:solidFill>
                </a:rPr>
                <a:t>prevent</a:t>
              </a:r>
              <a:r>
                <a:rPr lang="en-US" i="1" dirty="0" smtClean="0">
                  <a:solidFill>
                    <a:srgbClr val="000000"/>
                  </a:solidFill>
                </a:rPr>
                <a:t> infection/acquisition</a:t>
              </a:r>
            </a:p>
            <a:p>
              <a:pPr>
                <a:tabLst>
                  <a:tab pos="227013" algn="l"/>
                </a:tabLst>
              </a:pPr>
              <a:r>
                <a:rPr lang="en-US" i="1" dirty="0" smtClean="0">
                  <a:solidFill>
                    <a:srgbClr val="000000"/>
                  </a:solidFill>
                </a:rPr>
                <a:t>	</a:t>
              </a:r>
              <a:r>
                <a:rPr lang="en-US" i="1" dirty="0" err="1" smtClean="0">
                  <a:solidFill>
                    <a:srgbClr val="000000"/>
                  </a:solidFill>
                </a:rPr>
                <a:t>b</a:t>
              </a:r>
              <a:r>
                <a:rPr lang="en-US" i="1" dirty="0" smtClean="0">
                  <a:solidFill>
                    <a:srgbClr val="000000"/>
                  </a:solidFill>
                </a:rPr>
                <a:t>) </a:t>
              </a:r>
              <a:r>
                <a:rPr lang="en-US" b="1" i="1" dirty="0" smtClean="0">
                  <a:solidFill>
                    <a:srgbClr val="000000"/>
                  </a:solidFill>
                </a:rPr>
                <a:t>limit</a:t>
              </a:r>
              <a:r>
                <a:rPr lang="en-US" i="1" dirty="0" smtClean="0">
                  <a:solidFill>
                    <a:srgbClr val="000000"/>
                  </a:solidFill>
                </a:rPr>
                <a:t> infection/disease (post-infection control, reduced transmission)</a:t>
              </a:r>
            </a:p>
          </p:txBody>
        </p:sp>
      </p:grpSp>
      <p:grpSp>
        <p:nvGrpSpPr>
          <p:cNvPr id="32" name="Group 29"/>
          <p:cNvGrpSpPr/>
          <p:nvPr/>
        </p:nvGrpSpPr>
        <p:grpSpPr>
          <a:xfrm>
            <a:off x="4682473" y="2428036"/>
            <a:ext cx="4039389" cy="2042528"/>
            <a:chOff x="3587576" y="2579202"/>
            <a:chExt cx="4039390" cy="2042528"/>
          </a:xfrm>
        </p:grpSpPr>
        <p:sp>
          <p:nvSpPr>
            <p:cNvPr id="125" name="Oval 6"/>
            <p:cNvSpPr/>
            <p:nvPr/>
          </p:nvSpPr>
          <p:spPr>
            <a:xfrm>
              <a:off x="3587576" y="2579202"/>
              <a:ext cx="1768983" cy="1341006"/>
            </a:xfrm>
            <a:prstGeom prst="ellipse">
              <a:avLst/>
            </a:prstGeom>
            <a:solidFill>
              <a:srgbClr val="FF6600">
                <a:alpha val="50000"/>
              </a:srgb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6" name="Right Arrow 13"/>
            <p:cNvSpPr/>
            <p:nvPr/>
          </p:nvSpPr>
          <p:spPr>
            <a:xfrm rot="10800000">
              <a:off x="5030571" y="3524277"/>
              <a:ext cx="1291231" cy="152400"/>
            </a:xfrm>
            <a:prstGeom prst="rightArrow">
              <a:avLst/>
            </a:prstGeom>
            <a:solidFill>
              <a:srgbClr val="FF6600"/>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7" name="TextBox 14"/>
            <p:cNvSpPr txBox="1"/>
            <p:nvPr/>
          </p:nvSpPr>
          <p:spPr>
            <a:xfrm>
              <a:off x="5813345" y="3421401"/>
              <a:ext cx="1813621" cy="1200329"/>
            </a:xfrm>
            <a:prstGeom prst="rect">
              <a:avLst/>
            </a:prstGeom>
            <a:noFill/>
          </p:spPr>
          <p:txBody>
            <a:bodyPr wrap="square" rtlCol="0">
              <a:spAutoFit/>
            </a:bodyPr>
            <a:lstStyle/>
            <a:p>
              <a:pPr lvl="0" algn="ctr"/>
              <a:r>
                <a:rPr lang="en-US" b="1" dirty="0">
                  <a:solidFill>
                    <a:prstClr val="black"/>
                  </a:solidFill>
                </a:rPr>
                <a:t>CMC</a:t>
              </a:r>
              <a:r>
                <a:rPr lang="en-US" b="1" dirty="0" smtClean="0">
                  <a:solidFill>
                    <a:prstClr val="black"/>
                  </a:solidFill>
                </a:rPr>
                <a:t> </a:t>
              </a:r>
            </a:p>
            <a:p>
              <a:pPr lvl="0" algn="ctr"/>
              <a:r>
                <a:rPr lang="en-US" sz="1200" b="1" dirty="0" smtClean="0">
                  <a:solidFill>
                    <a:prstClr val="black"/>
                  </a:solidFill>
                </a:rPr>
                <a:t>(</a:t>
              </a:r>
              <a:r>
                <a:rPr lang="en-US" sz="1200" b="1" dirty="0">
                  <a:solidFill>
                    <a:prstClr val="black"/>
                  </a:solidFill>
                </a:rPr>
                <a:t>antibody-dependent complement-mediated </a:t>
              </a:r>
              <a:r>
                <a:rPr lang="en-US" sz="1200" b="1" dirty="0" err="1">
                  <a:solidFill>
                    <a:prstClr val="black"/>
                  </a:solidFill>
                </a:rPr>
                <a:t>cytotoxicity</a:t>
              </a:r>
              <a:r>
                <a:rPr lang="en-US" sz="1200" b="1" dirty="0">
                  <a:solidFill>
                    <a:prstClr val="black"/>
                  </a:solidFill>
                </a:rPr>
                <a:t>)</a:t>
              </a:r>
            </a:p>
            <a:p>
              <a:pPr algn="ctr"/>
              <a:endParaRPr lang="en-US" b="1" dirty="0">
                <a:solidFill>
                  <a:prstClr val="black"/>
                </a:solidFill>
              </a:endParaRPr>
            </a:p>
          </p:txBody>
        </p:sp>
      </p:grpSp>
      <p:grpSp>
        <p:nvGrpSpPr>
          <p:cNvPr id="39" name="Group 30"/>
          <p:cNvGrpSpPr/>
          <p:nvPr/>
        </p:nvGrpSpPr>
        <p:grpSpPr>
          <a:xfrm>
            <a:off x="5599967" y="1171436"/>
            <a:ext cx="2705378" cy="1107996"/>
            <a:chOff x="4474357" y="1322519"/>
            <a:chExt cx="2705379" cy="1107996"/>
          </a:xfrm>
        </p:grpSpPr>
        <p:sp>
          <p:nvSpPr>
            <p:cNvPr id="120" name="Right Arrow 10"/>
            <p:cNvSpPr/>
            <p:nvPr/>
          </p:nvSpPr>
          <p:spPr>
            <a:xfrm rot="8832618">
              <a:off x="4474357" y="1816551"/>
              <a:ext cx="1274900" cy="205521"/>
            </a:xfrm>
            <a:prstGeom prst="rightArrow">
              <a:avLst/>
            </a:prstGeom>
            <a:noFill/>
            <a:ln w="12700" cap="flat" cmpd="sng" algn="ctr">
              <a:solidFill>
                <a:schemeClr val="tx1"/>
              </a:solidFill>
              <a:prstDash val="sysDash"/>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21" name="TextBox 120"/>
            <p:cNvSpPr txBox="1"/>
            <p:nvPr/>
          </p:nvSpPr>
          <p:spPr>
            <a:xfrm>
              <a:off x="5033626" y="1322519"/>
              <a:ext cx="2146110" cy="1107996"/>
            </a:xfrm>
            <a:prstGeom prst="rect">
              <a:avLst/>
            </a:prstGeom>
            <a:noFill/>
          </p:spPr>
          <p:txBody>
            <a:bodyPr wrap="square" rtlCol="0">
              <a:spAutoFit/>
            </a:bodyPr>
            <a:lstStyle/>
            <a:p>
              <a:pPr algn="ctr"/>
              <a:r>
                <a:rPr lang="en-US" b="1" dirty="0" smtClean="0">
                  <a:solidFill>
                    <a:prstClr val="black"/>
                  </a:solidFill>
                </a:rPr>
                <a:t>Other </a:t>
              </a:r>
            </a:p>
            <a:p>
              <a:pPr algn="ctr"/>
              <a:r>
                <a:rPr lang="en-US" sz="1200" b="1" dirty="0" smtClean="0">
                  <a:solidFill>
                    <a:prstClr val="black"/>
                  </a:solidFill>
                </a:rPr>
                <a:t>(</a:t>
              </a:r>
              <a:r>
                <a:rPr lang="en-US" sz="1200" b="1" dirty="0">
                  <a:solidFill>
                    <a:prstClr val="black"/>
                  </a:solidFill>
                </a:rPr>
                <a:t>e.g., </a:t>
              </a:r>
              <a:r>
                <a:rPr lang="en-US" sz="1200" b="1" dirty="0" err="1">
                  <a:solidFill>
                    <a:prstClr val="black"/>
                  </a:solidFill>
                </a:rPr>
                <a:t>opsonization</a:t>
              </a:r>
              <a:r>
                <a:rPr lang="en-US" sz="1200" b="1" dirty="0">
                  <a:solidFill>
                    <a:prstClr val="black"/>
                  </a:solidFill>
                </a:rPr>
                <a:t>, </a:t>
              </a:r>
              <a:r>
                <a:rPr lang="en-US" sz="1200" b="1" dirty="0" err="1">
                  <a:solidFill>
                    <a:prstClr val="black"/>
                  </a:solidFill>
                </a:rPr>
                <a:t>phagocytosis</a:t>
              </a:r>
              <a:r>
                <a:rPr lang="en-US" sz="1200" b="1" dirty="0">
                  <a:solidFill>
                    <a:prstClr val="black"/>
                  </a:solidFill>
                </a:rPr>
                <a:t>, </a:t>
              </a:r>
            </a:p>
            <a:p>
              <a:pPr algn="ctr"/>
              <a:r>
                <a:rPr lang="en-US" sz="1200" b="1" dirty="0">
                  <a:solidFill>
                    <a:prstClr val="black"/>
                  </a:solidFill>
                </a:rPr>
                <a:t>inhibition of </a:t>
              </a:r>
              <a:r>
                <a:rPr lang="en-US" sz="1200" b="1" dirty="0" err="1">
                  <a:solidFill>
                    <a:prstClr val="black"/>
                  </a:solidFill>
                </a:rPr>
                <a:t>virokines</a:t>
              </a:r>
              <a:r>
                <a:rPr lang="en-US" sz="1200" b="1" dirty="0">
                  <a:solidFill>
                    <a:prstClr val="black"/>
                  </a:solidFill>
                </a:rPr>
                <a:t>) </a:t>
              </a:r>
            </a:p>
            <a:p>
              <a:pPr algn="ctr"/>
              <a:endParaRPr lang="en-US" sz="1200" b="1" dirty="0">
                <a:solidFill>
                  <a:prstClr val="black"/>
                </a:solidFill>
              </a:endParaRPr>
            </a:p>
          </p:txBody>
        </p:sp>
      </p:grpSp>
      <p:grpSp>
        <p:nvGrpSpPr>
          <p:cNvPr id="40" name="Group 31"/>
          <p:cNvGrpSpPr/>
          <p:nvPr/>
        </p:nvGrpSpPr>
        <p:grpSpPr>
          <a:xfrm>
            <a:off x="716117" y="2147719"/>
            <a:ext cx="5254465" cy="3772218"/>
            <a:chOff x="-409496" y="2298878"/>
            <a:chExt cx="5254465" cy="3772218"/>
          </a:xfrm>
        </p:grpSpPr>
        <p:sp>
          <p:nvSpPr>
            <p:cNvPr id="117" name="Oval 5"/>
            <p:cNvSpPr/>
            <p:nvPr/>
          </p:nvSpPr>
          <p:spPr>
            <a:xfrm>
              <a:off x="3908985" y="2298878"/>
              <a:ext cx="935984" cy="2189764"/>
            </a:xfrm>
            <a:prstGeom prst="ellipse">
              <a:avLst/>
            </a:prstGeom>
            <a:solidFill>
              <a:schemeClr val="bg1">
                <a:lumMod val="75000"/>
                <a:alpha val="50000"/>
              </a:scheme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18" name="Right Arrow 11"/>
            <p:cNvSpPr/>
            <p:nvPr/>
          </p:nvSpPr>
          <p:spPr>
            <a:xfrm rot="20531054" flipV="1">
              <a:off x="1949270" y="4415482"/>
              <a:ext cx="2383337" cy="220798"/>
            </a:xfrm>
            <a:prstGeom prst="rightArrow">
              <a:avLst/>
            </a:prstGeom>
            <a:solidFill>
              <a:schemeClr val="bg1">
                <a:lumMod val="75000"/>
              </a:schemeClr>
            </a:solidFill>
            <a:ln w="12700" cap="flat" cmpd="sng" algn="ctr">
              <a:solidFill>
                <a:srgbClr val="FF0000"/>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19" name="TextBox 118"/>
            <p:cNvSpPr txBox="1"/>
            <p:nvPr/>
          </p:nvSpPr>
          <p:spPr>
            <a:xfrm>
              <a:off x="-409496" y="4778434"/>
              <a:ext cx="3705105" cy="1292662"/>
            </a:xfrm>
            <a:prstGeom prst="rect">
              <a:avLst/>
            </a:prstGeom>
            <a:noFill/>
          </p:spPr>
          <p:txBody>
            <a:bodyPr wrap="square" rtlCol="0">
              <a:spAutoFit/>
            </a:bodyPr>
            <a:lstStyle/>
            <a:p>
              <a:pPr lvl="0" algn="ctr"/>
              <a:r>
                <a:rPr lang="en-US" b="1" dirty="0">
                  <a:solidFill>
                    <a:prstClr val="black"/>
                  </a:solidFill>
                </a:rPr>
                <a:t>Harmful</a:t>
              </a:r>
              <a:r>
                <a:rPr lang="en-US" b="1" dirty="0" smtClean="0">
                  <a:solidFill>
                    <a:prstClr val="black"/>
                  </a:solidFill>
                </a:rPr>
                <a:t> </a:t>
              </a:r>
            </a:p>
            <a:p>
              <a:pPr lvl="0" algn="ctr"/>
              <a:r>
                <a:rPr lang="en-US" sz="1200" b="1" dirty="0" smtClean="0">
                  <a:solidFill>
                    <a:prstClr val="black"/>
                  </a:solidFill>
                </a:rPr>
                <a:t>(</a:t>
              </a:r>
              <a:r>
                <a:rPr lang="en-US" sz="1200" b="1" dirty="0">
                  <a:solidFill>
                    <a:prstClr val="black"/>
                  </a:solidFill>
                </a:rPr>
                <a:t>e.g. infection-enhancing and/or </a:t>
              </a:r>
              <a:r>
                <a:rPr lang="en-US" sz="1200" b="1" dirty="0" err="1">
                  <a:solidFill>
                    <a:prstClr val="black"/>
                  </a:solidFill>
                </a:rPr>
                <a:t>immunopathological</a:t>
              </a:r>
              <a:r>
                <a:rPr lang="en-US" sz="1200" b="1" dirty="0">
                  <a:solidFill>
                    <a:prstClr val="black"/>
                  </a:solidFill>
                </a:rPr>
                <a:t>; also includes</a:t>
              </a:r>
              <a:r>
                <a:rPr lang="en-US" sz="1200" b="1" dirty="0" smtClean="0">
                  <a:solidFill>
                    <a:prstClr val="black"/>
                  </a:solidFill>
                </a:rPr>
                <a:t> Abs </a:t>
              </a:r>
              <a:r>
                <a:rPr lang="en-US" sz="1200" b="1" dirty="0">
                  <a:solidFill>
                    <a:prstClr val="black"/>
                  </a:solidFill>
                </a:rPr>
                <a:t>that displace or functionally block otherwise-protective</a:t>
              </a:r>
              <a:r>
                <a:rPr lang="en-US" sz="1200" b="1" dirty="0" smtClean="0">
                  <a:solidFill>
                    <a:prstClr val="black"/>
                  </a:solidFill>
                </a:rPr>
                <a:t> Abs) </a:t>
              </a:r>
            </a:p>
            <a:p>
              <a:pPr lvl="0" algn="ctr"/>
              <a:r>
                <a:rPr lang="en-US" sz="1200" b="1" i="1" dirty="0" smtClean="0">
                  <a:solidFill>
                    <a:prstClr val="black"/>
                  </a:solidFill>
                </a:rPr>
                <a:t>Note that many specificities of </a:t>
              </a:r>
              <a:r>
                <a:rPr lang="en-US" sz="1200" b="1" i="1" dirty="0" err="1" smtClean="0">
                  <a:solidFill>
                    <a:prstClr val="black"/>
                  </a:solidFill>
                </a:rPr>
                <a:t>Ab</a:t>
              </a:r>
              <a:r>
                <a:rPr lang="en-US" sz="1200" b="1" i="1" dirty="0" smtClean="0">
                  <a:solidFill>
                    <a:prstClr val="black"/>
                  </a:solidFill>
                </a:rPr>
                <a:t> can be either helpful or harmful depending on amount, timing, </a:t>
              </a:r>
              <a:r>
                <a:rPr lang="en-US" sz="1200" b="1" i="1" dirty="0" err="1" smtClean="0">
                  <a:solidFill>
                    <a:prstClr val="black"/>
                  </a:solidFill>
                </a:rPr>
                <a:t>Fc</a:t>
              </a:r>
              <a:r>
                <a:rPr lang="en-US" sz="1200" b="1" i="1" dirty="0" smtClean="0">
                  <a:solidFill>
                    <a:prstClr val="black"/>
                  </a:solidFill>
                </a:rPr>
                <a:t>, etc.</a:t>
              </a:r>
            </a:p>
          </p:txBody>
        </p:sp>
      </p:grpSp>
      <p:grpSp>
        <p:nvGrpSpPr>
          <p:cNvPr id="41" name="Group 27"/>
          <p:cNvGrpSpPr/>
          <p:nvPr/>
        </p:nvGrpSpPr>
        <p:grpSpPr>
          <a:xfrm>
            <a:off x="1837583" y="2076569"/>
            <a:ext cx="3860031" cy="2446824"/>
            <a:chOff x="711970" y="2227652"/>
            <a:chExt cx="3860031" cy="2446824"/>
          </a:xfrm>
        </p:grpSpPr>
        <p:sp>
          <p:nvSpPr>
            <p:cNvPr id="114" name="Right Arrow 7"/>
            <p:cNvSpPr/>
            <p:nvPr/>
          </p:nvSpPr>
          <p:spPr>
            <a:xfrm rot="21349640">
              <a:off x="2462426" y="3511680"/>
              <a:ext cx="966267" cy="229221"/>
            </a:xfrm>
            <a:prstGeom prst="rightArrow">
              <a:avLst/>
            </a:prstGeom>
            <a:solidFill>
              <a:srgbClr val="00FFFF">
                <a:alpha val="50000"/>
              </a:srgbClr>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15" name="TextBox 12"/>
            <p:cNvSpPr txBox="1"/>
            <p:nvPr/>
          </p:nvSpPr>
          <p:spPr>
            <a:xfrm>
              <a:off x="711970" y="3474147"/>
              <a:ext cx="1816124" cy="1200329"/>
            </a:xfrm>
            <a:prstGeom prst="rect">
              <a:avLst/>
            </a:prstGeom>
            <a:noFill/>
          </p:spPr>
          <p:txBody>
            <a:bodyPr wrap="square" rtlCol="0">
              <a:spAutoFit/>
            </a:bodyPr>
            <a:lstStyle/>
            <a:p>
              <a:pPr lvl="0" algn="ctr"/>
              <a:r>
                <a:rPr lang="en-US" b="1" dirty="0" smtClean="0">
                  <a:solidFill>
                    <a:prstClr val="black"/>
                  </a:solidFill>
                </a:rPr>
                <a:t>Neutralization </a:t>
              </a:r>
            </a:p>
            <a:p>
              <a:pPr lvl="0" algn="ctr"/>
              <a:r>
                <a:rPr lang="en-US" sz="1200" b="1" dirty="0" smtClean="0">
                  <a:solidFill>
                    <a:prstClr val="black"/>
                  </a:solidFill>
                </a:rPr>
                <a:t>(an </a:t>
              </a:r>
              <a:r>
                <a:rPr lang="en-US" sz="1200" b="1" i="1" dirty="0" smtClean="0">
                  <a:solidFill>
                    <a:prstClr val="black"/>
                  </a:solidFill>
                </a:rPr>
                <a:t>in vitro </a:t>
              </a:r>
              <a:r>
                <a:rPr lang="en-US" sz="1200" b="1" dirty="0" smtClean="0">
                  <a:solidFill>
                    <a:prstClr val="black"/>
                  </a:solidFill>
                </a:rPr>
                <a:t>phenomeno</a:t>
              </a:r>
              <a:r>
                <a:rPr lang="en-US" sz="1200" b="1" i="1" dirty="0" smtClean="0">
                  <a:solidFill>
                    <a:prstClr val="black"/>
                  </a:solidFill>
                </a:rPr>
                <a:t>n</a:t>
              </a:r>
              <a:r>
                <a:rPr lang="en-US" sz="1200" b="1" dirty="0" smtClean="0">
                  <a:solidFill>
                    <a:prstClr val="black"/>
                  </a:solidFill>
                </a:rPr>
                <a:t>, assay-dependent,  many mechanisms)</a:t>
              </a:r>
              <a:endParaRPr lang="en-US" sz="1200" b="1" dirty="0">
                <a:solidFill>
                  <a:prstClr val="black"/>
                </a:solidFill>
              </a:endParaRPr>
            </a:p>
            <a:p>
              <a:pPr algn="ctr"/>
              <a:endParaRPr lang="en-US" b="1" dirty="0">
                <a:solidFill>
                  <a:prstClr val="black"/>
                </a:solidFill>
              </a:endParaRPr>
            </a:p>
          </p:txBody>
        </p:sp>
        <p:sp>
          <p:nvSpPr>
            <p:cNvPr id="116" name="Oval 2"/>
            <p:cNvSpPr/>
            <p:nvPr/>
          </p:nvSpPr>
          <p:spPr>
            <a:xfrm>
              <a:off x="3173741" y="2227652"/>
              <a:ext cx="1398260" cy="1761987"/>
            </a:xfrm>
            <a:prstGeom prst="ellipse">
              <a:avLst/>
            </a:prstGeom>
            <a:solidFill>
              <a:srgbClr val="00FFFF">
                <a:alpha val="50000"/>
              </a:srgb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grpSp>
      <p:grpSp>
        <p:nvGrpSpPr>
          <p:cNvPr id="42" name="Group 28"/>
          <p:cNvGrpSpPr/>
          <p:nvPr/>
        </p:nvGrpSpPr>
        <p:grpSpPr>
          <a:xfrm>
            <a:off x="4682475" y="2147712"/>
            <a:ext cx="4005071" cy="1341006"/>
            <a:chOff x="3556857" y="2298878"/>
            <a:chExt cx="4005070" cy="1341006"/>
          </a:xfrm>
        </p:grpSpPr>
        <p:sp>
          <p:nvSpPr>
            <p:cNvPr id="111" name="Right Arrow 8"/>
            <p:cNvSpPr/>
            <p:nvPr/>
          </p:nvSpPr>
          <p:spPr>
            <a:xfrm rot="10382650">
              <a:off x="5126390" y="2595031"/>
              <a:ext cx="1054261" cy="211551"/>
            </a:xfrm>
            <a:prstGeom prst="rightArrow">
              <a:avLst/>
            </a:prstGeom>
            <a:solidFill>
              <a:srgbClr val="FFFF00"/>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12" name="TextBox 111"/>
            <p:cNvSpPr txBox="1"/>
            <p:nvPr/>
          </p:nvSpPr>
          <p:spPr>
            <a:xfrm>
              <a:off x="5735715" y="2458567"/>
              <a:ext cx="1826212" cy="1015663"/>
            </a:xfrm>
            <a:prstGeom prst="rect">
              <a:avLst/>
            </a:prstGeom>
            <a:noFill/>
          </p:spPr>
          <p:txBody>
            <a:bodyPr wrap="square" rtlCol="0">
              <a:spAutoFit/>
            </a:bodyPr>
            <a:lstStyle/>
            <a:p>
              <a:pPr lvl="0" algn="ctr"/>
              <a:r>
                <a:rPr lang="en-US" b="1" dirty="0">
                  <a:solidFill>
                    <a:prstClr val="black"/>
                  </a:solidFill>
                </a:rPr>
                <a:t>ADCC</a:t>
              </a:r>
              <a:r>
                <a:rPr lang="en-US" b="1" dirty="0" smtClean="0">
                  <a:solidFill>
                    <a:prstClr val="black"/>
                  </a:solidFill>
                </a:rPr>
                <a:t> </a:t>
              </a:r>
            </a:p>
            <a:p>
              <a:pPr lvl="0" algn="ctr"/>
              <a:r>
                <a:rPr lang="en-US" sz="1200" b="1" dirty="0" smtClean="0">
                  <a:solidFill>
                    <a:prstClr val="black"/>
                  </a:solidFill>
                </a:rPr>
                <a:t>(</a:t>
              </a:r>
              <a:r>
                <a:rPr lang="en-US" sz="1200" b="1" dirty="0">
                  <a:solidFill>
                    <a:prstClr val="black"/>
                  </a:solidFill>
                </a:rPr>
                <a:t>antibody-dependent cell-mediated </a:t>
              </a:r>
              <a:r>
                <a:rPr lang="en-US" sz="1200" b="1" dirty="0" err="1">
                  <a:solidFill>
                    <a:prstClr val="black"/>
                  </a:solidFill>
                </a:rPr>
                <a:t>cytotoxicity</a:t>
              </a:r>
              <a:r>
                <a:rPr lang="en-US" sz="1200" b="1" dirty="0">
                  <a:solidFill>
                    <a:prstClr val="black"/>
                  </a:solidFill>
                </a:rPr>
                <a:t>)</a:t>
              </a:r>
            </a:p>
            <a:p>
              <a:pPr algn="ctr"/>
              <a:endParaRPr lang="en-US" b="1" dirty="0" smtClean="0">
                <a:solidFill>
                  <a:prstClr val="black"/>
                </a:solidFill>
              </a:endParaRPr>
            </a:p>
          </p:txBody>
        </p:sp>
        <p:sp>
          <p:nvSpPr>
            <p:cNvPr id="113" name="Oval 112"/>
            <p:cNvSpPr/>
            <p:nvPr/>
          </p:nvSpPr>
          <p:spPr>
            <a:xfrm>
              <a:off x="3556857" y="2298878"/>
              <a:ext cx="1768983" cy="1341006"/>
            </a:xfrm>
            <a:prstGeom prst="ellipse">
              <a:avLst/>
            </a:prstGeom>
            <a:solidFill>
              <a:srgbClr val="FFFF00">
                <a:alpha val="50000"/>
              </a:srgb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grpSp>
      <p:grpSp>
        <p:nvGrpSpPr>
          <p:cNvPr id="43" name="Group 44"/>
          <p:cNvGrpSpPr/>
          <p:nvPr/>
        </p:nvGrpSpPr>
        <p:grpSpPr>
          <a:xfrm>
            <a:off x="4905561" y="569583"/>
            <a:ext cx="2111029" cy="2354739"/>
            <a:chOff x="3779949" y="720749"/>
            <a:chExt cx="2111029" cy="2354739"/>
          </a:xfrm>
        </p:grpSpPr>
        <p:sp>
          <p:nvSpPr>
            <p:cNvPr id="108" name="Oval 107"/>
            <p:cNvSpPr/>
            <p:nvPr/>
          </p:nvSpPr>
          <p:spPr>
            <a:xfrm>
              <a:off x="3779949" y="2161088"/>
              <a:ext cx="914400" cy="914400"/>
            </a:xfrm>
            <a:prstGeom prst="ellipse">
              <a:avLst/>
            </a:prstGeom>
            <a:solidFill>
              <a:srgbClr val="FF0000">
                <a:alpha val="75000"/>
              </a:srgbClr>
            </a:solidFill>
            <a:ln w="381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09" name="TextBox 108"/>
            <p:cNvSpPr txBox="1"/>
            <p:nvPr/>
          </p:nvSpPr>
          <p:spPr>
            <a:xfrm>
              <a:off x="4043808" y="720749"/>
              <a:ext cx="1847170" cy="830997"/>
            </a:xfrm>
            <a:prstGeom prst="rect">
              <a:avLst/>
            </a:prstGeom>
            <a:noFill/>
          </p:spPr>
          <p:txBody>
            <a:bodyPr wrap="square" rtlCol="0">
              <a:spAutoFit/>
            </a:bodyPr>
            <a:lstStyle/>
            <a:p>
              <a:pPr algn="ctr"/>
              <a:r>
                <a:rPr lang="en-US" b="1" dirty="0"/>
                <a:t>Broadly</a:t>
              </a:r>
            </a:p>
            <a:p>
              <a:pPr algn="ctr"/>
              <a:r>
                <a:rPr lang="en-US" b="1" dirty="0" smtClean="0"/>
                <a:t>Protective* </a:t>
              </a:r>
              <a:endParaRPr lang="en-US" b="1" dirty="0"/>
            </a:p>
            <a:p>
              <a:pPr algn="ctr"/>
              <a:r>
                <a:rPr lang="en-US" sz="1200" b="1" i="1" dirty="0"/>
                <a:t>in vivo</a:t>
              </a:r>
            </a:p>
          </p:txBody>
        </p:sp>
        <p:sp>
          <p:nvSpPr>
            <p:cNvPr id="110" name="Right Arrow 109"/>
            <p:cNvSpPr/>
            <p:nvPr/>
          </p:nvSpPr>
          <p:spPr>
            <a:xfrm rot="7090754">
              <a:off x="4062375" y="1838558"/>
              <a:ext cx="815637" cy="195355"/>
            </a:xfrm>
            <a:prstGeom prst="rightArrow">
              <a:avLst/>
            </a:prstGeom>
            <a:solidFill>
              <a:srgbClr val="FF0000"/>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grpSp>
      <p:grpSp>
        <p:nvGrpSpPr>
          <p:cNvPr id="44" name="Group 52"/>
          <p:cNvGrpSpPr/>
          <p:nvPr/>
        </p:nvGrpSpPr>
        <p:grpSpPr>
          <a:xfrm>
            <a:off x="4888830" y="2090467"/>
            <a:ext cx="783383" cy="688975"/>
            <a:chOff x="3763217" y="2241550"/>
            <a:chExt cx="783383" cy="688975"/>
          </a:xfrm>
        </p:grpSpPr>
        <p:sp>
          <p:nvSpPr>
            <p:cNvPr id="107" name="Freeform 106"/>
            <p:cNvSpPr/>
            <p:nvPr/>
          </p:nvSpPr>
          <p:spPr>
            <a:xfrm>
              <a:off x="3981450" y="2241550"/>
              <a:ext cx="565150" cy="688975"/>
            </a:xfrm>
            <a:custGeom>
              <a:avLst/>
              <a:gdLst>
                <a:gd name="connsiteX0" fmla="*/ 0 w 565150"/>
                <a:gd name="connsiteY0" fmla="*/ 0 h 688975"/>
                <a:gd name="connsiteX1" fmla="*/ 104775 w 565150"/>
                <a:gd name="connsiteY1" fmla="*/ 28575 h 688975"/>
                <a:gd name="connsiteX2" fmla="*/ 209550 w 565150"/>
                <a:gd name="connsiteY2" fmla="*/ 76200 h 688975"/>
                <a:gd name="connsiteX3" fmla="*/ 292100 w 565150"/>
                <a:gd name="connsiteY3" fmla="*/ 142875 h 688975"/>
                <a:gd name="connsiteX4" fmla="*/ 342900 w 565150"/>
                <a:gd name="connsiteY4" fmla="*/ 193675 h 688975"/>
                <a:gd name="connsiteX5" fmla="*/ 412750 w 565150"/>
                <a:gd name="connsiteY5" fmla="*/ 279400 h 688975"/>
                <a:gd name="connsiteX6" fmla="*/ 466725 w 565150"/>
                <a:gd name="connsiteY6" fmla="*/ 368300 h 688975"/>
                <a:gd name="connsiteX7" fmla="*/ 501650 w 565150"/>
                <a:gd name="connsiteY7" fmla="*/ 434975 h 688975"/>
                <a:gd name="connsiteX8" fmla="*/ 527050 w 565150"/>
                <a:gd name="connsiteY8" fmla="*/ 504825 h 688975"/>
                <a:gd name="connsiteX9" fmla="*/ 549275 w 565150"/>
                <a:gd name="connsiteY9" fmla="*/ 584200 h 688975"/>
                <a:gd name="connsiteX10" fmla="*/ 561975 w 565150"/>
                <a:gd name="connsiteY10" fmla="*/ 638175 h 688975"/>
                <a:gd name="connsiteX11" fmla="*/ 565150 w 565150"/>
                <a:gd name="connsiteY11" fmla="*/ 688975 h 688975"/>
                <a:gd name="connsiteX12" fmla="*/ 565150 w 565150"/>
                <a:gd name="connsiteY12" fmla="*/ 688975 h 68897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565150" h="688975">
                  <a:moveTo>
                    <a:pt x="0" y="0"/>
                  </a:moveTo>
                  <a:cubicBezTo>
                    <a:pt x="34925" y="7937"/>
                    <a:pt x="69850" y="15875"/>
                    <a:pt x="104775" y="28575"/>
                  </a:cubicBezTo>
                  <a:cubicBezTo>
                    <a:pt x="139700" y="41275"/>
                    <a:pt x="178329" y="57150"/>
                    <a:pt x="209550" y="76200"/>
                  </a:cubicBezTo>
                  <a:cubicBezTo>
                    <a:pt x="240771" y="95250"/>
                    <a:pt x="269875" y="123296"/>
                    <a:pt x="292100" y="142875"/>
                  </a:cubicBezTo>
                  <a:cubicBezTo>
                    <a:pt x="314325" y="162454"/>
                    <a:pt x="322792" y="170921"/>
                    <a:pt x="342900" y="193675"/>
                  </a:cubicBezTo>
                  <a:cubicBezTo>
                    <a:pt x="363008" y="216429"/>
                    <a:pt x="392113" y="250296"/>
                    <a:pt x="412750" y="279400"/>
                  </a:cubicBezTo>
                  <a:cubicBezTo>
                    <a:pt x="433388" y="308504"/>
                    <a:pt x="451908" y="342371"/>
                    <a:pt x="466725" y="368300"/>
                  </a:cubicBezTo>
                  <a:cubicBezTo>
                    <a:pt x="481542" y="394229"/>
                    <a:pt x="491596" y="412221"/>
                    <a:pt x="501650" y="434975"/>
                  </a:cubicBezTo>
                  <a:cubicBezTo>
                    <a:pt x="511704" y="457729"/>
                    <a:pt x="519113" y="479954"/>
                    <a:pt x="527050" y="504825"/>
                  </a:cubicBezTo>
                  <a:cubicBezTo>
                    <a:pt x="534987" y="529696"/>
                    <a:pt x="543454" y="561975"/>
                    <a:pt x="549275" y="584200"/>
                  </a:cubicBezTo>
                  <a:cubicBezTo>
                    <a:pt x="555096" y="606425"/>
                    <a:pt x="559329" y="620712"/>
                    <a:pt x="561975" y="638175"/>
                  </a:cubicBezTo>
                  <a:cubicBezTo>
                    <a:pt x="564621" y="655638"/>
                    <a:pt x="565150" y="688975"/>
                    <a:pt x="565150" y="688975"/>
                  </a:cubicBezTo>
                  <a:lnTo>
                    <a:pt x="565150" y="688975"/>
                  </a:lnTo>
                </a:path>
              </a:pathLst>
            </a:custGeom>
            <a:ln w="38100" cmpd="sng">
              <a:solidFill>
                <a:schemeClr val="bg1"/>
              </a:solidFill>
              <a:prstDash val="sysDash"/>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solidFill>
                  <a:prstClr val="black"/>
                </a:solidFill>
              </a:endParaRPr>
            </a:p>
          </p:txBody>
        </p:sp>
        <p:sp>
          <p:nvSpPr>
            <p:cNvPr id="106" name="TextBox 105"/>
            <p:cNvSpPr txBox="1"/>
            <p:nvPr/>
          </p:nvSpPr>
          <p:spPr>
            <a:xfrm>
              <a:off x="3763217" y="2430515"/>
              <a:ext cx="706373" cy="369332"/>
            </a:xfrm>
            <a:prstGeom prst="rect">
              <a:avLst/>
            </a:prstGeom>
            <a:noFill/>
          </p:spPr>
          <p:txBody>
            <a:bodyPr wrap="square" rtlCol="0">
              <a:spAutoFit/>
            </a:bodyPr>
            <a:lstStyle/>
            <a:p>
              <a:pPr algn="ctr"/>
              <a:r>
                <a:rPr lang="en-US" b="1" dirty="0">
                  <a:solidFill>
                    <a:srgbClr val="FFFFFF"/>
                  </a:solidFill>
                </a:rPr>
                <a:t>BN</a:t>
              </a:r>
            </a:p>
          </p:txBody>
        </p:sp>
      </p:grpSp>
      <p:grpSp>
        <p:nvGrpSpPr>
          <p:cNvPr id="131" name="Group 130"/>
          <p:cNvGrpSpPr/>
          <p:nvPr/>
        </p:nvGrpSpPr>
        <p:grpSpPr>
          <a:xfrm>
            <a:off x="4627825" y="1949100"/>
            <a:ext cx="2251967" cy="3736423"/>
            <a:chOff x="3507038" y="2052830"/>
            <a:chExt cx="2251967" cy="3736423"/>
          </a:xfrm>
        </p:grpSpPr>
        <p:grpSp>
          <p:nvGrpSpPr>
            <p:cNvPr id="46" name="Group 60"/>
            <p:cNvGrpSpPr/>
            <p:nvPr/>
          </p:nvGrpSpPr>
          <p:grpSpPr>
            <a:xfrm>
              <a:off x="3514114" y="2052830"/>
              <a:ext cx="2244891" cy="3736423"/>
              <a:chOff x="3509289" y="2100266"/>
              <a:chExt cx="2244892" cy="3736423"/>
            </a:xfrm>
          </p:grpSpPr>
          <p:sp>
            <p:nvSpPr>
              <p:cNvPr id="103" name="TextBox 102"/>
              <p:cNvSpPr txBox="1"/>
              <p:nvPr/>
            </p:nvSpPr>
            <p:spPr>
              <a:xfrm>
                <a:off x="3509289" y="5128803"/>
                <a:ext cx="2244892" cy="707886"/>
              </a:xfrm>
              <a:prstGeom prst="rect">
                <a:avLst/>
              </a:prstGeom>
              <a:noFill/>
              <a:ln w="38100" cap="flat" cmpd="sng" algn="ctr">
                <a:solidFill>
                  <a:srgbClr val="FF0000"/>
                </a:solidFill>
                <a:prstDash val="solid"/>
                <a:round/>
                <a:headEnd type="none" w="med" len="med"/>
                <a:tailEnd type="none" w="med" len="med"/>
              </a:ln>
            </p:spPr>
            <p:txBody>
              <a:bodyPr wrap="square" rtlCol="0">
                <a:spAutoFit/>
              </a:bodyPr>
              <a:lstStyle/>
              <a:p>
                <a:pPr algn="ctr"/>
                <a:r>
                  <a:rPr lang="en-US" sz="2000" b="1" dirty="0">
                    <a:solidFill>
                      <a:srgbClr val="FF0000"/>
                    </a:solidFill>
                  </a:rPr>
                  <a:t>CELL-TARGETING ANTIBODY (</a:t>
                </a:r>
                <a:r>
                  <a:rPr lang="en-US" sz="2000" b="1" dirty="0" err="1">
                    <a:solidFill>
                      <a:srgbClr val="FF0000"/>
                    </a:solidFill>
                  </a:rPr>
                  <a:t>CTAb</a:t>
                </a:r>
                <a:r>
                  <a:rPr lang="en-US" sz="2000" b="1" dirty="0">
                    <a:solidFill>
                      <a:srgbClr val="FF0000"/>
                    </a:solidFill>
                  </a:rPr>
                  <a:t>)</a:t>
                </a:r>
              </a:p>
            </p:txBody>
          </p:sp>
          <p:sp>
            <p:nvSpPr>
              <p:cNvPr id="104" name="Freeform 103"/>
              <p:cNvSpPr/>
              <p:nvPr/>
            </p:nvSpPr>
            <p:spPr>
              <a:xfrm>
                <a:off x="3524250" y="2100266"/>
                <a:ext cx="1822450" cy="1798634"/>
              </a:xfrm>
              <a:custGeom>
                <a:avLst/>
                <a:gdLst>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12900 w 1822450"/>
                  <a:gd name="connsiteY37" fmla="*/ 1557334 h 1798634"/>
                  <a:gd name="connsiteX38" fmla="*/ 1606550 w 1822450"/>
                  <a:gd name="connsiteY38" fmla="*/ 1576384 h 1798634"/>
                  <a:gd name="connsiteX39" fmla="*/ 1555750 w 1822450"/>
                  <a:gd name="connsiteY39" fmla="*/ 1633534 h 1798634"/>
                  <a:gd name="connsiteX40" fmla="*/ 1511300 w 1822450"/>
                  <a:gd name="connsiteY40" fmla="*/ 1646234 h 1798634"/>
                  <a:gd name="connsiteX41" fmla="*/ 1485900 w 1822450"/>
                  <a:gd name="connsiteY41" fmla="*/ 1671634 h 1798634"/>
                  <a:gd name="connsiteX42" fmla="*/ 1447800 w 1822450"/>
                  <a:gd name="connsiteY42" fmla="*/ 1697034 h 1798634"/>
                  <a:gd name="connsiteX43" fmla="*/ 1422400 w 1822450"/>
                  <a:gd name="connsiteY43" fmla="*/ 1703384 h 1798634"/>
                  <a:gd name="connsiteX44" fmla="*/ 1397000 w 1822450"/>
                  <a:gd name="connsiteY44" fmla="*/ 1716084 h 1798634"/>
                  <a:gd name="connsiteX45" fmla="*/ 1377950 w 1822450"/>
                  <a:gd name="connsiteY45" fmla="*/ 1728784 h 1798634"/>
                  <a:gd name="connsiteX46" fmla="*/ 1282700 w 1822450"/>
                  <a:gd name="connsiteY46" fmla="*/ 1735134 h 1798634"/>
                  <a:gd name="connsiteX47" fmla="*/ 1263650 w 1822450"/>
                  <a:gd name="connsiteY47" fmla="*/ 1747834 h 1798634"/>
                  <a:gd name="connsiteX48" fmla="*/ 1193800 w 1822450"/>
                  <a:gd name="connsiteY48" fmla="*/ 1766884 h 1798634"/>
                  <a:gd name="connsiteX49" fmla="*/ 1155700 w 1822450"/>
                  <a:gd name="connsiteY49" fmla="*/ 1779584 h 1798634"/>
                  <a:gd name="connsiteX50" fmla="*/ 1136650 w 1822450"/>
                  <a:gd name="connsiteY50" fmla="*/ 1785934 h 1798634"/>
                  <a:gd name="connsiteX51" fmla="*/ 1079500 w 1822450"/>
                  <a:gd name="connsiteY51" fmla="*/ 1798634 h 1798634"/>
                  <a:gd name="connsiteX52" fmla="*/ 793750 w 1822450"/>
                  <a:gd name="connsiteY52" fmla="*/ 1792284 h 1798634"/>
                  <a:gd name="connsiteX53" fmla="*/ 723900 w 1822450"/>
                  <a:gd name="connsiteY53" fmla="*/ 1779584 h 1798634"/>
                  <a:gd name="connsiteX54" fmla="*/ 673100 w 1822450"/>
                  <a:gd name="connsiteY54" fmla="*/ 1754184 h 1798634"/>
                  <a:gd name="connsiteX55" fmla="*/ 558800 w 1822450"/>
                  <a:gd name="connsiteY55" fmla="*/ 1735134 h 1798634"/>
                  <a:gd name="connsiteX56" fmla="*/ 520700 w 1822450"/>
                  <a:gd name="connsiteY56" fmla="*/ 1722434 h 1798634"/>
                  <a:gd name="connsiteX57" fmla="*/ 476250 w 1822450"/>
                  <a:gd name="connsiteY57" fmla="*/ 1703384 h 1798634"/>
                  <a:gd name="connsiteX58" fmla="*/ 438150 w 1822450"/>
                  <a:gd name="connsiteY58" fmla="*/ 1684334 h 1798634"/>
                  <a:gd name="connsiteX59" fmla="*/ 387350 w 1822450"/>
                  <a:gd name="connsiteY59" fmla="*/ 1671634 h 1798634"/>
                  <a:gd name="connsiteX60" fmla="*/ 368300 w 1822450"/>
                  <a:gd name="connsiteY60" fmla="*/ 1658934 h 1798634"/>
                  <a:gd name="connsiteX61" fmla="*/ 311150 w 1822450"/>
                  <a:gd name="connsiteY61" fmla="*/ 1646234 h 1798634"/>
                  <a:gd name="connsiteX62" fmla="*/ 292100 w 1822450"/>
                  <a:gd name="connsiteY62" fmla="*/ 1633534 h 1798634"/>
                  <a:gd name="connsiteX63" fmla="*/ 247650 w 1822450"/>
                  <a:gd name="connsiteY63" fmla="*/ 1576384 h 1798634"/>
                  <a:gd name="connsiteX64" fmla="*/ 228600 w 1822450"/>
                  <a:gd name="connsiteY64" fmla="*/ 1563684 h 1798634"/>
                  <a:gd name="connsiteX65" fmla="*/ 209550 w 1822450"/>
                  <a:gd name="connsiteY65" fmla="*/ 1557334 h 1798634"/>
                  <a:gd name="connsiteX66" fmla="*/ 203200 w 1822450"/>
                  <a:gd name="connsiteY66" fmla="*/ 1538284 h 1798634"/>
                  <a:gd name="connsiteX67" fmla="*/ 165100 w 1822450"/>
                  <a:gd name="connsiteY67" fmla="*/ 1519234 h 1798634"/>
                  <a:gd name="connsiteX68" fmla="*/ 139700 w 1822450"/>
                  <a:gd name="connsiteY68" fmla="*/ 1481134 h 1798634"/>
                  <a:gd name="connsiteX69" fmla="*/ 133350 w 1822450"/>
                  <a:gd name="connsiteY69" fmla="*/ 1455734 h 1798634"/>
                  <a:gd name="connsiteX70" fmla="*/ 107950 w 1822450"/>
                  <a:gd name="connsiteY70" fmla="*/ 1423984 h 1798634"/>
                  <a:gd name="connsiteX71" fmla="*/ 95250 w 1822450"/>
                  <a:gd name="connsiteY71" fmla="*/ 1404934 h 1798634"/>
                  <a:gd name="connsiteX72" fmla="*/ 88900 w 1822450"/>
                  <a:gd name="connsiteY72" fmla="*/ 1385884 h 1798634"/>
                  <a:gd name="connsiteX73" fmla="*/ 69850 w 1822450"/>
                  <a:gd name="connsiteY73" fmla="*/ 1373184 h 1798634"/>
                  <a:gd name="connsiteX74" fmla="*/ 50800 w 1822450"/>
                  <a:gd name="connsiteY74" fmla="*/ 1335084 h 1798634"/>
                  <a:gd name="connsiteX75" fmla="*/ 38100 w 1822450"/>
                  <a:gd name="connsiteY75" fmla="*/ 1296984 h 1798634"/>
                  <a:gd name="connsiteX76" fmla="*/ 31750 w 1822450"/>
                  <a:gd name="connsiteY76" fmla="*/ 1277934 h 1798634"/>
                  <a:gd name="connsiteX77" fmla="*/ 0 w 1822450"/>
                  <a:gd name="connsiteY77" fmla="*/ 1233484 h 1798634"/>
                  <a:gd name="connsiteX78" fmla="*/ 6350 w 1822450"/>
                  <a:gd name="connsiteY78" fmla="*/ 1138234 h 1798634"/>
                  <a:gd name="connsiteX79" fmla="*/ 19050 w 1822450"/>
                  <a:gd name="connsiteY79" fmla="*/ 1100134 h 1798634"/>
                  <a:gd name="connsiteX80" fmla="*/ 25400 w 1822450"/>
                  <a:gd name="connsiteY80" fmla="*/ 1068384 h 1798634"/>
                  <a:gd name="connsiteX81" fmla="*/ 38100 w 1822450"/>
                  <a:gd name="connsiteY81" fmla="*/ 1030284 h 1798634"/>
                  <a:gd name="connsiteX82" fmla="*/ 44450 w 1822450"/>
                  <a:gd name="connsiteY82" fmla="*/ 1011234 h 1798634"/>
                  <a:gd name="connsiteX83" fmla="*/ 38100 w 1822450"/>
                  <a:gd name="connsiteY83" fmla="*/ 979484 h 1798634"/>
                  <a:gd name="connsiteX84" fmla="*/ 25400 w 1822450"/>
                  <a:gd name="connsiteY84" fmla="*/ 941384 h 1798634"/>
                  <a:gd name="connsiteX85" fmla="*/ 25400 w 1822450"/>
                  <a:gd name="connsiteY85" fmla="*/ 738184 h 1798634"/>
                  <a:gd name="connsiteX86" fmla="*/ 31750 w 1822450"/>
                  <a:gd name="connsiteY86" fmla="*/ 700084 h 1798634"/>
                  <a:gd name="connsiteX87" fmla="*/ 63500 w 1822450"/>
                  <a:gd name="connsiteY87" fmla="*/ 636584 h 1798634"/>
                  <a:gd name="connsiteX88" fmla="*/ 82550 w 1822450"/>
                  <a:gd name="connsiteY88" fmla="*/ 623884 h 1798634"/>
                  <a:gd name="connsiteX89" fmla="*/ 95250 w 1822450"/>
                  <a:gd name="connsiteY89" fmla="*/ 585784 h 1798634"/>
                  <a:gd name="connsiteX90" fmla="*/ 101600 w 1822450"/>
                  <a:gd name="connsiteY90" fmla="*/ 566734 h 1798634"/>
                  <a:gd name="connsiteX91" fmla="*/ 120650 w 1822450"/>
                  <a:gd name="connsiteY91" fmla="*/ 554034 h 1798634"/>
                  <a:gd name="connsiteX92" fmla="*/ 146050 w 1822450"/>
                  <a:gd name="connsiteY92" fmla="*/ 515934 h 1798634"/>
                  <a:gd name="connsiteX93" fmla="*/ 152400 w 1822450"/>
                  <a:gd name="connsiteY93" fmla="*/ 496884 h 1798634"/>
                  <a:gd name="connsiteX94" fmla="*/ 171450 w 1822450"/>
                  <a:gd name="connsiteY94" fmla="*/ 477834 h 1798634"/>
                  <a:gd name="connsiteX95" fmla="*/ 184150 w 1822450"/>
                  <a:gd name="connsiteY95" fmla="*/ 458784 h 1798634"/>
                  <a:gd name="connsiteX96" fmla="*/ 203200 w 1822450"/>
                  <a:gd name="connsiteY96" fmla="*/ 446084 h 1798634"/>
                  <a:gd name="connsiteX97" fmla="*/ 279400 w 1822450"/>
                  <a:gd name="connsiteY97" fmla="*/ 382584 h 1798634"/>
                  <a:gd name="connsiteX98" fmla="*/ 317500 w 1822450"/>
                  <a:gd name="connsiteY98" fmla="*/ 369884 h 1798634"/>
                  <a:gd name="connsiteX99" fmla="*/ 355600 w 1822450"/>
                  <a:gd name="connsiteY99" fmla="*/ 350834 h 1798634"/>
                  <a:gd name="connsiteX100" fmla="*/ 374650 w 1822450"/>
                  <a:gd name="connsiteY100" fmla="*/ 338134 h 1798634"/>
                  <a:gd name="connsiteX101" fmla="*/ 431800 w 1822450"/>
                  <a:gd name="connsiteY101" fmla="*/ 319084 h 1798634"/>
                  <a:gd name="connsiteX102" fmla="*/ 450850 w 1822450"/>
                  <a:gd name="connsiteY102" fmla="*/ 312734 h 1798634"/>
                  <a:gd name="connsiteX103" fmla="*/ 469900 w 1822450"/>
                  <a:gd name="connsiteY103" fmla="*/ 300034 h 1798634"/>
                  <a:gd name="connsiteX104" fmla="*/ 527050 w 1822450"/>
                  <a:gd name="connsiteY104" fmla="*/ 280984 h 1798634"/>
                  <a:gd name="connsiteX105" fmla="*/ 584200 w 1822450"/>
                  <a:gd name="connsiteY105" fmla="*/ 261934 h 1798634"/>
                  <a:gd name="connsiteX106" fmla="*/ 603250 w 1822450"/>
                  <a:gd name="connsiteY106" fmla="*/ 255584 h 1798634"/>
                  <a:gd name="connsiteX107" fmla="*/ 622300 w 1822450"/>
                  <a:gd name="connsiteY107" fmla="*/ 249234 h 1798634"/>
                  <a:gd name="connsiteX108" fmla="*/ 711200 w 1822450"/>
                  <a:gd name="connsiteY108" fmla="*/ 242884 h 1798634"/>
                  <a:gd name="connsiteX109" fmla="*/ 774700 w 1822450"/>
                  <a:gd name="connsiteY109" fmla="*/ 230184 h 1798634"/>
                  <a:gd name="connsiteX110" fmla="*/ 838200 w 1822450"/>
                  <a:gd name="connsiteY110" fmla="*/ 211134 h 1798634"/>
                  <a:gd name="connsiteX111" fmla="*/ 876300 w 1822450"/>
                  <a:gd name="connsiteY111" fmla="*/ 198434 h 1798634"/>
                  <a:gd name="connsiteX112" fmla="*/ 895350 w 1822450"/>
                  <a:gd name="connsiteY112" fmla="*/ 192084 h 1798634"/>
                  <a:gd name="connsiteX113" fmla="*/ 908050 w 1822450"/>
                  <a:gd name="connsiteY113" fmla="*/ 173034 h 1798634"/>
                  <a:gd name="connsiteX114" fmla="*/ 927100 w 1822450"/>
                  <a:gd name="connsiteY114" fmla="*/ 160334 h 1798634"/>
                  <a:gd name="connsiteX115" fmla="*/ 933450 w 1822450"/>
                  <a:gd name="connsiteY115" fmla="*/ 141284 h 1798634"/>
                  <a:gd name="connsiteX116" fmla="*/ 946150 w 1822450"/>
                  <a:gd name="connsiteY116" fmla="*/ 122234 h 1798634"/>
                  <a:gd name="connsiteX117" fmla="*/ 958850 w 1822450"/>
                  <a:gd name="connsiteY117" fmla="*/ 84134 h 1798634"/>
                  <a:gd name="connsiteX118" fmla="*/ 965200 w 1822450"/>
                  <a:gd name="connsiteY118" fmla="*/ 26984 h 1798634"/>
                  <a:gd name="connsiteX119" fmla="*/ 971550 w 1822450"/>
                  <a:gd name="connsiteY119" fmla="*/ 7934 h 1798634"/>
                  <a:gd name="connsiteX120" fmla="*/ 990600 w 1822450"/>
                  <a:gd name="connsiteY120" fmla="*/ 1584 h 1798634"/>
                  <a:gd name="connsiteX121" fmla="*/ 1066800 w 1822450"/>
                  <a:gd name="connsiteY121" fmla="*/ 14284 h 1798634"/>
                  <a:gd name="connsiteX122" fmla="*/ 1104900 w 1822450"/>
                  <a:gd name="connsiteY122" fmla="*/ 33334 h 1798634"/>
                  <a:gd name="connsiteX123" fmla="*/ 1123950 w 1822450"/>
                  <a:gd name="connsiteY123" fmla="*/ 46034 h 1798634"/>
                  <a:gd name="connsiteX124" fmla="*/ 1143000 w 1822450"/>
                  <a:gd name="connsiteY124" fmla="*/ 52384 h 1798634"/>
                  <a:gd name="connsiteX125" fmla="*/ 1200150 w 1822450"/>
                  <a:gd name="connsiteY125" fmla="*/ 90484 h 1798634"/>
                  <a:gd name="connsiteX126" fmla="*/ 1219200 w 1822450"/>
                  <a:gd name="connsiteY126" fmla="*/ 103184 h 1798634"/>
                  <a:gd name="connsiteX127" fmla="*/ 1238250 w 1822450"/>
                  <a:gd name="connsiteY127" fmla="*/ 115884 h 1798634"/>
                  <a:gd name="connsiteX128" fmla="*/ 1257300 w 1822450"/>
                  <a:gd name="connsiteY128" fmla="*/ 134934 h 1798634"/>
                  <a:gd name="connsiteX129" fmla="*/ 1295400 w 1822450"/>
                  <a:gd name="connsiteY129" fmla="*/ 160334 h 1798634"/>
                  <a:gd name="connsiteX130" fmla="*/ 1320800 w 1822450"/>
                  <a:gd name="connsiteY130" fmla="*/ 185734 h 1798634"/>
                  <a:gd name="connsiteX131" fmla="*/ 1333500 w 1822450"/>
                  <a:gd name="connsiteY131" fmla="*/ 204784 h 1798634"/>
                  <a:gd name="connsiteX132" fmla="*/ 1352550 w 1822450"/>
                  <a:gd name="connsiteY132" fmla="*/ 217484 h 1798634"/>
                  <a:gd name="connsiteX133" fmla="*/ 1358900 w 1822450"/>
                  <a:gd name="connsiteY133" fmla="*/ 268284 h 1798634"/>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12900 w 1822450"/>
                  <a:gd name="connsiteY37" fmla="*/ 1557334 h 1798634"/>
                  <a:gd name="connsiteX38" fmla="*/ 1606550 w 1822450"/>
                  <a:gd name="connsiteY38" fmla="*/ 1576384 h 1798634"/>
                  <a:gd name="connsiteX39" fmla="*/ 1555750 w 1822450"/>
                  <a:gd name="connsiteY39" fmla="*/ 1633534 h 1798634"/>
                  <a:gd name="connsiteX40" fmla="*/ 1511300 w 1822450"/>
                  <a:gd name="connsiteY40" fmla="*/ 1646234 h 1798634"/>
                  <a:gd name="connsiteX41" fmla="*/ 1485900 w 1822450"/>
                  <a:gd name="connsiteY41" fmla="*/ 1671634 h 1798634"/>
                  <a:gd name="connsiteX42" fmla="*/ 1447800 w 1822450"/>
                  <a:gd name="connsiteY42" fmla="*/ 1697034 h 1798634"/>
                  <a:gd name="connsiteX43" fmla="*/ 1422400 w 1822450"/>
                  <a:gd name="connsiteY43" fmla="*/ 1703384 h 1798634"/>
                  <a:gd name="connsiteX44" fmla="*/ 1397000 w 1822450"/>
                  <a:gd name="connsiteY44" fmla="*/ 1716084 h 1798634"/>
                  <a:gd name="connsiteX45" fmla="*/ 1377950 w 1822450"/>
                  <a:gd name="connsiteY45" fmla="*/ 1728784 h 1798634"/>
                  <a:gd name="connsiteX46" fmla="*/ 1282700 w 1822450"/>
                  <a:gd name="connsiteY46" fmla="*/ 1735134 h 1798634"/>
                  <a:gd name="connsiteX47" fmla="*/ 1263650 w 1822450"/>
                  <a:gd name="connsiteY47" fmla="*/ 1747834 h 1798634"/>
                  <a:gd name="connsiteX48" fmla="*/ 1193800 w 1822450"/>
                  <a:gd name="connsiteY48" fmla="*/ 1766884 h 1798634"/>
                  <a:gd name="connsiteX49" fmla="*/ 1155700 w 1822450"/>
                  <a:gd name="connsiteY49" fmla="*/ 1779584 h 1798634"/>
                  <a:gd name="connsiteX50" fmla="*/ 1136650 w 1822450"/>
                  <a:gd name="connsiteY50" fmla="*/ 1785934 h 1798634"/>
                  <a:gd name="connsiteX51" fmla="*/ 1079500 w 1822450"/>
                  <a:gd name="connsiteY51" fmla="*/ 1798634 h 1798634"/>
                  <a:gd name="connsiteX52" fmla="*/ 793750 w 1822450"/>
                  <a:gd name="connsiteY52" fmla="*/ 1792284 h 1798634"/>
                  <a:gd name="connsiteX53" fmla="*/ 723900 w 1822450"/>
                  <a:gd name="connsiteY53" fmla="*/ 1779584 h 1798634"/>
                  <a:gd name="connsiteX54" fmla="*/ 673100 w 1822450"/>
                  <a:gd name="connsiteY54" fmla="*/ 1754184 h 1798634"/>
                  <a:gd name="connsiteX55" fmla="*/ 558800 w 1822450"/>
                  <a:gd name="connsiteY55" fmla="*/ 1735134 h 1798634"/>
                  <a:gd name="connsiteX56" fmla="*/ 520700 w 1822450"/>
                  <a:gd name="connsiteY56" fmla="*/ 1722434 h 1798634"/>
                  <a:gd name="connsiteX57" fmla="*/ 476250 w 1822450"/>
                  <a:gd name="connsiteY57" fmla="*/ 1703384 h 1798634"/>
                  <a:gd name="connsiteX58" fmla="*/ 438150 w 1822450"/>
                  <a:gd name="connsiteY58" fmla="*/ 1684334 h 1798634"/>
                  <a:gd name="connsiteX59" fmla="*/ 387350 w 1822450"/>
                  <a:gd name="connsiteY59" fmla="*/ 1671634 h 1798634"/>
                  <a:gd name="connsiteX60" fmla="*/ 368300 w 1822450"/>
                  <a:gd name="connsiteY60" fmla="*/ 1658934 h 1798634"/>
                  <a:gd name="connsiteX61" fmla="*/ 311150 w 1822450"/>
                  <a:gd name="connsiteY61" fmla="*/ 1646234 h 1798634"/>
                  <a:gd name="connsiteX62" fmla="*/ 292100 w 1822450"/>
                  <a:gd name="connsiteY62" fmla="*/ 1633534 h 1798634"/>
                  <a:gd name="connsiteX63" fmla="*/ 247650 w 1822450"/>
                  <a:gd name="connsiteY63" fmla="*/ 1576384 h 1798634"/>
                  <a:gd name="connsiteX64" fmla="*/ 228600 w 1822450"/>
                  <a:gd name="connsiteY64" fmla="*/ 1563684 h 1798634"/>
                  <a:gd name="connsiteX65" fmla="*/ 209550 w 1822450"/>
                  <a:gd name="connsiteY65" fmla="*/ 1557334 h 1798634"/>
                  <a:gd name="connsiteX66" fmla="*/ 203200 w 1822450"/>
                  <a:gd name="connsiteY66" fmla="*/ 1538284 h 1798634"/>
                  <a:gd name="connsiteX67" fmla="*/ 165100 w 1822450"/>
                  <a:gd name="connsiteY67" fmla="*/ 1519234 h 1798634"/>
                  <a:gd name="connsiteX68" fmla="*/ 139700 w 1822450"/>
                  <a:gd name="connsiteY68" fmla="*/ 1481134 h 1798634"/>
                  <a:gd name="connsiteX69" fmla="*/ 133350 w 1822450"/>
                  <a:gd name="connsiteY69" fmla="*/ 1455734 h 1798634"/>
                  <a:gd name="connsiteX70" fmla="*/ 107950 w 1822450"/>
                  <a:gd name="connsiteY70" fmla="*/ 1423984 h 1798634"/>
                  <a:gd name="connsiteX71" fmla="*/ 95250 w 1822450"/>
                  <a:gd name="connsiteY71" fmla="*/ 1404934 h 1798634"/>
                  <a:gd name="connsiteX72" fmla="*/ 88900 w 1822450"/>
                  <a:gd name="connsiteY72" fmla="*/ 1385884 h 1798634"/>
                  <a:gd name="connsiteX73" fmla="*/ 69850 w 1822450"/>
                  <a:gd name="connsiteY73" fmla="*/ 1373184 h 1798634"/>
                  <a:gd name="connsiteX74" fmla="*/ 50800 w 1822450"/>
                  <a:gd name="connsiteY74" fmla="*/ 1335084 h 1798634"/>
                  <a:gd name="connsiteX75" fmla="*/ 38100 w 1822450"/>
                  <a:gd name="connsiteY75" fmla="*/ 1296984 h 1798634"/>
                  <a:gd name="connsiteX76" fmla="*/ 31750 w 1822450"/>
                  <a:gd name="connsiteY76" fmla="*/ 1277934 h 1798634"/>
                  <a:gd name="connsiteX77" fmla="*/ 0 w 1822450"/>
                  <a:gd name="connsiteY77" fmla="*/ 1233484 h 1798634"/>
                  <a:gd name="connsiteX78" fmla="*/ 6350 w 1822450"/>
                  <a:gd name="connsiteY78" fmla="*/ 1138234 h 1798634"/>
                  <a:gd name="connsiteX79" fmla="*/ 19050 w 1822450"/>
                  <a:gd name="connsiteY79" fmla="*/ 1100134 h 1798634"/>
                  <a:gd name="connsiteX80" fmla="*/ 25400 w 1822450"/>
                  <a:gd name="connsiteY80" fmla="*/ 1068384 h 1798634"/>
                  <a:gd name="connsiteX81" fmla="*/ 38100 w 1822450"/>
                  <a:gd name="connsiteY81" fmla="*/ 1030284 h 1798634"/>
                  <a:gd name="connsiteX82" fmla="*/ 44450 w 1822450"/>
                  <a:gd name="connsiteY82" fmla="*/ 1011234 h 1798634"/>
                  <a:gd name="connsiteX83" fmla="*/ 38100 w 1822450"/>
                  <a:gd name="connsiteY83" fmla="*/ 979484 h 1798634"/>
                  <a:gd name="connsiteX84" fmla="*/ 25400 w 1822450"/>
                  <a:gd name="connsiteY84" fmla="*/ 941384 h 1798634"/>
                  <a:gd name="connsiteX85" fmla="*/ 25400 w 1822450"/>
                  <a:gd name="connsiteY85" fmla="*/ 738184 h 1798634"/>
                  <a:gd name="connsiteX86" fmla="*/ 31750 w 1822450"/>
                  <a:gd name="connsiteY86" fmla="*/ 700084 h 1798634"/>
                  <a:gd name="connsiteX87" fmla="*/ 63500 w 1822450"/>
                  <a:gd name="connsiteY87" fmla="*/ 636584 h 1798634"/>
                  <a:gd name="connsiteX88" fmla="*/ 82550 w 1822450"/>
                  <a:gd name="connsiteY88" fmla="*/ 623884 h 1798634"/>
                  <a:gd name="connsiteX89" fmla="*/ 95250 w 1822450"/>
                  <a:gd name="connsiteY89" fmla="*/ 585784 h 1798634"/>
                  <a:gd name="connsiteX90" fmla="*/ 101600 w 1822450"/>
                  <a:gd name="connsiteY90" fmla="*/ 566734 h 1798634"/>
                  <a:gd name="connsiteX91" fmla="*/ 120650 w 1822450"/>
                  <a:gd name="connsiteY91" fmla="*/ 554034 h 1798634"/>
                  <a:gd name="connsiteX92" fmla="*/ 146050 w 1822450"/>
                  <a:gd name="connsiteY92" fmla="*/ 515934 h 1798634"/>
                  <a:gd name="connsiteX93" fmla="*/ 152400 w 1822450"/>
                  <a:gd name="connsiteY93" fmla="*/ 496884 h 1798634"/>
                  <a:gd name="connsiteX94" fmla="*/ 171450 w 1822450"/>
                  <a:gd name="connsiteY94" fmla="*/ 477834 h 1798634"/>
                  <a:gd name="connsiteX95" fmla="*/ 184150 w 1822450"/>
                  <a:gd name="connsiteY95" fmla="*/ 458784 h 1798634"/>
                  <a:gd name="connsiteX96" fmla="*/ 203200 w 1822450"/>
                  <a:gd name="connsiteY96" fmla="*/ 446084 h 1798634"/>
                  <a:gd name="connsiteX97" fmla="*/ 279400 w 1822450"/>
                  <a:gd name="connsiteY97" fmla="*/ 382584 h 1798634"/>
                  <a:gd name="connsiteX98" fmla="*/ 317500 w 1822450"/>
                  <a:gd name="connsiteY98" fmla="*/ 369884 h 1798634"/>
                  <a:gd name="connsiteX99" fmla="*/ 355600 w 1822450"/>
                  <a:gd name="connsiteY99" fmla="*/ 350834 h 1798634"/>
                  <a:gd name="connsiteX100" fmla="*/ 374650 w 1822450"/>
                  <a:gd name="connsiteY100" fmla="*/ 338134 h 1798634"/>
                  <a:gd name="connsiteX101" fmla="*/ 431800 w 1822450"/>
                  <a:gd name="connsiteY101" fmla="*/ 319084 h 1798634"/>
                  <a:gd name="connsiteX102" fmla="*/ 450850 w 1822450"/>
                  <a:gd name="connsiteY102" fmla="*/ 312734 h 1798634"/>
                  <a:gd name="connsiteX103" fmla="*/ 469900 w 1822450"/>
                  <a:gd name="connsiteY103" fmla="*/ 300034 h 1798634"/>
                  <a:gd name="connsiteX104" fmla="*/ 527050 w 1822450"/>
                  <a:gd name="connsiteY104" fmla="*/ 280984 h 1798634"/>
                  <a:gd name="connsiteX105" fmla="*/ 584200 w 1822450"/>
                  <a:gd name="connsiteY105" fmla="*/ 261934 h 1798634"/>
                  <a:gd name="connsiteX106" fmla="*/ 603250 w 1822450"/>
                  <a:gd name="connsiteY106" fmla="*/ 255584 h 1798634"/>
                  <a:gd name="connsiteX107" fmla="*/ 622300 w 1822450"/>
                  <a:gd name="connsiteY107" fmla="*/ 249234 h 1798634"/>
                  <a:gd name="connsiteX108" fmla="*/ 711200 w 1822450"/>
                  <a:gd name="connsiteY108" fmla="*/ 242884 h 1798634"/>
                  <a:gd name="connsiteX109" fmla="*/ 774700 w 1822450"/>
                  <a:gd name="connsiteY109" fmla="*/ 230184 h 1798634"/>
                  <a:gd name="connsiteX110" fmla="*/ 838200 w 1822450"/>
                  <a:gd name="connsiteY110" fmla="*/ 211134 h 1798634"/>
                  <a:gd name="connsiteX111" fmla="*/ 876300 w 1822450"/>
                  <a:gd name="connsiteY111" fmla="*/ 198434 h 1798634"/>
                  <a:gd name="connsiteX112" fmla="*/ 895350 w 1822450"/>
                  <a:gd name="connsiteY112" fmla="*/ 192084 h 1798634"/>
                  <a:gd name="connsiteX113" fmla="*/ 908050 w 1822450"/>
                  <a:gd name="connsiteY113" fmla="*/ 173034 h 1798634"/>
                  <a:gd name="connsiteX114" fmla="*/ 927100 w 1822450"/>
                  <a:gd name="connsiteY114" fmla="*/ 160334 h 1798634"/>
                  <a:gd name="connsiteX115" fmla="*/ 933450 w 1822450"/>
                  <a:gd name="connsiteY115" fmla="*/ 141284 h 1798634"/>
                  <a:gd name="connsiteX116" fmla="*/ 946150 w 1822450"/>
                  <a:gd name="connsiteY116" fmla="*/ 122234 h 1798634"/>
                  <a:gd name="connsiteX117" fmla="*/ 958850 w 1822450"/>
                  <a:gd name="connsiteY117" fmla="*/ 84134 h 1798634"/>
                  <a:gd name="connsiteX118" fmla="*/ 965200 w 1822450"/>
                  <a:gd name="connsiteY118" fmla="*/ 26984 h 1798634"/>
                  <a:gd name="connsiteX119" fmla="*/ 971550 w 1822450"/>
                  <a:gd name="connsiteY119" fmla="*/ 7934 h 1798634"/>
                  <a:gd name="connsiteX120" fmla="*/ 990600 w 1822450"/>
                  <a:gd name="connsiteY120" fmla="*/ 1584 h 1798634"/>
                  <a:gd name="connsiteX121" fmla="*/ 1066800 w 1822450"/>
                  <a:gd name="connsiteY121" fmla="*/ 14284 h 1798634"/>
                  <a:gd name="connsiteX122" fmla="*/ 1104900 w 1822450"/>
                  <a:gd name="connsiteY122" fmla="*/ 33334 h 1798634"/>
                  <a:gd name="connsiteX123" fmla="*/ 1123950 w 1822450"/>
                  <a:gd name="connsiteY123" fmla="*/ 46034 h 1798634"/>
                  <a:gd name="connsiteX124" fmla="*/ 1143000 w 1822450"/>
                  <a:gd name="connsiteY124" fmla="*/ 52384 h 1798634"/>
                  <a:gd name="connsiteX125" fmla="*/ 1200150 w 1822450"/>
                  <a:gd name="connsiteY125" fmla="*/ 90484 h 1798634"/>
                  <a:gd name="connsiteX126" fmla="*/ 1219200 w 1822450"/>
                  <a:gd name="connsiteY126" fmla="*/ 103184 h 1798634"/>
                  <a:gd name="connsiteX127" fmla="*/ 1238250 w 1822450"/>
                  <a:gd name="connsiteY127" fmla="*/ 115884 h 1798634"/>
                  <a:gd name="connsiteX128" fmla="*/ 1257300 w 1822450"/>
                  <a:gd name="connsiteY128" fmla="*/ 134934 h 1798634"/>
                  <a:gd name="connsiteX129" fmla="*/ 1295400 w 1822450"/>
                  <a:gd name="connsiteY129" fmla="*/ 160334 h 1798634"/>
                  <a:gd name="connsiteX130" fmla="*/ 1320800 w 1822450"/>
                  <a:gd name="connsiteY130" fmla="*/ 185734 h 1798634"/>
                  <a:gd name="connsiteX131" fmla="*/ 1333500 w 1822450"/>
                  <a:gd name="connsiteY131" fmla="*/ 204784 h 1798634"/>
                  <a:gd name="connsiteX132" fmla="*/ 1352550 w 1822450"/>
                  <a:gd name="connsiteY132" fmla="*/ 217484 h 1798634"/>
                  <a:gd name="connsiteX133" fmla="*/ 1358900 w 1822450"/>
                  <a:gd name="connsiteY133" fmla="*/ 268284 h 1798634"/>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12900 w 1822450"/>
                  <a:gd name="connsiteY37" fmla="*/ 1557334 h 1798634"/>
                  <a:gd name="connsiteX38" fmla="*/ 1606550 w 1822450"/>
                  <a:gd name="connsiteY38" fmla="*/ 1576384 h 1798634"/>
                  <a:gd name="connsiteX39" fmla="*/ 1555750 w 1822450"/>
                  <a:gd name="connsiteY39" fmla="*/ 1633534 h 1798634"/>
                  <a:gd name="connsiteX40" fmla="*/ 1511300 w 1822450"/>
                  <a:gd name="connsiteY40" fmla="*/ 1646234 h 1798634"/>
                  <a:gd name="connsiteX41" fmla="*/ 1485900 w 1822450"/>
                  <a:gd name="connsiteY41" fmla="*/ 1671634 h 1798634"/>
                  <a:gd name="connsiteX42" fmla="*/ 1447800 w 1822450"/>
                  <a:gd name="connsiteY42" fmla="*/ 1697034 h 1798634"/>
                  <a:gd name="connsiteX43" fmla="*/ 1422400 w 1822450"/>
                  <a:gd name="connsiteY43" fmla="*/ 1703384 h 1798634"/>
                  <a:gd name="connsiteX44" fmla="*/ 1397000 w 1822450"/>
                  <a:gd name="connsiteY44" fmla="*/ 1716084 h 1798634"/>
                  <a:gd name="connsiteX45" fmla="*/ 1377950 w 1822450"/>
                  <a:gd name="connsiteY45" fmla="*/ 1728784 h 1798634"/>
                  <a:gd name="connsiteX46" fmla="*/ 1282700 w 1822450"/>
                  <a:gd name="connsiteY46" fmla="*/ 1735134 h 1798634"/>
                  <a:gd name="connsiteX47" fmla="*/ 1263650 w 1822450"/>
                  <a:gd name="connsiteY47" fmla="*/ 1747834 h 1798634"/>
                  <a:gd name="connsiteX48" fmla="*/ 1193800 w 1822450"/>
                  <a:gd name="connsiteY48" fmla="*/ 1766884 h 1798634"/>
                  <a:gd name="connsiteX49" fmla="*/ 1155700 w 1822450"/>
                  <a:gd name="connsiteY49" fmla="*/ 1779584 h 1798634"/>
                  <a:gd name="connsiteX50" fmla="*/ 1136650 w 1822450"/>
                  <a:gd name="connsiteY50" fmla="*/ 1785934 h 1798634"/>
                  <a:gd name="connsiteX51" fmla="*/ 1079500 w 1822450"/>
                  <a:gd name="connsiteY51" fmla="*/ 1798634 h 1798634"/>
                  <a:gd name="connsiteX52" fmla="*/ 793750 w 1822450"/>
                  <a:gd name="connsiteY52" fmla="*/ 1792284 h 1798634"/>
                  <a:gd name="connsiteX53" fmla="*/ 723900 w 1822450"/>
                  <a:gd name="connsiteY53" fmla="*/ 1779584 h 1798634"/>
                  <a:gd name="connsiteX54" fmla="*/ 673100 w 1822450"/>
                  <a:gd name="connsiteY54" fmla="*/ 1754184 h 1798634"/>
                  <a:gd name="connsiteX55" fmla="*/ 558800 w 1822450"/>
                  <a:gd name="connsiteY55" fmla="*/ 1735134 h 1798634"/>
                  <a:gd name="connsiteX56" fmla="*/ 520700 w 1822450"/>
                  <a:gd name="connsiteY56" fmla="*/ 1722434 h 1798634"/>
                  <a:gd name="connsiteX57" fmla="*/ 476250 w 1822450"/>
                  <a:gd name="connsiteY57" fmla="*/ 1703384 h 1798634"/>
                  <a:gd name="connsiteX58" fmla="*/ 438150 w 1822450"/>
                  <a:gd name="connsiteY58" fmla="*/ 1684334 h 1798634"/>
                  <a:gd name="connsiteX59" fmla="*/ 387350 w 1822450"/>
                  <a:gd name="connsiteY59" fmla="*/ 1671634 h 1798634"/>
                  <a:gd name="connsiteX60" fmla="*/ 368300 w 1822450"/>
                  <a:gd name="connsiteY60" fmla="*/ 1658934 h 1798634"/>
                  <a:gd name="connsiteX61" fmla="*/ 311150 w 1822450"/>
                  <a:gd name="connsiteY61" fmla="*/ 1646234 h 1798634"/>
                  <a:gd name="connsiteX62" fmla="*/ 301625 w 1822450"/>
                  <a:gd name="connsiteY62" fmla="*/ 1636709 h 1798634"/>
                  <a:gd name="connsiteX63" fmla="*/ 292100 w 1822450"/>
                  <a:gd name="connsiteY63" fmla="*/ 1633534 h 1798634"/>
                  <a:gd name="connsiteX64" fmla="*/ 247650 w 1822450"/>
                  <a:gd name="connsiteY64" fmla="*/ 1576384 h 1798634"/>
                  <a:gd name="connsiteX65" fmla="*/ 228600 w 1822450"/>
                  <a:gd name="connsiteY65" fmla="*/ 1563684 h 1798634"/>
                  <a:gd name="connsiteX66" fmla="*/ 209550 w 1822450"/>
                  <a:gd name="connsiteY66" fmla="*/ 1557334 h 1798634"/>
                  <a:gd name="connsiteX67" fmla="*/ 203200 w 1822450"/>
                  <a:gd name="connsiteY67" fmla="*/ 1538284 h 1798634"/>
                  <a:gd name="connsiteX68" fmla="*/ 165100 w 1822450"/>
                  <a:gd name="connsiteY68" fmla="*/ 1519234 h 1798634"/>
                  <a:gd name="connsiteX69" fmla="*/ 139700 w 1822450"/>
                  <a:gd name="connsiteY69" fmla="*/ 1481134 h 1798634"/>
                  <a:gd name="connsiteX70" fmla="*/ 133350 w 1822450"/>
                  <a:gd name="connsiteY70" fmla="*/ 1455734 h 1798634"/>
                  <a:gd name="connsiteX71" fmla="*/ 107950 w 1822450"/>
                  <a:gd name="connsiteY71" fmla="*/ 1423984 h 1798634"/>
                  <a:gd name="connsiteX72" fmla="*/ 95250 w 1822450"/>
                  <a:gd name="connsiteY72" fmla="*/ 1404934 h 1798634"/>
                  <a:gd name="connsiteX73" fmla="*/ 88900 w 1822450"/>
                  <a:gd name="connsiteY73" fmla="*/ 1385884 h 1798634"/>
                  <a:gd name="connsiteX74" fmla="*/ 69850 w 1822450"/>
                  <a:gd name="connsiteY74" fmla="*/ 1373184 h 1798634"/>
                  <a:gd name="connsiteX75" fmla="*/ 50800 w 1822450"/>
                  <a:gd name="connsiteY75" fmla="*/ 1335084 h 1798634"/>
                  <a:gd name="connsiteX76" fmla="*/ 38100 w 1822450"/>
                  <a:gd name="connsiteY76" fmla="*/ 1296984 h 1798634"/>
                  <a:gd name="connsiteX77" fmla="*/ 31750 w 1822450"/>
                  <a:gd name="connsiteY77" fmla="*/ 1277934 h 1798634"/>
                  <a:gd name="connsiteX78" fmla="*/ 0 w 1822450"/>
                  <a:gd name="connsiteY78" fmla="*/ 1233484 h 1798634"/>
                  <a:gd name="connsiteX79" fmla="*/ 6350 w 1822450"/>
                  <a:gd name="connsiteY79" fmla="*/ 1138234 h 1798634"/>
                  <a:gd name="connsiteX80" fmla="*/ 19050 w 1822450"/>
                  <a:gd name="connsiteY80" fmla="*/ 1100134 h 1798634"/>
                  <a:gd name="connsiteX81" fmla="*/ 25400 w 1822450"/>
                  <a:gd name="connsiteY81" fmla="*/ 1068384 h 1798634"/>
                  <a:gd name="connsiteX82" fmla="*/ 38100 w 1822450"/>
                  <a:gd name="connsiteY82" fmla="*/ 1030284 h 1798634"/>
                  <a:gd name="connsiteX83" fmla="*/ 44450 w 1822450"/>
                  <a:gd name="connsiteY83" fmla="*/ 1011234 h 1798634"/>
                  <a:gd name="connsiteX84" fmla="*/ 38100 w 1822450"/>
                  <a:gd name="connsiteY84" fmla="*/ 979484 h 1798634"/>
                  <a:gd name="connsiteX85" fmla="*/ 25400 w 1822450"/>
                  <a:gd name="connsiteY85" fmla="*/ 941384 h 1798634"/>
                  <a:gd name="connsiteX86" fmla="*/ 25400 w 1822450"/>
                  <a:gd name="connsiteY86" fmla="*/ 738184 h 1798634"/>
                  <a:gd name="connsiteX87" fmla="*/ 31750 w 1822450"/>
                  <a:gd name="connsiteY87" fmla="*/ 700084 h 1798634"/>
                  <a:gd name="connsiteX88" fmla="*/ 63500 w 1822450"/>
                  <a:gd name="connsiteY88" fmla="*/ 636584 h 1798634"/>
                  <a:gd name="connsiteX89" fmla="*/ 82550 w 1822450"/>
                  <a:gd name="connsiteY89" fmla="*/ 623884 h 1798634"/>
                  <a:gd name="connsiteX90" fmla="*/ 95250 w 1822450"/>
                  <a:gd name="connsiteY90" fmla="*/ 585784 h 1798634"/>
                  <a:gd name="connsiteX91" fmla="*/ 101600 w 1822450"/>
                  <a:gd name="connsiteY91" fmla="*/ 566734 h 1798634"/>
                  <a:gd name="connsiteX92" fmla="*/ 120650 w 1822450"/>
                  <a:gd name="connsiteY92" fmla="*/ 554034 h 1798634"/>
                  <a:gd name="connsiteX93" fmla="*/ 146050 w 1822450"/>
                  <a:gd name="connsiteY93" fmla="*/ 515934 h 1798634"/>
                  <a:gd name="connsiteX94" fmla="*/ 152400 w 1822450"/>
                  <a:gd name="connsiteY94" fmla="*/ 496884 h 1798634"/>
                  <a:gd name="connsiteX95" fmla="*/ 171450 w 1822450"/>
                  <a:gd name="connsiteY95" fmla="*/ 477834 h 1798634"/>
                  <a:gd name="connsiteX96" fmla="*/ 184150 w 1822450"/>
                  <a:gd name="connsiteY96" fmla="*/ 458784 h 1798634"/>
                  <a:gd name="connsiteX97" fmla="*/ 203200 w 1822450"/>
                  <a:gd name="connsiteY97" fmla="*/ 446084 h 1798634"/>
                  <a:gd name="connsiteX98" fmla="*/ 279400 w 1822450"/>
                  <a:gd name="connsiteY98" fmla="*/ 382584 h 1798634"/>
                  <a:gd name="connsiteX99" fmla="*/ 317500 w 1822450"/>
                  <a:gd name="connsiteY99" fmla="*/ 369884 h 1798634"/>
                  <a:gd name="connsiteX100" fmla="*/ 355600 w 1822450"/>
                  <a:gd name="connsiteY100" fmla="*/ 350834 h 1798634"/>
                  <a:gd name="connsiteX101" fmla="*/ 374650 w 1822450"/>
                  <a:gd name="connsiteY101" fmla="*/ 338134 h 1798634"/>
                  <a:gd name="connsiteX102" fmla="*/ 431800 w 1822450"/>
                  <a:gd name="connsiteY102" fmla="*/ 319084 h 1798634"/>
                  <a:gd name="connsiteX103" fmla="*/ 450850 w 1822450"/>
                  <a:gd name="connsiteY103" fmla="*/ 312734 h 1798634"/>
                  <a:gd name="connsiteX104" fmla="*/ 469900 w 1822450"/>
                  <a:gd name="connsiteY104" fmla="*/ 300034 h 1798634"/>
                  <a:gd name="connsiteX105" fmla="*/ 527050 w 1822450"/>
                  <a:gd name="connsiteY105" fmla="*/ 280984 h 1798634"/>
                  <a:gd name="connsiteX106" fmla="*/ 584200 w 1822450"/>
                  <a:gd name="connsiteY106" fmla="*/ 261934 h 1798634"/>
                  <a:gd name="connsiteX107" fmla="*/ 603250 w 1822450"/>
                  <a:gd name="connsiteY107" fmla="*/ 255584 h 1798634"/>
                  <a:gd name="connsiteX108" fmla="*/ 622300 w 1822450"/>
                  <a:gd name="connsiteY108" fmla="*/ 249234 h 1798634"/>
                  <a:gd name="connsiteX109" fmla="*/ 711200 w 1822450"/>
                  <a:gd name="connsiteY109" fmla="*/ 242884 h 1798634"/>
                  <a:gd name="connsiteX110" fmla="*/ 774700 w 1822450"/>
                  <a:gd name="connsiteY110" fmla="*/ 230184 h 1798634"/>
                  <a:gd name="connsiteX111" fmla="*/ 838200 w 1822450"/>
                  <a:gd name="connsiteY111" fmla="*/ 211134 h 1798634"/>
                  <a:gd name="connsiteX112" fmla="*/ 876300 w 1822450"/>
                  <a:gd name="connsiteY112" fmla="*/ 198434 h 1798634"/>
                  <a:gd name="connsiteX113" fmla="*/ 895350 w 1822450"/>
                  <a:gd name="connsiteY113" fmla="*/ 192084 h 1798634"/>
                  <a:gd name="connsiteX114" fmla="*/ 908050 w 1822450"/>
                  <a:gd name="connsiteY114" fmla="*/ 173034 h 1798634"/>
                  <a:gd name="connsiteX115" fmla="*/ 927100 w 1822450"/>
                  <a:gd name="connsiteY115" fmla="*/ 160334 h 1798634"/>
                  <a:gd name="connsiteX116" fmla="*/ 933450 w 1822450"/>
                  <a:gd name="connsiteY116" fmla="*/ 141284 h 1798634"/>
                  <a:gd name="connsiteX117" fmla="*/ 946150 w 1822450"/>
                  <a:gd name="connsiteY117" fmla="*/ 122234 h 1798634"/>
                  <a:gd name="connsiteX118" fmla="*/ 958850 w 1822450"/>
                  <a:gd name="connsiteY118" fmla="*/ 84134 h 1798634"/>
                  <a:gd name="connsiteX119" fmla="*/ 965200 w 1822450"/>
                  <a:gd name="connsiteY119" fmla="*/ 26984 h 1798634"/>
                  <a:gd name="connsiteX120" fmla="*/ 971550 w 1822450"/>
                  <a:gd name="connsiteY120" fmla="*/ 7934 h 1798634"/>
                  <a:gd name="connsiteX121" fmla="*/ 990600 w 1822450"/>
                  <a:gd name="connsiteY121" fmla="*/ 1584 h 1798634"/>
                  <a:gd name="connsiteX122" fmla="*/ 1066800 w 1822450"/>
                  <a:gd name="connsiteY122" fmla="*/ 14284 h 1798634"/>
                  <a:gd name="connsiteX123" fmla="*/ 1104900 w 1822450"/>
                  <a:gd name="connsiteY123" fmla="*/ 33334 h 1798634"/>
                  <a:gd name="connsiteX124" fmla="*/ 1123950 w 1822450"/>
                  <a:gd name="connsiteY124" fmla="*/ 46034 h 1798634"/>
                  <a:gd name="connsiteX125" fmla="*/ 1143000 w 1822450"/>
                  <a:gd name="connsiteY125" fmla="*/ 52384 h 1798634"/>
                  <a:gd name="connsiteX126" fmla="*/ 1200150 w 1822450"/>
                  <a:gd name="connsiteY126" fmla="*/ 90484 h 1798634"/>
                  <a:gd name="connsiteX127" fmla="*/ 1219200 w 1822450"/>
                  <a:gd name="connsiteY127" fmla="*/ 103184 h 1798634"/>
                  <a:gd name="connsiteX128" fmla="*/ 1238250 w 1822450"/>
                  <a:gd name="connsiteY128" fmla="*/ 115884 h 1798634"/>
                  <a:gd name="connsiteX129" fmla="*/ 1257300 w 1822450"/>
                  <a:gd name="connsiteY129" fmla="*/ 134934 h 1798634"/>
                  <a:gd name="connsiteX130" fmla="*/ 1295400 w 1822450"/>
                  <a:gd name="connsiteY130" fmla="*/ 160334 h 1798634"/>
                  <a:gd name="connsiteX131" fmla="*/ 1320800 w 1822450"/>
                  <a:gd name="connsiteY131" fmla="*/ 185734 h 1798634"/>
                  <a:gd name="connsiteX132" fmla="*/ 1333500 w 1822450"/>
                  <a:gd name="connsiteY132" fmla="*/ 204784 h 1798634"/>
                  <a:gd name="connsiteX133" fmla="*/ 1352550 w 1822450"/>
                  <a:gd name="connsiteY133" fmla="*/ 217484 h 1798634"/>
                  <a:gd name="connsiteX134" fmla="*/ 1358900 w 1822450"/>
                  <a:gd name="connsiteY134" fmla="*/ 268284 h 1798634"/>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12900 w 1822450"/>
                  <a:gd name="connsiteY37" fmla="*/ 1557334 h 1798634"/>
                  <a:gd name="connsiteX38" fmla="*/ 1606550 w 1822450"/>
                  <a:gd name="connsiteY38" fmla="*/ 1576384 h 1798634"/>
                  <a:gd name="connsiteX39" fmla="*/ 1555750 w 1822450"/>
                  <a:gd name="connsiteY39" fmla="*/ 1633534 h 1798634"/>
                  <a:gd name="connsiteX40" fmla="*/ 1511300 w 1822450"/>
                  <a:gd name="connsiteY40" fmla="*/ 1646234 h 1798634"/>
                  <a:gd name="connsiteX41" fmla="*/ 1485900 w 1822450"/>
                  <a:gd name="connsiteY41" fmla="*/ 1671634 h 1798634"/>
                  <a:gd name="connsiteX42" fmla="*/ 1447800 w 1822450"/>
                  <a:gd name="connsiteY42" fmla="*/ 1697034 h 1798634"/>
                  <a:gd name="connsiteX43" fmla="*/ 1422400 w 1822450"/>
                  <a:gd name="connsiteY43" fmla="*/ 1703384 h 1798634"/>
                  <a:gd name="connsiteX44" fmla="*/ 1397000 w 1822450"/>
                  <a:gd name="connsiteY44" fmla="*/ 1716084 h 1798634"/>
                  <a:gd name="connsiteX45" fmla="*/ 1377950 w 1822450"/>
                  <a:gd name="connsiteY45" fmla="*/ 1728784 h 1798634"/>
                  <a:gd name="connsiteX46" fmla="*/ 1282700 w 1822450"/>
                  <a:gd name="connsiteY46" fmla="*/ 1735134 h 1798634"/>
                  <a:gd name="connsiteX47" fmla="*/ 1263650 w 1822450"/>
                  <a:gd name="connsiteY47" fmla="*/ 1747834 h 1798634"/>
                  <a:gd name="connsiteX48" fmla="*/ 1193800 w 1822450"/>
                  <a:gd name="connsiteY48" fmla="*/ 1766884 h 1798634"/>
                  <a:gd name="connsiteX49" fmla="*/ 1155700 w 1822450"/>
                  <a:gd name="connsiteY49" fmla="*/ 1779584 h 1798634"/>
                  <a:gd name="connsiteX50" fmla="*/ 1136650 w 1822450"/>
                  <a:gd name="connsiteY50" fmla="*/ 1785934 h 1798634"/>
                  <a:gd name="connsiteX51" fmla="*/ 1079500 w 1822450"/>
                  <a:gd name="connsiteY51" fmla="*/ 1798634 h 1798634"/>
                  <a:gd name="connsiteX52" fmla="*/ 793750 w 1822450"/>
                  <a:gd name="connsiteY52" fmla="*/ 1792284 h 1798634"/>
                  <a:gd name="connsiteX53" fmla="*/ 723900 w 1822450"/>
                  <a:gd name="connsiteY53" fmla="*/ 1779584 h 1798634"/>
                  <a:gd name="connsiteX54" fmla="*/ 673100 w 1822450"/>
                  <a:gd name="connsiteY54" fmla="*/ 1754184 h 1798634"/>
                  <a:gd name="connsiteX55" fmla="*/ 558800 w 1822450"/>
                  <a:gd name="connsiteY55" fmla="*/ 1735134 h 1798634"/>
                  <a:gd name="connsiteX56" fmla="*/ 520700 w 1822450"/>
                  <a:gd name="connsiteY56" fmla="*/ 1722434 h 1798634"/>
                  <a:gd name="connsiteX57" fmla="*/ 476250 w 1822450"/>
                  <a:gd name="connsiteY57" fmla="*/ 1703384 h 1798634"/>
                  <a:gd name="connsiteX58" fmla="*/ 438150 w 1822450"/>
                  <a:gd name="connsiteY58" fmla="*/ 1684334 h 1798634"/>
                  <a:gd name="connsiteX59" fmla="*/ 387350 w 1822450"/>
                  <a:gd name="connsiteY59" fmla="*/ 1671634 h 1798634"/>
                  <a:gd name="connsiteX60" fmla="*/ 368300 w 1822450"/>
                  <a:gd name="connsiteY60" fmla="*/ 1658934 h 1798634"/>
                  <a:gd name="connsiteX61" fmla="*/ 311150 w 1822450"/>
                  <a:gd name="connsiteY61" fmla="*/ 1646234 h 1798634"/>
                  <a:gd name="connsiteX62" fmla="*/ 301625 w 1822450"/>
                  <a:gd name="connsiteY62" fmla="*/ 1636709 h 1798634"/>
                  <a:gd name="connsiteX63" fmla="*/ 292100 w 1822450"/>
                  <a:gd name="connsiteY63" fmla="*/ 1633534 h 1798634"/>
                  <a:gd name="connsiteX64" fmla="*/ 247650 w 1822450"/>
                  <a:gd name="connsiteY64" fmla="*/ 1576384 h 1798634"/>
                  <a:gd name="connsiteX65" fmla="*/ 228600 w 1822450"/>
                  <a:gd name="connsiteY65" fmla="*/ 1563684 h 1798634"/>
                  <a:gd name="connsiteX66" fmla="*/ 209550 w 1822450"/>
                  <a:gd name="connsiteY66" fmla="*/ 1557334 h 1798634"/>
                  <a:gd name="connsiteX67" fmla="*/ 203200 w 1822450"/>
                  <a:gd name="connsiteY67" fmla="*/ 1538284 h 1798634"/>
                  <a:gd name="connsiteX68" fmla="*/ 165100 w 1822450"/>
                  <a:gd name="connsiteY68" fmla="*/ 1519234 h 1798634"/>
                  <a:gd name="connsiteX69" fmla="*/ 139700 w 1822450"/>
                  <a:gd name="connsiteY69" fmla="*/ 1481134 h 1798634"/>
                  <a:gd name="connsiteX70" fmla="*/ 133350 w 1822450"/>
                  <a:gd name="connsiteY70" fmla="*/ 1455734 h 1798634"/>
                  <a:gd name="connsiteX71" fmla="*/ 107950 w 1822450"/>
                  <a:gd name="connsiteY71" fmla="*/ 1423984 h 1798634"/>
                  <a:gd name="connsiteX72" fmla="*/ 95250 w 1822450"/>
                  <a:gd name="connsiteY72" fmla="*/ 1404934 h 1798634"/>
                  <a:gd name="connsiteX73" fmla="*/ 88900 w 1822450"/>
                  <a:gd name="connsiteY73" fmla="*/ 1385884 h 1798634"/>
                  <a:gd name="connsiteX74" fmla="*/ 69850 w 1822450"/>
                  <a:gd name="connsiteY74" fmla="*/ 1373184 h 1798634"/>
                  <a:gd name="connsiteX75" fmla="*/ 50800 w 1822450"/>
                  <a:gd name="connsiteY75" fmla="*/ 1335084 h 1798634"/>
                  <a:gd name="connsiteX76" fmla="*/ 38100 w 1822450"/>
                  <a:gd name="connsiteY76" fmla="*/ 1296984 h 1798634"/>
                  <a:gd name="connsiteX77" fmla="*/ 31750 w 1822450"/>
                  <a:gd name="connsiteY77" fmla="*/ 1277934 h 1798634"/>
                  <a:gd name="connsiteX78" fmla="*/ 0 w 1822450"/>
                  <a:gd name="connsiteY78" fmla="*/ 1233484 h 1798634"/>
                  <a:gd name="connsiteX79" fmla="*/ 6350 w 1822450"/>
                  <a:gd name="connsiteY79" fmla="*/ 1138234 h 1798634"/>
                  <a:gd name="connsiteX80" fmla="*/ 19050 w 1822450"/>
                  <a:gd name="connsiteY80" fmla="*/ 1100134 h 1798634"/>
                  <a:gd name="connsiteX81" fmla="*/ 25400 w 1822450"/>
                  <a:gd name="connsiteY81" fmla="*/ 1068384 h 1798634"/>
                  <a:gd name="connsiteX82" fmla="*/ 38100 w 1822450"/>
                  <a:gd name="connsiteY82" fmla="*/ 1030284 h 1798634"/>
                  <a:gd name="connsiteX83" fmla="*/ 44450 w 1822450"/>
                  <a:gd name="connsiteY83" fmla="*/ 1011234 h 1798634"/>
                  <a:gd name="connsiteX84" fmla="*/ 38100 w 1822450"/>
                  <a:gd name="connsiteY84" fmla="*/ 979484 h 1798634"/>
                  <a:gd name="connsiteX85" fmla="*/ 25400 w 1822450"/>
                  <a:gd name="connsiteY85" fmla="*/ 941384 h 1798634"/>
                  <a:gd name="connsiteX86" fmla="*/ 25400 w 1822450"/>
                  <a:gd name="connsiteY86" fmla="*/ 738184 h 1798634"/>
                  <a:gd name="connsiteX87" fmla="*/ 31750 w 1822450"/>
                  <a:gd name="connsiteY87" fmla="*/ 700084 h 1798634"/>
                  <a:gd name="connsiteX88" fmla="*/ 63500 w 1822450"/>
                  <a:gd name="connsiteY88" fmla="*/ 636584 h 1798634"/>
                  <a:gd name="connsiteX89" fmla="*/ 82550 w 1822450"/>
                  <a:gd name="connsiteY89" fmla="*/ 623884 h 1798634"/>
                  <a:gd name="connsiteX90" fmla="*/ 95250 w 1822450"/>
                  <a:gd name="connsiteY90" fmla="*/ 585784 h 1798634"/>
                  <a:gd name="connsiteX91" fmla="*/ 101600 w 1822450"/>
                  <a:gd name="connsiteY91" fmla="*/ 566734 h 1798634"/>
                  <a:gd name="connsiteX92" fmla="*/ 120650 w 1822450"/>
                  <a:gd name="connsiteY92" fmla="*/ 554034 h 1798634"/>
                  <a:gd name="connsiteX93" fmla="*/ 146050 w 1822450"/>
                  <a:gd name="connsiteY93" fmla="*/ 515934 h 1798634"/>
                  <a:gd name="connsiteX94" fmla="*/ 152400 w 1822450"/>
                  <a:gd name="connsiteY94" fmla="*/ 496884 h 1798634"/>
                  <a:gd name="connsiteX95" fmla="*/ 171450 w 1822450"/>
                  <a:gd name="connsiteY95" fmla="*/ 477834 h 1798634"/>
                  <a:gd name="connsiteX96" fmla="*/ 184150 w 1822450"/>
                  <a:gd name="connsiteY96" fmla="*/ 458784 h 1798634"/>
                  <a:gd name="connsiteX97" fmla="*/ 203200 w 1822450"/>
                  <a:gd name="connsiteY97" fmla="*/ 446084 h 1798634"/>
                  <a:gd name="connsiteX98" fmla="*/ 279400 w 1822450"/>
                  <a:gd name="connsiteY98" fmla="*/ 382584 h 1798634"/>
                  <a:gd name="connsiteX99" fmla="*/ 317500 w 1822450"/>
                  <a:gd name="connsiteY99" fmla="*/ 369884 h 1798634"/>
                  <a:gd name="connsiteX100" fmla="*/ 355600 w 1822450"/>
                  <a:gd name="connsiteY100" fmla="*/ 350834 h 1798634"/>
                  <a:gd name="connsiteX101" fmla="*/ 374650 w 1822450"/>
                  <a:gd name="connsiteY101" fmla="*/ 338134 h 1798634"/>
                  <a:gd name="connsiteX102" fmla="*/ 431800 w 1822450"/>
                  <a:gd name="connsiteY102" fmla="*/ 319084 h 1798634"/>
                  <a:gd name="connsiteX103" fmla="*/ 450850 w 1822450"/>
                  <a:gd name="connsiteY103" fmla="*/ 312734 h 1798634"/>
                  <a:gd name="connsiteX104" fmla="*/ 469900 w 1822450"/>
                  <a:gd name="connsiteY104" fmla="*/ 300034 h 1798634"/>
                  <a:gd name="connsiteX105" fmla="*/ 527050 w 1822450"/>
                  <a:gd name="connsiteY105" fmla="*/ 280984 h 1798634"/>
                  <a:gd name="connsiteX106" fmla="*/ 584200 w 1822450"/>
                  <a:gd name="connsiteY106" fmla="*/ 261934 h 1798634"/>
                  <a:gd name="connsiteX107" fmla="*/ 603250 w 1822450"/>
                  <a:gd name="connsiteY107" fmla="*/ 255584 h 1798634"/>
                  <a:gd name="connsiteX108" fmla="*/ 622300 w 1822450"/>
                  <a:gd name="connsiteY108" fmla="*/ 249234 h 1798634"/>
                  <a:gd name="connsiteX109" fmla="*/ 711200 w 1822450"/>
                  <a:gd name="connsiteY109" fmla="*/ 242884 h 1798634"/>
                  <a:gd name="connsiteX110" fmla="*/ 774700 w 1822450"/>
                  <a:gd name="connsiteY110" fmla="*/ 230184 h 1798634"/>
                  <a:gd name="connsiteX111" fmla="*/ 838200 w 1822450"/>
                  <a:gd name="connsiteY111" fmla="*/ 211134 h 1798634"/>
                  <a:gd name="connsiteX112" fmla="*/ 876300 w 1822450"/>
                  <a:gd name="connsiteY112" fmla="*/ 198434 h 1798634"/>
                  <a:gd name="connsiteX113" fmla="*/ 895350 w 1822450"/>
                  <a:gd name="connsiteY113" fmla="*/ 192084 h 1798634"/>
                  <a:gd name="connsiteX114" fmla="*/ 908050 w 1822450"/>
                  <a:gd name="connsiteY114" fmla="*/ 173034 h 1798634"/>
                  <a:gd name="connsiteX115" fmla="*/ 927100 w 1822450"/>
                  <a:gd name="connsiteY115" fmla="*/ 160334 h 1798634"/>
                  <a:gd name="connsiteX116" fmla="*/ 933450 w 1822450"/>
                  <a:gd name="connsiteY116" fmla="*/ 141284 h 1798634"/>
                  <a:gd name="connsiteX117" fmla="*/ 946150 w 1822450"/>
                  <a:gd name="connsiteY117" fmla="*/ 122234 h 1798634"/>
                  <a:gd name="connsiteX118" fmla="*/ 958850 w 1822450"/>
                  <a:gd name="connsiteY118" fmla="*/ 84134 h 1798634"/>
                  <a:gd name="connsiteX119" fmla="*/ 965200 w 1822450"/>
                  <a:gd name="connsiteY119" fmla="*/ 26984 h 1798634"/>
                  <a:gd name="connsiteX120" fmla="*/ 971550 w 1822450"/>
                  <a:gd name="connsiteY120" fmla="*/ 7934 h 1798634"/>
                  <a:gd name="connsiteX121" fmla="*/ 990600 w 1822450"/>
                  <a:gd name="connsiteY121" fmla="*/ 1584 h 1798634"/>
                  <a:gd name="connsiteX122" fmla="*/ 1066800 w 1822450"/>
                  <a:gd name="connsiteY122" fmla="*/ 14284 h 1798634"/>
                  <a:gd name="connsiteX123" fmla="*/ 1104900 w 1822450"/>
                  <a:gd name="connsiteY123" fmla="*/ 33334 h 1798634"/>
                  <a:gd name="connsiteX124" fmla="*/ 1123950 w 1822450"/>
                  <a:gd name="connsiteY124" fmla="*/ 46034 h 1798634"/>
                  <a:gd name="connsiteX125" fmla="*/ 1143000 w 1822450"/>
                  <a:gd name="connsiteY125" fmla="*/ 52384 h 1798634"/>
                  <a:gd name="connsiteX126" fmla="*/ 1200150 w 1822450"/>
                  <a:gd name="connsiteY126" fmla="*/ 90484 h 1798634"/>
                  <a:gd name="connsiteX127" fmla="*/ 1219200 w 1822450"/>
                  <a:gd name="connsiteY127" fmla="*/ 103184 h 1798634"/>
                  <a:gd name="connsiteX128" fmla="*/ 1238250 w 1822450"/>
                  <a:gd name="connsiteY128" fmla="*/ 115884 h 1798634"/>
                  <a:gd name="connsiteX129" fmla="*/ 1257300 w 1822450"/>
                  <a:gd name="connsiteY129" fmla="*/ 134934 h 1798634"/>
                  <a:gd name="connsiteX130" fmla="*/ 1295400 w 1822450"/>
                  <a:gd name="connsiteY130" fmla="*/ 160334 h 1798634"/>
                  <a:gd name="connsiteX131" fmla="*/ 1320800 w 1822450"/>
                  <a:gd name="connsiteY131" fmla="*/ 185734 h 1798634"/>
                  <a:gd name="connsiteX132" fmla="*/ 1333500 w 1822450"/>
                  <a:gd name="connsiteY132" fmla="*/ 204784 h 1798634"/>
                  <a:gd name="connsiteX133" fmla="*/ 1352550 w 1822450"/>
                  <a:gd name="connsiteY133" fmla="*/ 217484 h 1798634"/>
                  <a:gd name="connsiteX134" fmla="*/ 1358900 w 1822450"/>
                  <a:gd name="connsiteY134" fmla="*/ 268284 h 1798634"/>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22425 w 1822450"/>
                  <a:gd name="connsiteY37" fmla="*/ 1550984 h 1798634"/>
                  <a:gd name="connsiteX38" fmla="*/ 1612900 w 1822450"/>
                  <a:gd name="connsiteY38" fmla="*/ 1557334 h 1798634"/>
                  <a:gd name="connsiteX39" fmla="*/ 1606550 w 1822450"/>
                  <a:gd name="connsiteY39" fmla="*/ 1576384 h 1798634"/>
                  <a:gd name="connsiteX40" fmla="*/ 1555750 w 1822450"/>
                  <a:gd name="connsiteY40" fmla="*/ 1633534 h 1798634"/>
                  <a:gd name="connsiteX41" fmla="*/ 1511300 w 1822450"/>
                  <a:gd name="connsiteY41" fmla="*/ 1646234 h 1798634"/>
                  <a:gd name="connsiteX42" fmla="*/ 1485900 w 1822450"/>
                  <a:gd name="connsiteY42" fmla="*/ 1671634 h 1798634"/>
                  <a:gd name="connsiteX43" fmla="*/ 1447800 w 1822450"/>
                  <a:gd name="connsiteY43" fmla="*/ 1697034 h 1798634"/>
                  <a:gd name="connsiteX44" fmla="*/ 1422400 w 1822450"/>
                  <a:gd name="connsiteY44" fmla="*/ 1703384 h 1798634"/>
                  <a:gd name="connsiteX45" fmla="*/ 1397000 w 1822450"/>
                  <a:gd name="connsiteY45" fmla="*/ 1716084 h 1798634"/>
                  <a:gd name="connsiteX46" fmla="*/ 1377950 w 1822450"/>
                  <a:gd name="connsiteY46" fmla="*/ 1728784 h 1798634"/>
                  <a:gd name="connsiteX47" fmla="*/ 1282700 w 1822450"/>
                  <a:gd name="connsiteY47" fmla="*/ 1735134 h 1798634"/>
                  <a:gd name="connsiteX48" fmla="*/ 1263650 w 1822450"/>
                  <a:gd name="connsiteY48" fmla="*/ 1747834 h 1798634"/>
                  <a:gd name="connsiteX49" fmla="*/ 1193800 w 1822450"/>
                  <a:gd name="connsiteY49" fmla="*/ 1766884 h 1798634"/>
                  <a:gd name="connsiteX50" fmla="*/ 1155700 w 1822450"/>
                  <a:gd name="connsiteY50" fmla="*/ 1779584 h 1798634"/>
                  <a:gd name="connsiteX51" fmla="*/ 1136650 w 1822450"/>
                  <a:gd name="connsiteY51" fmla="*/ 1785934 h 1798634"/>
                  <a:gd name="connsiteX52" fmla="*/ 1079500 w 1822450"/>
                  <a:gd name="connsiteY52" fmla="*/ 1798634 h 1798634"/>
                  <a:gd name="connsiteX53" fmla="*/ 793750 w 1822450"/>
                  <a:gd name="connsiteY53" fmla="*/ 1792284 h 1798634"/>
                  <a:gd name="connsiteX54" fmla="*/ 723900 w 1822450"/>
                  <a:gd name="connsiteY54" fmla="*/ 1779584 h 1798634"/>
                  <a:gd name="connsiteX55" fmla="*/ 673100 w 1822450"/>
                  <a:gd name="connsiteY55" fmla="*/ 1754184 h 1798634"/>
                  <a:gd name="connsiteX56" fmla="*/ 558800 w 1822450"/>
                  <a:gd name="connsiteY56" fmla="*/ 1735134 h 1798634"/>
                  <a:gd name="connsiteX57" fmla="*/ 520700 w 1822450"/>
                  <a:gd name="connsiteY57" fmla="*/ 1722434 h 1798634"/>
                  <a:gd name="connsiteX58" fmla="*/ 476250 w 1822450"/>
                  <a:gd name="connsiteY58" fmla="*/ 1703384 h 1798634"/>
                  <a:gd name="connsiteX59" fmla="*/ 438150 w 1822450"/>
                  <a:gd name="connsiteY59" fmla="*/ 1684334 h 1798634"/>
                  <a:gd name="connsiteX60" fmla="*/ 387350 w 1822450"/>
                  <a:gd name="connsiteY60" fmla="*/ 1671634 h 1798634"/>
                  <a:gd name="connsiteX61" fmla="*/ 368300 w 1822450"/>
                  <a:gd name="connsiteY61" fmla="*/ 1658934 h 1798634"/>
                  <a:gd name="connsiteX62" fmla="*/ 311150 w 1822450"/>
                  <a:gd name="connsiteY62" fmla="*/ 1646234 h 1798634"/>
                  <a:gd name="connsiteX63" fmla="*/ 301625 w 1822450"/>
                  <a:gd name="connsiteY63" fmla="*/ 1636709 h 1798634"/>
                  <a:gd name="connsiteX64" fmla="*/ 292100 w 1822450"/>
                  <a:gd name="connsiteY64" fmla="*/ 1633534 h 1798634"/>
                  <a:gd name="connsiteX65" fmla="*/ 247650 w 1822450"/>
                  <a:gd name="connsiteY65" fmla="*/ 1576384 h 1798634"/>
                  <a:gd name="connsiteX66" fmla="*/ 228600 w 1822450"/>
                  <a:gd name="connsiteY66" fmla="*/ 1563684 h 1798634"/>
                  <a:gd name="connsiteX67" fmla="*/ 209550 w 1822450"/>
                  <a:gd name="connsiteY67" fmla="*/ 1557334 h 1798634"/>
                  <a:gd name="connsiteX68" fmla="*/ 203200 w 1822450"/>
                  <a:gd name="connsiteY68" fmla="*/ 1538284 h 1798634"/>
                  <a:gd name="connsiteX69" fmla="*/ 165100 w 1822450"/>
                  <a:gd name="connsiteY69" fmla="*/ 1519234 h 1798634"/>
                  <a:gd name="connsiteX70" fmla="*/ 139700 w 1822450"/>
                  <a:gd name="connsiteY70" fmla="*/ 1481134 h 1798634"/>
                  <a:gd name="connsiteX71" fmla="*/ 133350 w 1822450"/>
                  <a:gd name="connsiteY71" fmla="*/ 1455734 h 1798634"/>
                  <a:gd name="connsiteX72" fmla="*/ 107950 w 1822450"/>
                  <a:gd name="connsiteY72" fmla="*/ 1423984 h 1798634"/>
                  <a:gd name="connsiteX73" fmla="*/ 95250 w 1822450"/>
                  <a:gd name="connsiteY73" fmla="*/ 1404934 h 1798634"/>
                  <a:gd name="connsiteX74" fmla="*/ 88900 w 1822450"/>
                  <a:gd name="connsiteY74" fmla="*/ 1385884 h 1798634"/>
                  <a:gd name="connsiteX75" fmla="*/ 69850 w 1822450"/>
                  <a:gd name="connsiteY75" fmla="*/ 1373184 h 1798634"/>
                  <a:gd name="connsiteX76" fmla="*/ 50800 w 1822450"/>
                  <a:gd name="connsiteY76" fmla="*/ 1335084 h 1798634"/>
                  <a:gd name="connsiteX77" fmla="*/ 38100 w 1822450"/>
                  <a:gd name="connsiteY77" fmla="*/ 1296984 h 1798634"/>
                  <a:gd name="connsiteX78" fmla="*/ 31750 w 1822450"/>
                  <a:gd name="connsiteY78" fmla="*/ 1277934 h 1798634"/>
                  <a:gd name="connsiteX79" fmla="*/ 0 w 1822450"/>
                  <a:gd name="connsiteY79" fmla="*/ 1233484 h 1798634"/>
                  <a:gd name="connsiteX80" fmla="*/ 6350 w 1822450"/>
                  <a:gd name="connsiteY80" fmla="*/ 1138234 h 1798634"/>
                  <a:gd name="connsiteX81" fmla="*/ 19050 w 1822450"/>
                  <a:gd name="connsiteY81" fmla="*/ 1100134 h 1798634"/>
                  <a:gd name="connsiteX82" fmla="*/ 25400 w 1822450"/>
                  <a:gd name="connsiteY82" fmla="*/ 1068384 h 1798634"/>
                  <a:gd name="connsiteX83" fmla="*/ 38100 w 1822450"/>
                  <a:gd name="connsiteY83" fmla="*/ 1030284 h 1798634"/>
                  <a:gd name="connsiteX84" fmla="*/ 44450 w 1822450"/>
                  <a:gd name="connsiteY84" fmla="*/ 1011234 h 1798634"/>
                  <a:gd name="connsiteX85" fmla="*/ 38100 w 1822450"/>
                  <a:gd name="connsiteY85" fmla="*/ 979484 h 1798634"/>
                  <a:gd name="connsiteX86" fmla="*/ 25400 w 1822450"/>
                  <a:gd name="connsiteY86" fmla="*/ 941384 h 1798634"/>
                  <a:gd name="connsiteX87" fmla="*/ 25400 w 1822450"/>
                  <a:gd name="connsiteY87" fmla="*/ 738184 h 1798634"/>
                  <a:gd name="connsiteX88" fmla="*/ 31750 w 1822450"/>
                  <a:gd name="connsiteY88" fmla="*/ 700084 h 1798634"/>
                  <a:gd name="connsiteX89" fmla="*/ 63500 w 1822450"/>
                  <a:gd name="connsiteY89" fmla="*/ 636584 h 1798634"/>
                  <a:gd name="connsiteX90" fmla="*/ 82550 w 1822450"/>
                  <a:gd name="connsiteY90" fmla="*/ 623884 h 1798634"/>
                  <a:gd name="connsiteX91" fmla="*/ 95250 w 1822450"/>
                  <a:gd name="connsiteY91" fmla="*/ 585784 h 1798634"/>
                  <a:gd name="connsiteX92" fmla="*/ 101600 w 1822450"/>
                  <a:gd name="connsiteY92" fmla="*/ 566734 h 1798634"/>
                  <a:gd name="connsiteX93" fmla="*/ 120650 w 1822450"/>
                  <a:gd name="connsiteY93" fmla="*/ 554034 h 1798634"/>
                  <a:gd name="connsiteX94" fmla="*/ 146050 w 1822450"/>
                  <a:gd name="connsiteY94" fmla="*/ 515934 h 1798634"/>
                  <a:gd name="connsiteX95" fmla="*/ 152400 w 1822450"/>
                  <a:gd name="connsiteY95" fmla="*/ 496884 h 1798634"/>
                  <a:gd name="connsiteX96" fmla="*/ 171450 w 1822450"/>
                  <a:gd name="connsiteY96" fmla="*/ 477834 h 1798634"/>
                  <a:gd name="connsiteX97" fmla="*/ 184150 w 1822450"/>
                  <a:gd name="connsiteY97" fmla="*/ 458784 h 1798634"/>
                  <a:gd name="connsiteX98" fmla="*/ 203200 w 1822450"/>
                  <a:gd name="connsiteY98" fmla="*/ 446084 h 1798634"/>
                  <a:gd name="connsiteX99" fmla="*/ 279400 w 1822450"/>
                  <a:gd name="connsiteY99" fmla="*/ 382584 h 1798634"/>
                  <a:gd name="connsiteX100" fmla="*/ 317500 w 1822450"/>
                  <a:gd name="connsiteY100" fmla="*/ 369884 h 1798634"/>
                  <a:gd name="connsiteX101" fmla="*/ 355600 w 1822450"/>
                  <a:gd name="connsiteY101" fmla="*/ 350834 h 1798634"/>
                  <a:gd name="connsiteX102" fmla="*/ 374650 w 1822450"/>
                  <a:gd name="connsiteY102" fmla="*/ 338134 h 1798634"/>
                  <a:gd name="connsiteX103" fmla="*/ 431800 w 1822450"/>
                  <a:gd name="connsiteY103" fmla="*/ 319084 h 1798634"/>
                  <a:gd name="connsiteX104" fmla="*/ 450850 w 1822450"/>
                  <a:gd name="connsiteY104" fmla="*/ 312734 h 1798634"/>
                  <a:gd name="connsiteX105" fmla="*/ 469900 w 1822450"/>
                  <a:gd name="connsiteY105" fmla="*/ 300034 h 1798634"/>
                  <a:gd name="connsiteX106" fmla="*/ 527050 w 1822450"/>
                  <a:gd name="connsiteY106" fmla="*/ 280984 h 1798634"/>
                  <a:gd name="connsiteX107" fmla="*/ 584200 w 1822450"/>
                  <a:gd name="connsiteY107" fmla="*/ 261934 h 1798634"/>
                  <a:gd name="connsiteX108" fmla="*/ 603250 w 1822450"/>
                  <a:gd name="connsiteY108" fmla="*/ 255584 h 1798634"/>
                  <a:gd name="connsiteX109" fmla="*/ 622300 w 1822450"/>
                  <a:gd name="connsiteY109" fmla="*/ 249234 h 1798634"/>
                  <a:gd name="connsiteX110" fmla="*/ 711200 w 1822450"/>
                  <a:gd name="connsiteY110" fmla="*/ 242884 h 1798634"/>
                  <a:gd name="connsiteX111" fmla="*/ 774700 w 1822450"/>
                  <a:gd name="connsiteY111" fmla="*/ 230184 h 1798634"/>
                  <a:gd name="connsiteX112" fmla="*/ 838200 w 1822450"/>
                  <a:gd name="connsiteY112" fmla="*/ 211134 h 1798634"/>
                  <a:gd name="connsiteX113" fmla="*/ 876300 w 1822450"/>
                  <a:gd name="connsiteY113" fmla="*/ 198434 h 1798634"/>
                  <a:gd name="connsiteX114" fmla="*/ 895350 w 1822450"/>
                  <a:gd name="connsiteY114" fmla="*/ 192084 h 1798634"/>
                  <a:gd name="connsiteX115" fmla="*/ 908050 w 1822450"/>
                  <a:gd name="connsiteY115" fmla="*/ 173034 h 1798634"/>
                  <a:gd name="connsiteX116" fmla="*/ 927100 w 1822450"/>
                  <a:gd name="connsiteY116" fmla="*/ 160334 h 1798634"/>
                  <a:gd name="connsiteX117" fmla="*/ 933450 w 1822450"/>
                  <a:gd name="connsiteY117" fmla="*/ 141284 h 1798634"/>
                  <a:gd name="connsiteX118" fmla="*/ 946150 w 1822450"/>
                  <a:gd name="connsiteY118" fmla="*/ 122234 h 1798634"/>
                  <a:gd name="connsiteX119" fmla="*/ 958850 w 1822450"/>
                  <a:gd name="connsiteY119" fmla="*/ 84134 h 1798634"/>
                  <a:gd name="connsiteX120" fmla="*/ 965200 w 1822450"/>
                  <a:gd name="connsiteY120" fmla="*/ 26984 h 1798634"/>
                  <a:gd name="connsiteX121" fmla="*/ 971550 w 1822450"/>
                  <a:gd name="connsiteY121" fmla="*/ 7934 h 1798634"/>
                  <a:gd name="connsiteX122" fmla="*/ 990600 w 1822450"/>
                  <a:gd name="connsiteY122" fmla="*/ 1584 h 1798634"/>
                  <a:gd name="connsiteX123" fmla="*/ 1066800 w 1822450"/>
                  <a:gd name="connsiteY123" fmla="*/ 14284 h 1798634"/>
                  <a:gd name="connsiteX124" fmla="*/ 1104900 w 1822450"/>
                  <a:gd name="connsiteY124" fmla="*/ 33334 h 1798634"/>
                  <a:gd name="connsiteX125" fmla="*/ 1123950 w 1822450"/>
                  <a:gd name="connsiteY125" fmla="*/ 46034 h 1798634"/>
                  <a:gd name="connsiteX126" fmla="*/ 1143000 w 1822450"/>
                  <a:gd name="connsiteY126" fmla="*/ 52384 h 1798634"/>
                  <a:gd name="connsiteX127" fmla="*/ 1200150 w 1822450"/>
                  <a:gd name="connsiteY127" fmla="*/ 90484 h 1798634"/>
                  <a:gd name="connsiteX128" fmla="*/ 1219200 w 1822450"/>
                  <a:gd name="connsiteY128" fmla="*/ 103184 h 1798634"/>
                  <a:gd name="connsiteX129" fmla="*/ 1238250 w 1822450"/>
                  <a:gd name="connsiteY129" fmla="*/ 115884 h 1798634"/>
                  <a:gd name="connsiteX130" fmla="*/ 1257300 w 1822450"/>
                  <a:gd name="connsiteY130" fmla="*/ 134934 h 1798634"/>
                  <a:gd name="connsiteX131" fmla="*/ 1295400 w 1822450"/>
                  <a:gd name="connsiteY131" fmla="*/ 160334 h 1798634"/>
                  <a:gd name="connsiteX132" fmla="*/ 1320800 w 1822450"/>
                  <a:gd name="connsiteY132" fmla="*/ 185734 h 1798634"/>
                  <a:gd name="connsiteX133" fmla="*/ 1333500 w 1822450"/>
                  <a:gd name="connsiteY133" fmla="*/ 204784 h 1798634"/>
                  <a:gd name="connsiteX134" fmla="*/ 1352550 w 1822450"/>
                  <a:gd name="connsiteY134" fmla="*/ 217484 h 1798634"/>
                  <a:gd name="connsiteX135" fmla="*/ 1358900 w 1822450"/>
                  <a:gd name="connsiteY135" fmla="*/ 268284 h 1798634"/>
                  <a:gd name="connsiteX0" fmla="*/ 1358900 w 1822450"/>
                  <a:gd name="connsiteY0" fmla="*/ 268284 h 1798634"/>
                  <a:gd name="connsiteX1" fmla="*/ 1397000 w 1822450"/>
                  <a:gd name="connsiteY1" fmla="*/ 287334 h 1798634"/>
                  <a:gd name="connsiteX2" fmla="*/ 1435100 w 1822450"/>
                  <a:gd name="connsiteY2" fmla="*/ 300034 h 1798634"/>
                  <a:gd name="connsiteX3" fmla="*/ 1454150 w 1822450"/>
                  <a:gd name="connsiteY3" fmla="*/ 306384 h 1798634"/>
                  <a:gd name="connsiteX4" fmla="*/ 1473200 w 1822450"/>
                  <a:gd name="connsiteY4" fmla="*/ 312734 h 1798634"/>
                  <a:gd name="connsiteX5" fmla="*/ 1492250 w 1822450"/>
                  <a:gd name="connsiteY5" fmla="*/ 319084 h 1798634"/>
                  <a:gd name="connsiteX6" fmla="*/ 1504950 w 1822450"/>
                  <a:gd name="connsiteY6" fmla="*/ 338134 h 1798634"/>
                  <a:gd name="connsiteX7" fmla="*/ 1543050 w 1822450"/>
                  <a:gd name="connsiteY7" fmla="*/ 350834 h 1798634"/>
                  <a:gd name="connsiteX8" fmla="*/ 1574800 w 1822450"/>
                  <a:gd name="connsiteY8" fmla="*/ 382584 h 1798634"/>
                  <a:gd name="connsiteX9" fmla="*/ 1606550 w 1822450"/>
                  <a:gd name="connsiteY9" fmla="*/ 407984 h 1798634"/>
                  <a:gd name="connsiteX10" fmla="*/ 1631950 w 1822450"/>
                  <a:gd name="connsiteY10" fmla="*/ 446084 h 1798634"/>
                  <a:gd name="connsiteX11" fmla="*/ 1644650 w 1822450"/>
                  <a:gd name="connsiteY11" fmla="*/ 465134 h 1798634"/>
                  <a:gd name="connsiteX12" fmla="*/ 1663700 w 1822450"/>
                  <a:gd name="connsiteY12" fmla="*/ 471484 h 1798634"/>
                  <a:gd name="connsiteX13" fmla="*/ 1676400 w 1822450"/>
                  <a:gd name="connsiteY13" fmla="*/ 490534 h 1798634"/>
                  <a:gd name="connsiteX14" fmla="*/ 1695450 w 1822450"/>
                  <a:gd name="connsiteY14" fmla="*/ 528634 h 1798634"/>
                  <a:gd name="connsiteX15" fmla="*/ 1746250 w 1822450"/>
                  <a:gd name="connsiteY15" fmla="*/ 585784 h 1798634"/>
                  <a:gd name="connsiteX16" fmla="*/ 1752600 w 1822450"/>
                  <a:gd name="connsiteY16" fmla="*/ 604834 h 1798634"/>
                  <a:gd name="connsiteX17" fmla="*/ 1778000 w 1822450"/>
                  <a:gd name="connsiteY17" fmla="*/ 642934 h 1798634"/>
                  <a:gd name="connsiteX18" fmla="*/ 1809750 w 1822450"/>
                  <a:gd name="connsiteY18" fmla="*/ 738184 h 1798634"/>
                  <a:gd name="connsiteX19" fmla="*/ 1816100 w 1822450"/>
                  <a:gd name="connsiteY19" fmla="*/ 757234 h 1798634"/>
                  <a:gd name="connsiteX20" fmla="*/ 1822450 w 1822450"/>
                  <a:gd name="connsiteY20" fmla="*/ 776284 h 1798634"/>
                  <a:gd name="connsiteX21" fmla="*/ 1816100 w 1822450"/>
                  <a:gd name="connsiteY21" fmla="*/ 903284 h 1798634"/>
                  <a:gd name="connsiteX22" fmla="*/ 1809750 w 1822450"/>
                  <a:gd name="connsiteY22" fmla="*/ 922334 h 1798634"/>
                  <a:gd name="connsiteX23" fmla="*/ 1803400 w 1822450"/>
                  <a:gd name="connsiteY23" fmla="*/ 954084 h 1798634"/>
                  <a:gd name="connsiteX24" fmla="*/ 1790700 w 1822450"/>
                  <a:gd name="connsiteY24" fmla="*/ 998534 h 1798634"/>
                  <a:gd name="connsiteX25" fmla="*/ 1797050 w 1822450"/>
                  <a:gd name="connsiteY25" fmla="*/ 1062034 h 1798634"/>
                  <a:gd name="connsiteX26" fmla="*/ 1803400 w 1822450"/>
                  <a:gd name="connsiteY26" fmla="*/ 1100134 h 1798634"/>
                  <a:gd name="connsiteX27" fmla="*/ 1816100 w 1822450"/>
                  <a:gd name="connsiteY27" fmla="*/ 1157284 h 1798634"/>
                  <a:gd name="connsiteX28" fmla="*/ 1809750 w 1822450"/>
                  <a:gd name="connsiteY28" fmla="*/ 1258884 h 1798634"/>
                  <a:gd name="connsiteX29" fmla="*/ 1803400 w 1822450"/>
                  <a:gd name="connsiteY29" fmla="*/ 1284284 h 1798634"/>
                  <a:gd name="connsiteX30" fmla="*/ 1784350 w 1822450"/>
                  <a:gd name="connsiteY30" fmla="*/ 1373184 h 1798634"/>
                  <a:gd name="connsiteX31" fmla="*/ 1778000 w 1822450"/>
                  <a:gd name="connsiteY31" fmla="*/ 1392234 h 1798634"/>
                  <a:gd name="connsiteX32" fmla="*/ 1765300 w 1822450"/>
                  <a:gd name="connsiteY32" fmla="*/ 1417634 h 1798634"/>
                  <a:gd name="connsiteX33" fmla="*/ 1733550 w 1822450"/>
                  <a:gd name="connsiteY33" fmla="*/ 1474784 h 1798634"/>
                  <a:gd name="connsiteX34" fmla="*/ 1720850 w 1822450"/>
                  <a:gd name="connsiteY34" fmla="*/ 1493834 h 1798634"/>
                  <a:gd name="connsiteX35" fmla="*/ 1701800 w 1822450"/>
                  <a:gd name="connsiteY35" fmla="*/ 1506534 h 1798634"/>
                  <a:gd name="connsiteX36" fmla="*/ 1638300 w 1822450"/>
                  <a:gd name="connsiteY36" fmla="*/ 1550984 h 1798634"/>
                  <a:gd name="connsiteX37" fmla="*/ 1622425 w 1822450"/>
                  <a:gd name="connsiteY37" fmla="*/ 1550984 h 1798634"/>
                  <a:gd name="connsiteX38" fmla="*/ 1612900 w 1822450"/>
                  <a:gd name="connsiteY38" fmla="*/ 1557334 h 1798634"/>
                  <a:gd name="connsiteX39" fmla="*/ 1606550 w 1822450"/>
                  <a:gd name="connsiteY39" fmla="*/ 1576384 h 1798634"/>
                  <a:gd name="connsiteX40" fmla="*/ 1555750 w 1822450"/>
                  <a:gd name="connsiteY40" fmla="*/ 1633534 h 1798634"/>
                  <a:gd name="connsiteX41" fmla="*/ 1511300 w 1822450"/>
                  <a:gd name="connsiteY41" fmla="*/ 1646234 h 1798634"/>
                  <a:gd name="connsiteX42" fmla="*/ 1485900 w 1822450"/>
                  <a:gd name="connsiteY42" fmla="*/ 1671634 h 1798634"/>
                  <a:gd name="connsiteX43" fmla="*/ 1447800 w 1822450"/>
                  <a:gd name="connsiteY43" fmla="*/ 1697034 h 1798634"/>
                  <a:gd name="connsiteX44" fmla="*/ 1422400 w 1822450"/>
                  <a:gd name="connsiteY44" fmla="*/ 1703384 h 1798634"/>
                  <a:gd name="connsiteX45" fmla="*/ 1397000 w 1822450"/>
                  <a:gd name="connsiteY45" fmla="*/ 1716084 h 1798634"/>
                  <a:gd name="connsiteX46" fmla="*/ 1377950 w 1822450"/>
                  <a:gd name="connsiteY46" fmla="*/ 1728784 h 1798634"/>
                  <a:gd name="connsiteX47" fmla="*/ 1282700 w 1822450"/>
                  <a:gd name="connsiteY47" fmla="*/ 1735134 h 1798634"/>
                  <a:gd name="connsiteX48" fmla="*/ 1263650 w 1822450"/>
                  <a:gd name="connsiteY48" fmla="*/ 1747834 h 1798634"/>
                  <a:gd name="connsiteX49" fmla="*/ 1193800 w 1822450"/>
                  <a:gd name="connsiteY49" fmla="*/ 1766884 h 1798634"/>
                  <a:gd name="connsiteX50" fmla="*/ 1155700 w 1822450"/>
                  <a:gd name="connsiteY50" fmla="*/ 1779584 h 1798634"/>
                  <a:gd name="connsiteX51" fmla="*/ 1136650 w 1822450"/>
                  <a:gd name="connsiteY51" fmla="*/ 1785934 h 1798634"/>
                  <a:gd name="connsiteX52" fmla="*/ 1079500 w 1822450"/>
                  <a:gd name="connsiteY52" fmla="*/ 1798634 h 1798634"/>
                  <a:gd name="connsiteX53" fmla="*/ 793750 w 1822450"/>
                  <a:gd name="connsiteY53" fmla="*/ 1792284 h 1798634"/>
                  <a:gd name="connsiteX54" fmla="*/ 723900 w 1822450"/>
                  <a:gd name="connsiteY54" fmla="*/ 1779584 h 1798634"/>
                  <a:gd name="connsiteX55" fmla="*/ 673100 w 1822450"/>
                  <a:gd name="connsiteY55" fmla="*/ 1754184 h 1798634"/>
                  <a:gd name="connsiteX56" fmla="*/ 558800 w 1822450"/>
                  <a:gd name="connsiteY56" fmla="*/ 1735134 h 1798634"/>
                  <a:gd name="connsiteX57" fmla="*/ 520700 w 1822450"/>
                  <a:gd name="connsiteY57" fmla="*/ 1722434 h 1798634"/>
                  <a:gd name="connsiteX58" fmla="*/ 476250 w 1822450"/>
                  <a:gd name="connsiteY58" fmla="*/ 1703384 h 1798634"/>
                  <a:gd name="connsiteX59" fmla="*/ 438150 w 1822450"/>
                  <a:gd name="connsiteY59" fmla="*/ 1684334 h 1798634"/>
                  <a:gd name="connsiteX60" fmla="*/ 387350 w 1822450"/>
                  <a:gd name="connsiteY60" fmla="*/ 1671634 h 1798634"/>
                  <a:gd name="connsiteX61" fmla="*/ 368300 w 1822450"/>
                  <a:gd name="connsiteY61" fmla="*/ 1658934 h 1798634"/>
                  <a:gd name="connsiteX62" fmla="*/ 311150 w 1822450"/>
                  <a:gd name="connsiteY62" fmla="*/ 1646234 h 1798634"/>
                  <a:gd name="connsiteX63" fmla="*/ 301625 w 1822450"/>
                  <a:gd name="connsiteY63" fmla="*/ 1636709 h 1798634"/>
                  <a:gd name="connsiteX64" fmla="*/ 292100 w 1822450"/>
                  <a:gd name="connsiteY64" fmla="*/ 1633534 h 1798634"/>
                  <a:gd name="connsiteX65" fmla="*/ 247650 w 1822450"/>
                  <a:gd name="connsiteY65" fmla="*/ 1576384 h 1798634"/>
                  <a:gd name="connsiteX66" fmla="*/ 228600 w 1822450"/>
                  <a:gd name="connsiteY66" fmla="*/ 1563684 h 1798634"/>
                  <a:gd name="connsiteX67" fmla="*/ 209550 w 1822450"/>
                  <a:gd name="connsiteY67" fmla="*/ 1557334 h 1798634"/>
                  <a:gd name="connsiteX68" fmla="*/ 203200 w 1822450"/>
                  <a:gd name="connsiteY68" fmla="*/ 1538284 h 1798634"/>
                  <a:gd name="connsiteX69" fmla="*/ 165100 w 1822450"/>
                  <a:gd name="connsiteY69" fmla="*/ 1519234 h 1798634"/>
                  <a:gd name="connsiteX70" fmla="*/ 139700 w 1822450"/>
                  <a:gd name="connsiteY70" fmla="*/ 1481134 h 1798634"/>
                  <a:gd name="connsiteX71" fmla="*/ 133350 w 1822450"/>
                  <a:gd name="connsiteY71" fmla="*/ 1455734 h 1798634"/>
                  <a:gd name="connsiteX72" fmla="*/ 107950 w 1822450"/>
                  <a:gd name="connsiteY72" fmla="*/ 1423984 h 1798634"/>
                  <a:gd name="connsiteX73" fmla="*/ 95250 w 1822450"/>
                  <a:gd name="connsiteY73" fmla="*/ 1404934 h 1798634"/>
                  <a:gd name="connsiteX74" fmla="*/ 88900 w 1822450"/>
                  <a:gd name="connsiteY74" fmla="*/ 1385884 h 1798634"/>
                  <a:gd name="connsiteX75" fmla="*/ 69850 w 1822450"/>
                  <a:gd name="connsiteY75" fmla="*/ 1373184 h 1798634"/>
                  <a:gd name="connsiteX76" fmla="*/ 50800 w 1822450"/>
                  <a:gd name="connsiteY76" fmla="*/ 1335084 h 1798634"/>
                  <a:gd name="connsiteX77" fmla="*/ 38100 w 1822450"/>
                  <a:gd name="connsiteY77" fmla="*/ 1296984 h 1798634"/>
                  <a:gd name="connsiteX78" fmla="*/ 31750 w 1822450"/>
                  <a:gd name="connsiteY78" fmla="*/ 1277934 h 1798634"/>
                  <a:gd name="connsiteX79" fmla="*/ 0 w 1822450"/>
                  <a:gd name="connsiteY79" fmla="*/ 1233484 h 1798634"/>
                  <a:gd name="connsiteX80" fmla="*/ 6350 w 1822450"/>
                  <a:gd name="connsiteY80" fmla="*/ 1138234 h 1798634"/>
                  <a:gd name="connsiteX81" fmla="*/ 19050 w 1822450"/>
                  <a:gd name="connsiteY81" fmla="*/ 1100134 h 1798634"/>
                  <a:gd name="connsiteX82" fmla="*/ 25400 w 1822450"/>
                  <a:gd name="connsiteY82" fmla="*/ 1068384 h 1798634"/>
                  <a:gd name="connsiteX83" fmla="*/ 38100 w 1822450"/>
                  <a:gd name="connsiteY83" fmla="*/ 1030284 h 1798634"/>
                  <a:gd name="connsiteX84" fmla="*/ 44450 w 1822450"/>
                  <a:gd name="connsiteY84" fmla="*/ 1011234 h 1798634"/>
                  <a:gd name="connsiteX85" fmla="*/ 38100 w 1822450"/>
                  <a:gd name="connsiteY85" fmla="*/ 979484 h 1798634"/>
                  <a:gd name="connsiteX86" fmla="*/ 25400 w 1822450"/>
                  <a:gd name="connsiteY86" fmla="*/ 941384 h 1798634"/>
                  <a:gd name="connsiteX87" fmla="*/ 25400 w 1822450"/>
                  <a:gd name="connsiteY87" fmla="*/ 738184 h 1798634"/>
                  <a:gd name="connsiteX88" fmla="*/ 31750 w 1822450"/>
                  <a:gd name="connsiteY88" fmla="*/ 700084 h 1798634"/>
                  <a:gd name="connsiteX89" fmla="*/ 63500 w 1822450"/>
                  <a:gd name="connsiteY89" fmla="*/ 636584 h 1798634"/>
                  <a:gd name="connsiteX90" fmla="*/ 82550 w 1822450"/>
                  <a:gd name="connsiteY90" fmla="*/ 623884 h 1798634"/>
                  <a:gd name="connsiteX91" fmla="*/ 95250 w 1822450"/>
                  <a:gd name="connsiteY91" fmla="*/ 585784 h 1798634"/>
                  <a:gd name="connsiteX92" fmla="*/ 101600 w 1822450"/>
                  <a:gd name="connsiteY92" fmla="*/ 566734 h 1798634"/>
                  <a:gd name="connsiteX93" fmla="*/ 120650 w 1822450"/>
                  <a:gd name="connsiteY93" fmla="*/ 554034 h 1798634"/>
                  <a:gd name="connsiteX94" fmla="*/ 146050 w 1822450"/>
                  <a:gd name="connsiteY94" fmla="*/ 515934 h 1798634"/>
                  <a:gd name="connsiteX95" fmla="*/ 152400 w 1822450"/>
                  <a:gd name="connsiteY95" fmla="*/ 496884 h 1798634"/>
                  <a:gd name="connsiteX96" fmla="*/ 171450 w 1822450"/>
                  <a:gd name="connsiteY96" fmla="*/ 477834 h 1798634"/>
                  <a:gd name="connsiteX97" fmla="*/ 184150 w 1822450"/>
                  <a:gd name="connsiteY97" fmla="*/ 458784 h 1798634"/>
                  <a:gd name="connsiteX98" fmla="*/ 203200 w 1822450"/>
                  <a:gd name="connsiteY98" fmla="*/ 446084 h 1798634"/>
                  <a:gd name="connsiteX99" fmla="*/ 279400 w 1822450"/>
                  <a:gd name="connsiteY99" fmla="*/ 382584 h 1798634"/>
                  <a:gd name="connsiteX100" fmla="*/ 317500 w 1822450"/>
                  <a:gd name="connsiteY100" fmla="*/ 369884 h 1798634"/>
                  <a:gd name="connsiteX101" fmla="*/ 355600 w 1822450"/>
                  <a:gd name="connsiteY101" fmla="*/ 350834 h 1798634"/>
                  <a:gd name="connsiteX102" fmla="*/ 374650 w 1822450"/>
                  <a:gd name="connsiteY102" fmla="*/ 338134 h 1798634"/>
                  <a:gd name="connsiteX103" fmla="*/ 431800 w 1822450"/>
                  <a:gd name="connsiteY103" fmla="*/ 319084 h 1798634"/>
                  <a:gd name="connsiteX104" fmla="*/ 450850 w 1822450"/>
                  <a:gd name="connsiteY104" fmla="*/ 312734 h 1798634"/>
                  <a:gd name="connsiteX105" fmla="*/ 469900 w 1822450"/>
                  <a:gd name="connsiteY105" fmla="*/ 300034 h 1798634"/>
                  <a:gd name="connsiteX106" fmla="*/ 527050 w 1822450"/>
                  <a:gd name="connsiteY106" fmla="*/ 280984 h 1798634"/>
                  <a:gd name="connsiteX107" fmla="*/ 584200 w 1822450"/>
                  <a:gd name="connsiteY107" fmla="*/ 261934 h 1798634"/>
                  <a:gd name="connsiteX108" fmla="*/ 603250 w 1822450"/>
                  <a:gd name="connsiteY108" fmla="*/ 255584 h 1798634"/>
                  <a:gd name="connsiteX109" fmla="*/ 622300 w 1822450"/>
                  <a:gd name="connsiteY109" fmla="*/ 249234 h 1798634"/>
                  <a:gd name="connsiteX110" fmla="*/ 711200 w 1822450"/>
                  <a:gd name="connsiteY110" fmla="*/ 242884 h 1798634"/>
                  <a:gd name="connsiteX111" fmla="*/ 774700 w 1822450"/>
                  <a:gd name="connsiteY111" fmla="*/ 230184 h 1798634"/>
                  <a:gd name="connsiteX112" fmla="*/ 838200 w 1822450"/>
                  <a:gd name="connsiteY112" fmla="*/ 211134 h 1798634"/>
                  <a:gd name="connsiteX113" fmla="*/ 876300 w 1822450"/>
                  <a:gd name="connsiteY113" fmla="*/ 198434 h 1798634"/>
                  <a:gd name="connsiteX114" fmla="*/ 895350 w 1822450"/>
                  <a:gd name="connsiteY114" fmla="*/ 192084 h 1798634"/>
                  <a:gd name="connsiteX115" fmla="*/ 908050 w 1822450"/>
                  <a:gd name="connsiteY115" fmla="*/ 173034 h 1798634"/>
                  <a:gd name="connsiteX116" fmla="*/ 927100 w 1822450"/>
                  <a:gd name="connsiteY116" fmla="*/ 160334 h 1798634"/>
                  <a:gd name="connsiteX117" fmla="*/ 933450 w 1822450"/>
                  <a:gd name="connsiteY117" fmla="*/ 141284 h 1798634"/>
                  <a:gd name="connsiteX118" fmla="*/ 946150 w 1822450"/>
                  <a:gd name="connsiteY118" fmla="*/ 122234 h 1798634"/>
                  <a:gd name="connsiteX119" fmla="*/ 958850 w 1822450"/>
                  <a:gd name="connsiteY119" fmla="*/ 84134 h 1798634"/>
                  <a:gd name="connsiteX120" fmla="*/ 965200 w 1822450"/>
                  <a:gd name="connsiteY120" fmla="*/ 26984 h 1798634"/>
                  <a:gd name="connsiteX121" fmla="*/ 971550 w 1822450"/>
                  <a:gd name="connsiteY121" fmla="*/ 7934 h 1798634"/>
                  <a:gd name="connsiteX122" fmla="*/ 990600 w 1822450"/>
                  <a:gd name="connsiteY122" fmla="*/ 1584 h 1798634"/>
                  <a:gd name="connsiteX123" fmla="*/ 1066800 w 1822450"/>
                  <a:gd name="connsiteY123" fmla="*/ 14284 h 1798634"/>
                  <a:gd name="connsiteX124" fmla="*/ 1104900 w 1822450"/>
                  <a:gd name="connsiteY124" fmla="*/ 33334 h 1798634"/>
                  <a:gd name="connsiteX125" fmla="*/ 1123950 w 1822450"/>
                  <a:gd name="connsiteY125" fmla="*/ 46034 h 1798634"/>
                  <a:gd name="connsiteX126" fmla="*/ 1143000 w 1822450"/>
                  <a:gd name="connsiteY126" fmla="*/ 52384 h 1798634"/>
                  <a:gd name="connsiteX127" fmla="*/ 1200150 w 1822450"/>
                  <a:gd name="connsiteY127" fmla="*/ 90484 h 1798634"/>
                  <a:gd name="connsiteX128" fmla="*/ 1219200 w 1822450"/>
                  <a:gd name="connsiteY128" fmla="*/ 103184 h 1798634"/>
                  <a:gd name="connsiteX129" fmla="*/ 1238250 w 1822450"/>
                  <a:gd name="connsiteY129" fmla="*/ 115884 h 1798634"/>
                  <a:gd name="connsiteX130" fmla="*/ 1257300 w 1822450"/>
                  <a:gd name="connsiteY130" fmla="*/ 134934 h 1798634"/>
                  <a:gd name="connsiteX131" fmla="*/ 1295400 w 1822450"/>
                  <a:gd name="connsiteY131" fmla="*/ 160334 h 1798634"/>
                  <a:gd name="connsiteX132" fmla="*/ 1320800 w 1822450"/>
                  <a:gd name="connsiteY132" fmla="*/ 185734 h 1798634"/>
                  <a:gd name="connsiteX133" fmla="*/ 1333500 w 1822450"/>
                  <a:gd name="connsiteY133" fmla="*/ 204784 h 1798634"/>
                  <a:gd name="connsiteX134" fmla="*/ 1352550 w 1822450"/>
                  <a:gd name="connsiteY134" fmla="*/ 217484 h 1798634"/>
                  <a:gd name="connsiteX135" fmla="*/ 1358900 w 1822450"/>
                  <a:gd name="connsiteY135" fmla="*/ 268284 h 17986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Lst>
                <a:rect l="l" t="t" r="r" b="b"/>
                <a:pathLst>
                  <a:path w="1822450" h="1798634">
                    <a:moveTo>
                      <a:pt x="1358900" y="268284"/>
                    </a:moveTo>
                    <a:cubicBezTo>
                      <a:pt x="1366308" y="279926"/>
                      <a:pt x="1323142" y="254508"/>
                      <a:pt x="1397000" y="287334"/>
                    </a:cubicBezTo>
                    <a:cubicBezTo>
                      <a:pt x="1409233" y="292771"/>
                      <a:pt x="1422400" y="295801"/>
                      <a:pt x="1435100" y="300034"/>
                    </a:cubicBezTo>
                    <a:lnTo>
                      <a:pt x="1454150" y="306384"/>
                    </a:lnTo>
                    <a:lnTo>
                      <a:pt x="1473200" y="312734"/>
                    </a:lnTo>
                    <a:lnTo>
                      <a:pt x="1492250" y="319084"/>
                    </a:lnTo>
                    <a:cubicBezTo>
                      <a:pt x="1496483" y="325434"/>
                      <a:pt x="1498478" y="334089"/>
                      <a:pt x="1504950" y="338134"/>
                    </a:cubicBezTo>
                    <a:cubicBezTo>
                      <a:pt x="1516302" y="345229"/>
                      <a:pt x="1543050" y="350834"/>
                      <a:pt x="1543050" y="350834"/>
                    </a:cubicBezTo>
                    <a:cubicBezTo>
                      <a:pt x="1576917" y="401634"/>
                      <a:pt x="1532467" y="340251"/>
                      <a:pt x="1574800" y="382584"/>
                    </a:cubicBezTo>
                    <a:cubicBezTo>
                      <a:pt x="1603523" y="411307"/>
                      <a:pt x="1569464" y="395622"/>
                      <a:pt x="1606550" y="407984"/>
                    </a:cubicBezTo>
                    <a:lnTo>
                      <a:pt x="1631950" y="446084"/>
                    </a:lnTo>
                    <a:cubicBezTo>
                      <a:pt x="1636183" y="452434"/>
                      <a:pt x="1637410" y="462721"/>
                      <a:pt x="1644650" y="465134"/>
                    </a:cubicBezTo>
                    <a:lnTo>
                      <a:pt x="1663700" y="471484"/>
                    </a:lnTo>
                    <a:cubicBezTo>
                      <a:pt x="1667933" y="477834"/>
                      <a:pt x="1672987" y="483708"/>
                      <a:pt x="1676400" y="490534"/>
                    </a:cubicBezTo>
                    <a:cubicBezTo>
                      <a:pt x="1689009" y="515753"/>
                      <a:pt x="1674652" y="505236"/>
                      <a:pt x="1695450" y="528634"/>
                    </a:cubicBezTo>
                    <a:cubicBezTo>
                      <a:pt x="1714684" y="550272"/>
                      <a:pt x="1733897" y="561078"/>
                      <a:pt x="1746250" y="585784"/>
                    </a:cubicBezTo>
                    <a:cubicBezTo>
                      <a:pt x="1749243" y="591771"/>
                      <a:pt x="1749349" y="598983"/>
                      <a:pt x="1752600" y="604834"/>
                    </a:cubicBezTo>
                    <a:cubicBezTo>
                      <a:pt x="1760013" y="618177"/>
                      <a:pt x="1773173" y="628454"/>
                      <a:pt x="1778000" y="642934"/>
                    </a:cubicBezTo>
                    <a:lnTo>
                      <a:pt x="1809750" y="738184"/>
                    </a:lnTo>
                    <a:lnTo>
                      <a:pt x="1816100" y="757234"/>
                    </a:lnTo>
                    <a:lnTo>
                      <a:pt x="1822450" y="776284"/>
                    </a:lnTo>
                    <a:cubicBezTo>
                      <a:pt x="1820333" y="818617"/>
                      <a:pt x="1819772" y="861057"/>
                      <a:pt x="1816100" y="903284"/>
                    </a:cubicBezTo>
                    <a:cubicBezTo>
                      <a:pt x="1815520" y="909952"/>
                      <a:pt x="1811373" y="915840"/>
                      <a:pt x="1809750" y="922334"/>
                    </a:cubicBezTo>
                    <a:cubicBezTo>
                      <a:pt x="1807132" y="932805"/>
                      <a:pt x="1805741" y="943548"/>
                      <a:pt x="1803400" y="954084"/>
                    </a:cubicBezTo>
                    <a:cubicBezTo>
                      <a:pt x="1798084" y="978004"/>
                      <a:pt x="1797771" y="977320"/>
                      <a:pt x="1790700" y="998534"/>
                    </a:cubicBezTo>
                    <a:cubicBezTo>
                      <a:pt x="1792817" y="1019701"/>
                      <a:pt x="1794412" y="1040926"/>
                      <a:pt x="1797050" y="1062034"/>
                    </a:cubicBezTo>
                    <a:cubicBezTo>
                      <a:pt x="1798647" y="1074810"/>
                      <a:pt x="1801097" y="1087466"/>
                      <a:pt x="1803400" y="1100134"/>
                    </a:cubicBezTo>
                    <a:cubicBezTo>
                      <a:pt x="1808774" y="1129693"/>
                      <a:pt x="1809305" y="1130105"/>
                      <a:pt x="1816100" y="1157284"/>
                    </a:cubicBezTo>
                    <a:cubicBezTo>
                      <a:pt x="1813983" y="1191151"/>
                      <a:pt x="1813126" y="1225120"/>
                      <a:pt x="1809750" y="1258884"/>
                    </a:cubicBezTo>
                    <a:cubicBezTo>
                      <a:pt x="1808882" y="1267568"/>
                      <a:pt x="1805229" y="1275750"/>
                      <a:pt x="1803400" y="1284284"/>
                    </a:cubicBezTo>
                    <a:cubicBezTo>
                      <a:pt x="1797152" y="1313443"/>
                      <a:pt x="1792635" y="1344187"/>
                      <a:pt x="1784350" y="1373184"/>
                    </a:cubicBezTo>
                    <a:cubicBezTo>
                      <a:pt x="1782511" y="1379620"/>
                      <a:pt x="1780637" y="1386082"/>
                      <a:pt x="1778000" y="1392234"/>
                    </a:cubicBezTo>
                    <a:cubicBezTo>
                      <a:pt x="1774271" y="1400935"/>
                      <a:pt x="1769029" y="1408933"/>
                      <a:pt x="1765300" y="1417634"/>
                    </a:cubicBezTo>
                    <a:cubicBezTo>
                      <a:pt x="1745182" y="1464576"/>
                      <a:pt x="1783052" y="1400530"/>
                      <a:pt x="1733550" y="1474784"/>
                    </a:cubicBezTo>
                    <a:cubicBezTo>
                      <a:pt x="1729317" y="1481134"/>
                      <a:pt x="1727200" y="1489601"/>
                      <a:pt x="1720850" y="1493834"/>
                    </a:cubicBezTo>
                    <a:lnTo>
                      <a:pt x="1701800" y="1506534"/>
                    </a:lnTo>
                    <a:cubicBezTo>
                      <a:pt x="1667642" y="1557770"/>
                      <a:pt x="1692819" y="1540080"/>
                      <a:pt x="1638300" y="1550984"/>
                    </a:cubicBezTo>
                    <a:cubicBezTo>
                      <a:pt x="1625071" y="1558392"/>
                      <a:pt x="1658372" y="1589867"/>
                      <a:pt x="1622425" y="1550984"/>
                    </a:cubicBezTo>
                    <a:cubicBezTo>
                      <a:pt x="1618192" y="1552042"/>
                      <a:pt x="1615546" y="1553101"/>
                      <a:pt x="1612900" y="1557334"/>
                    </a:cubicBezTo>
                    <a:cubicBezTo>
                      <a:pt x="1610783" y="1563684"/>
                      <a:pt x="1609543" y="1570397"/>
                      <a:pt x="1606550" y="1576384"/>
                    </a:cubicBezTo>
                    <a:cubicBezTo>
                      <a:pt x="1598283" y="1592917"/>
                      <a:pt x="1565367" y="1631130"/>
                      <a:pt x="1555750" y="1633534"/>
                    </a:cubicBezTo>
                    <a:cubicBezTo>
                      <a:pt x="1523856" y="1641507"/>
                      <a:pt x="1538629" y="1637124"/>
                      <a:pt x="1511300" y="1646234"/>
                    </a:cubicBezTo>
                    <a:cubicBezTo>
                      <a:pt x="1500524" y="1678561"/>
                      <a:pt x="1513609" y="1656240"/>
                      <a:pt x="1485900" y="1671634"/>
                    </a:cubicBezTo>
                    <a:cubicBezTo>
                      <a:pt x="1472557" y="1679047"/>
                      <a:pt x="1460500" y="1688567"/>
                      <a:pt x="1447800" y="1697034"/>
                    </a:cubicBezTo>
                    <a:cubicBezTo>
                      <a:pt x="1440538" y="1701875"/>
                      <a:pt x="1430572" y="1700320"/>
                      <a:pt x="1422400" y="1703384"/>
                    </a:cubicBezTo>
                    <a:cubicBezTo>
                      <a:pt x="1413537" y="1706708"/>
                      <a:pt x="1405219" y="1711388"/>
                      <a:pt x="1397000" y="1716084"/>
                    </a:cubicBezTo>
                    <a:cubicBezTo>
                      <a:pt x="1390374" y="1719870"/>
                      <a:pt x="1385478" y="1727529"/>
                      <a:pt x="1377950" y="1728784"/>
                    </a:cubicBezTo>
                    <a:cubicBezTo>
                      <a:pt x="1346562" y="1734015"/>
                      <a:pt x="1314450" y="1733017"/>
                      <a:pt x="1282700" y="1735134"/>
                    </a:cubicBezTo>
                    <a:cubicBezTo>
                      <a:pt x="1276350" y="1739367"/>
                      <a:pt x="1270624" y="1744734"/>
                      <a:pt x="1263650" y="1747834"/>
                    </a:cubicBezTo>
                    <a:cubicBezTo>
                      <a:pt x="1223014" y="1765894"/>
                      <a:pt x="1232466" y="1756339"/>
                      <a:pt x="1193800" y="1766884"/>
                    </a:cubicBezTo>
                    <a:cubicBezTo>
                      <a:pt x="1180885" y="1770406"/>
                      <a:pt x="1168400" y="1775351"/>
                      <a:pt x="1155700" y="1779584"/>
                    </a:cubicBezTo>
                    <a:cubicBezTo>
                      <a:pt x="1149350" y="1781701"/>
                      <a:pt x="1143252" y="1784834"/>
                      <a:pt x="1136650" y="1785934"/>
                    </a:cubicBezTo>
                    <a:cubicBezTo>
                      <a:pt x="1091948" y="1793384"/>
                      <a:pt x="1110764" y="1788213"/>
                      <a:pt x="1079500" y="1798634"/>
                    </a:cubicBezTo>
                    <a:lnTo>
                      <a:pt x="793750" y="1792284"/>
                    </a:lnTo>
                    <a:cubicBezTo>
                      <a:pt x="783644" y="1791888"/>
                      <a:pt x="735884" y="1781981"/>
                      <a:pt x="723900" y="1779584"/>
                    </a:cubicBezTo>
                    <a:cubicBezTo>
                      <a:pt x="702255" y="1747117"/>
                      <a:pt x="721770" y="1766351"/>
                      <a:pt x="673100" y="1754184"/>
                    </a:cubicBezTo>
                    <a:cubicBezTo>
                      <a:pt x="579680" y="1730829"/>
                      <a:pt x="707630" y="1747536"/>
                      <a:pt x="558800" y="1735134"/>
                    </a:cubicBezTo>
                    <a:cubicBezTo>
                      <a:pt x="546100" y="1730901"/>
                      <a:pt x="531839" y="1729860"/>
                      <a:pt x="520700" y="1722434"/>
                    </a:cubicBezTo>
                    <a:cubicBezTo>
                      <a:pt x="494388" y="1704893"/>
                      <a:pt x="509054" y="1711585"/>
                      <a:pt x="476250" y="1703384"/>
                    </a:cubicBezTo>
                    <a:cubicBezTo>
                      <a:pt x="456242" y="1690046"/>
                      <a:pt x="460395" y="1690401"/>
                      <a:pt x="438150" y="1684334"/>
                    </a:cubicBezTo>
                    <a:cubicBezTo>
                      <a:pt x="421311" y="1679741"/>
                      <a:pt x="387350" y="1671634"/>
                      <a:pt x="387350" y="1671634"/>
                    </a:cubicBezTo>
                    <a:cubicBezTo>
                      <a:pt x="381000" y="1667401"/>
                      <a:pt x="375540" y="1661347"/>
                      <a:pt x="368300" y="1658934"/>
                    </a:cubicBezTo>
                    <a:cubicBezTo>
                      <a:pt x="339034" y="1649179"/>
                      <a:pt x="334390" y="1657854"/>
                      <a:pt x="311150" y="1646234"/>
                    </a:cubicBezTo>
                    <a:cubicBezTo>
                      <a:pt x="300038" y="1642530"/>
                      <a:pt x="314325" y="1608417"/>
                      <a:pt x="301625" y="1636709"/>
                    </a:cubicBezTo>
                    <a:cubicBezTo>
                      <a:pt x="298450" y="1634592"/>
                      <a:pt x="301096" y="1643588"/>
                      <a:pt x="292100" y="1633534"/>
                    </a:cubicBezTo>
                    <a:cubicBezTo>
                      <a:pt x="274399" y="1606983"/>
                      <a:pt x="270032" y="1595036"/>
                      <a:pt x="247650" y="1576384"/>
                    </a:cubicBezTo>
                    <a:cubicBezTo>
                      <a:pt x="241787" y="1571498"/>
                      <a:pt x="235426" y="1567097"/>
                      <a:pt x="228600" y="1563684"/>
                    </a:cubicBezTo>
                    <a:cubicBezTo>
                      <a:pt x="222613" y="1560691"/>
                      <a:pt x="215900" y="1559451"/>
                      <a:pt x="209550" y="1557334"/>
                    </a:cubicBezTo>
                    <a:cubicBezTo>
                      <a:pt x="207433" y="1550984"/>
                      <a:pt x="207381" y="1543511"/>
                      <a:pt x="203200" y="1538284"/>
                    </a:cubicBezTo>
                    <a:cubicBezTo>
                      <a:pt x="194248" y="1527093"/>
                      <a:pt x="177649" y="1523417"/>
                      <a:pt x="165100" y="1519234"/>
                    </a:cubicBezTo>
                    <a:cubicBezTo>
                      <a:pt x="156633" y="1506534"/>
                      <a:pt x="143402" y="1495942"/>
                      <a:pt x="139700" y="1481134"/>
                    </a:cubicBezTo>
                    <a:cubicBezTo>
                      <a:pt x="137583" y="1472667"/>
                      <a:pt x="137588" y="1463363"/>
                      <a:pt x="133350" y="1455734"/>
                    </a:cubicBezTo>
                    <a:cubicBezTo>
                      <a:pt x="126768" y="1443886"/>
                      <a:pt x="116082" y="1434827"/>
                      <a:pt x="107950" y="1423984"/>
                    </a:cubicBezTo>
                    <a:cubicBezTo>
                      <a:pt x="103371" y="1417879"/>
                      <a:pt x="98663" y="1411760"/>
                      <a:pt x="95250" y="1404934"/>
                    </a:cubicBezTo>
                    <a:cubicBezTo>
                      <a:pt x="92257" y="1398947"/>
                      <a:pt x="93081" y="1391111"/>
                      <a:pt x="88900" y="1385884"/>
                    </a:cubicBezTo>
                    <a:cubicBezTo>
                      <a:pt x="84132" y="1379925"/>
                      <a:pt x="76200" y="1377417"/>
                      <a:pt x="69850" y="1373184"/>
                    </a:cubicBezTo>
                    <a:cubicBezTo>
                      <a:pt x="46692" y="1303709"/>
                      <a:pt x="83626" y="1408942"/>
                      <a:pt x="50800" y="1335084"/>
                    </a:cubicBezTo>
                    <a:cubicBezTo>
                      <a:pt x="45363" y="1322851"/>
                      <a:pt x="42333" y="1309684"/>
                      <a:pt x="38100" y="1296984"/>
                    </a:cubicBezTo>
                    <a:cubicBezTo>
                      <a:pt x="35983" y="1290634"/>
                      <a:pt x="35766" y="1283289"/>
                      <a:pt x="31750" y="1277934"/>
                    </a:cubicBezTo>
                    <a:cubicBezTo>
                      <a:pt x="8121" y="1246429"/>
                      <a:pt x="18571" y="1261340"/>
                      <a:pt x="0" y="1233484"/>
                    </a:cubicBezTo>
                    <a:cubicBezTo>
                      <a:pt x="2117" y="1201734"/>
                      <a:pt x="1850" y="1169735"/>
                      <a:pt x="6350" y="1138234"/>
                    </a:cubicBezTo>
                    <a:cubicBezTo>
                      <a:pt x="8243" y="1124982"/>
                      <a:pt x="16425" y="1113261"/>
                      <a:pt x="19050" y="1100134"/>
                    </a:cubicBezTo>
                    <a:cubicBezTo>
                      <a:pt x="21167" y="1089551"/>
                      <a:pt x="22560" y="1078797"/>
                      <a:pt x="25400" y="1068384"/>
                    </a:cubicBezTo>
                    <a:cubicBezTo>
                      <a:pt x="28922" y="1055469"/>
                      <a:pt x="33867" y="1042984"/>
                      <a:pt x="38100" y="1030284"/>
                    </a:cubicBezTo>
                    <a:lnTo>
                      <a:pt x="44450" y="1011234"/>
                    </a:lnTo>
                    <a:cubicBezTo>
                      <a:pt x="42333" y="1000651"/>
                      <a:pt x="40940" y="989897"/>
                      <a:pt x="38100" y="979484"/>
                    </a:cubicBezTo>
                    <a:cubicBezTo>
                      <a:pt x="34578" y="966569"/>
                      <a:pt x="25400" y="941384"/>
                      <a:pt x="25400" y="941384"/>
                    </a:cubicBezTo>
                    <a:cubicBezTo>
                      <a:pt x="17768" y="834540"/>
                      <a:pt x="15556" y="856308"/>
                      <a:pt x="25400" y="738184"/>
                    </a:cubicBezTo>
                    <a:cubicBezTo>
                      <a:pt x="26469" y="725353"/>
                      <a:pt x="29225" y="712709"/>
                      <a:pt x="31750" y="700084"/>
                    </a:cubicBezTo>
                    <a:cubicBezTo>
                      <a:pt x="36157" y="678049"/>
                      <a:pt x="43132" y="650163"/>
                      <a:pt x="63500" y="636584"/>
                    </a:cubicBezTo>
                    <a:lnTo>
                      <a:pt x="82550" y="623884"/>
                    </a:lnTo>
                    <a:lnTo>
                      <a:pt x="95250" y="585784"/>
                    </a:lnTo>
                    <a:cubicBezTo>
                      <a:pt x="97367" y="579434"/>
                      <a:pt x="96031" y="570447"/>
                      <a:pt x="101600" y="566734"/>
                    </a:cubicBezTo>
                    <a:lnTo>
                      <a:pt x="120650" y="554034"/>
                    </a:lnTo>
                    <a:cubicBezTo>
                      <a:pt x="135749" y="508738"/>
                      <a:pt x="114339" y="563500"/>
                      <a:pt x="146050" y="515934"/>
                    </a:cubicBezTo>
                    <a:cubicBezTo>
                      <a:pt x="149763" y="510365"/>
                      <a:pt x="148687" y="502453"/>
                      <a:pt x="152400" y="496884"/>
                    </a:cubicBezTo>
                    <a:cubicBezTo>
                      <a:pt x="157381" y="489412"/>
                      <a:pt x="165701" y="484733"/>
                      <a:pt x="171450" y="477834"/>
                    </a:cubicBezTo>
                    <a:cubicBezTo>
                      <a:pt x="176336" y="471971"/>
                      <a:pt x="178754" y="464180"/>
                      <a:pt x="184150" y="458784"/>
                    </a:cubicBezTo>
                    <a:cubicBezTo>
                      <a:pt x="189546" y="453388"/>
                      <a:pt x="197496" y="451154"/>
                      <a:pt x="203200" y="446084"/>
                    </a:cubicBezTo>
                    <a:cubicBezTo>
                      <a:pt x="224421" y="427220"/>
                      <a:pt x="249872" y="392427"/>
                      <a:pt x="279400" y="382584"/>
                    </a:cubicBezTo>
                    <a:cubicBezTo>
                      <a:pt x="292100" y="378351"/>
                      <a:pt x="306361" y="377310"/>
                      <a:pt x="317500" y="369884"/>
                    </a:cubicBezTo>
                    <a:cubicBezTo>
                      <a:pt x="372095" y="333488"/>
                      <a:pt x="303020" y="377124"/>
                      <a:pt x="355600" y="350834"/>
                    </a:cubicBezTo>
                    <a:cubicBezTo>
                      <a:pt x="362426" y="347421"/>
                      <a:pt x="367676" y="341234"/>
                      <a:pt x="374650" y="338134"/>
                    </a:cubicBezTo>
                    <a:lnTo>
                      <a:pt x="431800" y="319084"/>
                    </a:lnTo>
                    <a:cubicBezTo>
                      <a:pt x="438150" y="316967"/>
                      <a:pt x="445281" y="316447"/>
                      <a:pt x="450850" y="312734"/>
                    </a:cubicBezTo>
                    <a:cubicBezTo>
                      <a:pt x="457200" y="308501"/>
                      <a:pt x="462926" y="303134"/>
                      <a:pt x="469900" y="300034"/>
                    </a:cubicBezTo>
                    <a:lnTo>
                      <a:pt x="527050" y="280984"/>
                    </a:lnTo>
                    <a:lnTo>
                      <a:pt x="584200" y="261934"/>
                    </a:lnTo>
                    <a:lnTo>
                      <a:pt x="603250" y="255584"/>
                    </a:lnTo>
                    <a:cubicBezTo>
                      <a:pt x="609600" y="253467"/>
                      <a:pt x="615624" y="249711"/>
                      <a:pt x="622300" y="249234"/>
                    </a:cubicBezTo>
                    <a:lnTo>
                      <a:pt x="711200" y="242884"/>
                    </a:lnTo>
                    <a:cubicBezTo>
                      <a:pt x="750323" y="229843"/>
                      <a:pt x="710490" y="241859"/>
                      <a:pt x="774700" y="230184"/>
                    </a:cubicBezTo>
                    <a:cubicBezTo>
                      <a:pt x="795813" y="226345"/>
                      <a:pt x="818318" y="217761"/>
                      <a:pt x="838200" y="211134"/>
                    </a:cubicBezTo>
                    <a:lnTo>
                      <a:pt x="876300" y="198434"/>
                    </a:lnTo>
                    <a:lnTo>
                      <a:pt x="895350" y="192084"/>
                    </a:lnTo>
                    <a:cubicBezTo>
                      <a:pt x="899583" y="185734"/>
                      <a:pt x="902654" y="178430"/>
                      <a:pt x="908050" y="173034"/>
                    </a:cubicBezTo>
                    <a:cubicBezTo>
                      <a:pt x="913446" y="167638"/>
                      <a:pt x="922332" y="166293"/>
                      <a:pt x="927100" y="160334"/>
                    </a:cubicBezTo>
                    <a:cubicBezTo>
                      <a:pt x="931281" y="155107"/>
                      <a:pt x="930457" y="147271"/>
                      <a:pt x="933450" y="141284"/>
                    </a:cubicBezTo>
                    <a:cubicBezTo>
                      <a:pt x="936863" y="134458"/>
                      <a:pt x="943050" y="129208"/>
                      <a:pt x="946150" y="122234"/>
                    </a:cubicBezTo>
                    <a:cubicBezTo>
                      <a:pt x="951587" y="110001"/>
                      <a:pt x="958850" y="84134"/>
                      <a:pt x="958850" y="84134"/>
                    </a:cubicBezTo>
                    <a:cubicBezTo>
                      <a:pt x="960967" y="65084"/>
                      <a:pt x="962049" y="45890"/>
                      <a:pt x="965200" y="26984"/>
                    </a:cubicBezTo>
                    <a:cubicBezTo>
                      <a:pt x="966300" y="20382"/>
                      <a:pt x="966817" y="12667"/>
                      <a:pt x="971550" y="7934"/>
                    </a:cubicBezTo>
                    <a:cubicBezTo>
                      <a:pt x="976283" y="3201"/>
                      <a:pt x="984250" y="3701"/>
                      <a:pt x="990600" y="1584"/>
                    </a:cubicBezTo>
                    <a:cubicBezTo>
                      <a:pt x="1016000" y="5817"/>
                      <a:pt x="1045374" y="0"/>
                      <a:pt x="1066800" y="14284"/>
                    </a:cubicBezTo>
                    <a:cubicBezTo>
                      <a:pt x="1121395" y="50680"/>
                      <a:pt x="1052320" y="7044"/>
                      <a:pt x="1104900" y="33334"/>
                    </a:cubicBezTo>
                    <a:cubicBezTo>
                      <a:pt x="1111726" y="36747"/>
                      <a:pt x="1117124" y="42621"/>
                      <a:pt x="1123950" y="46034"/>
                    </a:cubicBezTo>
                    <a:cubicBezTo>
                      <a:pt x="1129937" y="49027"/>
                      <a:pt x="1137149" y="49133"/>
                      <a:pt x="1143000" y="52384"/>
                    </a:cubicBezTo>
                    <a:lnTo>
                      <a:pt x="1200150" y="90484"/>
                    </a:lnTo>
                    <a:lnTo>
                      <a:pt x="1219200" y="103184"/>
                    </a:lnTo>
                    <a:cubicBezTo>
                      <a:pt x="1225550" y="107417"/>
                      <a:pt x="1232854" y="110488"/>
                      <a:pt x="1238250" y="115884"/>
                    </a:cubicBezTo>
                    <a:cubicBezTo>
                      <a:pt x="1244600" y="122234"/>
                      <a:pt x="1250211" y="129421"/>
                      <a:pt x="1257300" y="134934"/>
                    </a:cubicBezTo>
                    <a:cubicBezTo>
                      <a:pt x="1269348" y="144305"/>
                      <a:pt x="1295400" y="160334"/>
                      <a:pt x="1295400" y="160334"/>
                    </a:cubicBezTo>
                    <a:cubicBezTo>
                      <a:pt x="1309255" y="201898"/>
                      <a:pt x="1290012" y="161104"/>
                      <a:pt x="1320800" y="185734"/>
                    </a:cubicBezTo>
                    <a:cubicBezTo>
                      <a:pt x="1326759" y="190502"/>
                      <a:pt x="1328104" y="199388"/>
                      <a:pt x="1333500" y="204784"/>
                    </a:cubicBezTo>
                    <a:cubicBezTo>
                      <a:pt x="1338896" y="210180"/>
                      <a:pt x="1346200" y="213251"/>
                      <a:pt x="1352550" y="217484"/>
                    </a:cubicBezTo>
                    <a:cubicBezTo>
                      <a:pt x="1381472" y="260868"/>
                      <a:pt x="1351492" y="256642"/>
                      <a:pt x="1358900" y="268284"/>
                    </a:cubicBezTo>
                    <a:close/>
                  </a:path>
                </a:pathLst>
              </a:custGeom>
              <a:noFill/>
              <a:ln w="38100" cap="flat" cmpd="sng" algn="ctr">
                <a:solidFill>
                  <a:srgbClr val="FF0000"/>
                </a:solidFill>
                <a:prstDash val="solid"/>
                <a:round/>
                <a:headEnd type="none" w="med" len="med"/>
                <a:tailEnd type="none" w="med" len="med"/>
              </a:ln>
              <a:effectLst>
                <a:glow rad="38100">
                  <a:schemeClr val="tx1">
                    <a:lumMod val="95000"/>
                    <a:lumOff val="5000"/>
                    <a:alpha val="75000"/>
                  </a:schemeClr>
                </a:glow>
                <a:outerShdw blurRad="40000" dist="23000" dir="5400000" rotWithShape="0">
                  <a:srgbClr val="000000">
                    <a:alpha val="35000"/>
                  </a:srgbClr>
                </a:outerShdw>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sp>
            <p:nvSpPr>
              <p:cNvPr id="105" name="Right Arrow 104"/>
              <p:cNvSpPr/>
              <p:nvPr/>
            </p:nvSpPr>
            <p:spPr>
              <a:xfrm rot="15399698">
                <a:off x="3732900" y="4012981"/>
                <a:ext cx="1675246" cy="312147"/>
              </a:xfrm>
              <a:prstGeom prst="rightArrow">
                <a:avLst/>
              </a:prstGeom>
              <a:solidFill>
                <a:srgbClr val="FF0000"/>
              </a:solidFill>
              <a:ln w="12700" cap="flat" cmpd="sng" algn="ctr">
                <a:solidFill>
                  <a:schemeClr val="tx1"/>
                </a:solidFill>
                <a:prstDash val="solid"/>
                <a:round/>
                <a:headEnd type="none" w="med" len="med"/>
                <a:tailEnd type="none" w="med" len="med"/>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prstClr val="white"/>
                  </a:solidFill>
                </a:endParaRPr>
              </a:p>
            </p:txBody>
          </p:sp>
        </p:grpSp>
        <p:grpSp>
          <p:nvGrpSpPr>
            <p:cNvPr id="48" name="Group 146"/>
            <p:cNvGrpSpPr/>
            <p:nvPr/>
          </p:nvGrpSpPr>
          <p:grpSpPr>
            <a:xfrm>
              <a:off x="3507038" y="2251264"/>
              <a:ext cx="1844486" cy="1559002"/>
              <a:chOff x="4769016" y="2013267"/>
              <a:chExt cx="2075047" cy="1559002"/>
            </a:xfrm>
          </p:grpSpPr>
          <p:cxnSp>
            <p:nvCxnSpPr>
              <p:cNvPr id="132" name="Straight Connector 131"/>
              <p:cNvCxnSpPr>
                <a:endCxn id="104" idx="13"/>
              </p:cNvCxnSpPr>
              <p:nvPr/>
            </p:nvCxnSpPr>
            <p:spPr>
              <a:xfrm flipV="1">
                <a:off x="4769016" y="2305367"/>
                <a:ext cx="1910741" cy="504902"/>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34" name="Straight Connector 133"/>
              <p:cNvCxnSpPr/>
              <p:nvPr/>
            </p:nvCxnSpPr>
            <p:spPr>
              <a:xfrm flipV="1">
                <a:off x="4857916" y="2470467"/>
                <a:ext cx="1910741" cy="504902"/>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35" name="Straight Connector 134"/>
              <p:cNvCxnSpPr/>
              <p:nvPr/>
            </p:nvCxnSpPr>
            <p:spPr>
              <a:xfrm flipV="1">
                <a:off x="4921416" y="2660967"/>
                <a:ext cx="1910741" cy="504902"/>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36" name="Straight Connector 135"/>
              <p:cNvCxnSpPr/>
              <p:nvPr/>
            </p:nvCxnSpPr>
            <p:spPr>
              <a:xfrm flipV="1">
                <a:off x="5048416" y="2832908"/>
                <a:ext cx="1795647" cy="485361"/>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37" name="Straight Connector 136"/>
              <p:cNvCxnSpPr>
                <a:endCxn id="104" idx="32"/>
              </p:cNvCxnSpPr>
              <p:nvPr/>
            </p:nvCxnSpPr>
            <p:spPr>
              <a:xfrm flipV="1">
                <a:off x="6474401" y="3232467"/>
                <a:ext cx="305367" cy="96375"/>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38" name="Straight Connector 137"/>
              <p:cNvCxnSpPr>
                <a:endCxn id="104" idx="32"/>
              </p:cNvCxnSpPr>
              <p:nvPr/>
            </p:nvCxnSpPr>
            <p:spPr>
              <a:xfrm flipV="1">
                <a:off x="5531016" y="3232467"/>
                <a:ext cx="1248753" cy="339802"/>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40" name="Straight Connector 139"/>
              <p:cNvCxnSpPr/>
              <p:nvPr/>
            </p:nvCxnSpPr>
            <p:spPr>
              <a:xfrm flipV="1">
                <a:off x="4921416" y="2013267"/>
                <a:ext cx="1358291" cy="335620"/>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cxnSp>
            <p:nvCxnSpPr>
              <p:cNvPr id="141" name="Straight Connector 140"/>
              <p:cNvCxnSpPr/>
              <p:nvPr/>
            </p:nvCxnSpPr>
            <p:spPr>
              <a:xfrm flipV="1">
                <a:off x="4830497" y="2216467"/>
                <a:ext cx="1699241" cy="401411"/>
              </a:xfrm>
              <a:prstGeom prst="line">
                <a:avLst/>
              </a:prstGeom>
              <a:ln w="38100" cap="flat" cmpd="sng" algn="ctr">
                <a:solidFill>
                  <a:srgbClr val="FF0000"/>
                </a:solidFill>
                <a:prstDash val="solid"/>
                <a:round/>
                <a:headEnd type="none" w="med" len="med"/>
                <a:tailEnd type="none" w="med" len="med"/>
              </a:ln>
            </p:spPr>
            <p:style>
              <a:lnRef idx="2">
                <a:schemeClr val="accent1"/>
              </a:lnRef>
              <a:fillRef idx="0">
                <a:schemeClr val="accent1"/>
              </a:fillRef>
              <a:effectRef idx="1">
                <a:schemeClr val="accent1"/>
              </a:effectRef>
              <a:fontRef idx="minor">
                <a:schemeClr val="tx1"/>
              </a:fontRef>
            </p:style>
          </p:cxnSp>
        </p:grpSp>
      </p:grpSp>
      <p:sp>
        <p:nvSpPr>
          <p:cNvPr id="52" name="TextBox 51"/>
          <p:cNvSpPr txBox="1"/>
          <p:nvPr/>
        </p:nvSpPr>
        <p:spPr>
          <a:xfrm>
            <a:off x="481342" y="6304684"/>
            <a:ext cx="8181315" cy="369332"/>
          </a:xfrm>
          <a:prstGeom prst="rect">
            <a:avLst/>
          </a:prstGeom>
          <a:noFill/>
        </p:spPr>
        <p:txBody>
          <a:bodyPr wrap="square" rtlCol="0">
            <a:spAutoFit/>
          </a:bodyPr>
          <a:lstStyle/>
          <a:p>
            <a:pPr algn="ctr"/>
            <a:r>
              <a:rPr lang="en-US" b="1" dirty="0" smtClean="0"/>
              <a:t>Euler diagram of </a:t>
            </a:r>
            <a:r>
              <a:rPr lang="en-US" b="1" dirty="0" err="1" smtClean="0"/>
              <a:t>CTAb</a:t>
            </a:r>
            <a:r>
              <a:rPr lang="en-US" b="1" dirty="0" smtClean="0"/>
              <a:t> in the context of functional antibodies to an enveloped virus</a:t>
            </a: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4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2"/>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2"/>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9"/>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40"/>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3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54</TotalTime>
  <Words>586</Words>
  <Application>Microsoft Macintosh PowerPoint</Application>
  <PresentationFormat>On-screen Show (4:3)</PresentationFormat>
  <Paragraphs>25</Paragraphs>
  <Slides>1</Slides>
  <Notes>1</Notes>
  <HiddenSlides>0</HiddenSlides>
  <MMClips>0</MMClips>
  <ScaleCrop>false</ScaleCrop>
  <HeadingPairs>
    <vt:vector size="4" baseType="variant">
      <vt:variant>
        <vt:lpstr>Design Template</vt:lpstr>
      </vt:variant>
      <vt:variant>
        <vt:i4>1</vt:i4>
      </vt:variant>
      <vt:variant>
        <vt:lpstr>Slide Titles</vt:lpstr>
      </vt:variant>
      <vt:variant>
        <vt:i4>1</vt:i4>
      </vt:variant>
    </vt:vector>
  </HeadingPairs>
  <TitlesOfParts>
    <vt:vector size="2" baseType="lpstr">
      <vt:lpstr>Office Theme</vt:lpstr>
      <vt:lpstr>Slide 1</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lan Schmaljohn</dc:creator>
  <cp:lastModifiedBy>Alan Schmaljohn</cp:lastModifiedBy>
  <cp:revision>4</cp:revision>
  <dcterms:created xsi:type="dcterms:W3CDTF">2016-03-22T15:15:44Z</dcterms:created>
  <dcterms:modified xsi:type="dcterms:W3CDTF">2016-03-22T15:18:05Z</dcterms:modified>
</cp:coreProperties>
</file>